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046" autoAdjust="0"/>
    <p:restoredTop sz="94660"/>
  </p:normalViewPr>
  <p:slideViewPr>
    <p:cSldViewPr>
      <p:cViewPr varScale="1">
        <p:scale>
          <a:sx n="110" d="100"/>
          <a:sy n="110" d="100"/>
        </p:scale>
        <p:origin x="2082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09900C4D-E3F8-432E-8A0D-DC97B53B0720}" type="datetimeFigureOut">
              <a:rPr lang="en-US" smtClean="0"/>
              <a:t>2/15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AB3E609A-BEE2-484C-AE0F-B55570F1C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6078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D689B-0256-40B0-80BB-14C761E23949}" type="datetimeFigureOut">
              <a:rPr lang="en-US" smtClean="0"/>
              <a:t>2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B92D-0B7B-4C5F-9936-38E69628F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654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D689B-0256-40B0-80BB-14C761E23949}" type="datetimeFigureOut">
              <a:rPr lang="en-US" smtClean="0"/>
              <a:t>2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B92D-0B7B-4C5F-9936-38E69628F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454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D689B-0256-40B0-80BB-14C761E23949}" type="datetimeFigureOut">
              <a:rPr lang="en-US" smtClean="0"/>
              <a:t>2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B92D-0B7B-4C5F-9936-38E69628F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545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D689B-0256-40B0-80BB-14C761E23949}" type="datetimeFigureOut">
              <a:rPr lang="en-US" smtClean="0"/>
              <a:t>2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B92D-0B7B-4C5F-9936-38E69628F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699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D689B-0256-40B0-80BB-14C761E23949}" type="datetimeFigureOut">
              <a:rPr lang="en-US" smtClean="0"/>
              <a:t>2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B92D-0B7B-4C5F-9936-38E69628F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558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D689B-0256-40B0-80BB-14C761E23949}" type="datetimeFigureOut">
              <a:rPr lang="en-US" smtClean="0"/>
              <a:t>2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B92D-0B7B-4C5F-9936-38E69628F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9395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D689B-0256-40B0-80BB-14C761E23949}" type="datetimeFigureOut">
              <a:rPr lang="en-US" smtClean="0"/>
              <a:t>2/15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B92D-0B7B-4C5F-9936-38E69628F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221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D689B-0256-40B0-80BB-14C761E23949}" type="datetimeFigureOut">
              <a:rPr lang="en-US" smtClean="0"/>
              <a:t>2/15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B92D-0B7B-4C5F-9936-38E69628F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019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D689B-0256-40B0-80BB-14C761E23949}" type="datetimeFigureOut">
              <a:rPr lang="en-US" smtClean="0"/>
              <a:t>2/15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B92D-0B7B-4C5F-9936-38E69628F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045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D689B-0256-40B0-80BB-14C761E23949}" type="datetimeFigureOut">
              <a:rPr lang="en-US" smtClean="0"/>
              <a:t>2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B92D-0B7B-4C5F-9936-38E69628F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301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D689B-0256-40B0-80BB-14C761E23949}" type="datetimeFigureOut">
              <a:rPr lang="en-US" smtClean="0"/>
              <a:t>2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B92D-0B7B-4C5F-9936-38E69628F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631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1D689B-0256-40B0-80BB-14C761E23949}" type="datetimeFigureOut">
              <a:rPr lang="en-US" smtClean="0"/>
              <a:t>2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B4B92D-0B7B-4C5F-9936-38E69628F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04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06"/>
          <p:cNvSpPr>
            <a:spLocks noChangeArrowheads="1"/>
          </p:cNvSpPr>
          <p:nvPr/>
        </p:nvSpPr>
        <p:spPr bwMode="auto">
          <a:xfrm>
            <a:off x="1506159" y="1459314"/>
            <a:ext cx="10164" cy="43446"/>
          </a:xfrm>
          <a:prstGeom prst="rect">
            <a:avLst/>
          </a:prstGeom>
          <a:solidFill>
            <a:srgbClr val="FFFFCC"/>
          </a:solidFill>
          <a:ln w="0">
            <a:solidFill>
              <a:srgbClr val="CCCC99"/>
            </a:solidFill>
            <a:miter lim="800000"/>
            <a:headEnd/>
            <a:tailEnd/>
          </a:ln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endParaRPr lang="en-US" altLang="en-US" sz="3200"/>
          </a:p>
        </p:txBody>
      </p:sp>
      <p:sp>
        <p:nvSpPr>
          <p:cNvPr id="5" name="Rectangle 107"/>
          <p:cNvSpPr>
            <a:spLocks noChangeArrowheads="1"/>
          </p:cNvSpPr>
          <p:nvPr/>
        </p:nvSpPr>
        <p:spPr bwMode="auto">
          <a:xfrm>
            <a:off x="1516323" y="1459314"/>
            <a:ext cx="5066693" cy="43446"/>
          </a:xfrm>
          <a:prstGeom prst="rect">
            <a:avLst/>
          </a:prstGeom>
          <a:solidFill>
            <a:schemeClr val="tx1"/>
          </a:solidFill>
          <a:ln w="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endParaRPr lang="en-US" altLang="en-US" sz="3200"/>
          </a:p>
        </p:txBody>
      </p:sp>
      <p:sp>
        <p:nvSpPr>
          <p:cNvPr id="6" name="Line 111"/>
          <p:cNvSpPr>
            <a:spLocks noChangeShapeType="1"/>
          </p:cNvSpPr>
          <p:nvPr/>
        </p:nvSpPr>
        <p:spPr bwMode="auto">
          <a:xfrm flipH="1">
            <a:off x="5404006" y="1123321"/>
            <a:ext cx="5473" cy="272269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3200"/>
          </a:p>
        </p:txBody>
      </p:sp>
      <p:sp>
        <p:nvSpPr>
          <p:cNvPr id="7" name="Rectangle 112"/>
          <p:cNvSpPr>
            <a:spLocks noChangeArrowheads="1"/>
          </p:cNvSpPr>
          <p:nvPr/>
        </p:nvSpPr>
        <p:spPr bwMode="auto">
          <a:xfrm>
            <a:off x="5182145" y="822028"/>
            <a:ext cx="436018" cy="307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2000" b="1" dirty="0" smtClean="0"/>
              <a:t>Neo</a:t>
            </a:r>
            <a:endParaRPr lang="en-US" altLang="en-US" sz="2000" b="1" dirty="0"/>
          </a:p>
        </p:txBody>
      </p:sp>
      <p:sp>
        <p:nvSpPr>
          <p:cNvPr id="8" name="Line 114"/>
          <p:cNvSpPr>
            <a:spLocks noChangeShapeType="1"/>
          </p:cNvSpPr>
          <p:nvPr/>
        </p:nvSpPr>
        <p:spPr bwMode="auto">
          <a:xfrm flipH="1">
            <a:off x="4115734" y="1210216"/>
            <a:ext cx="2542" cy="1853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3200"/>
          </a:p>
        </p:txBody>
      </p:sp>
      <p:sp>
        <p:nvSpPr>
          <p:cNvPr id="9" name="Rectangle 115"/>
          <p:cNvSpPr>
            <a:spLocks noChangeArrowheads="1"/>
          </p:cNvSpPr>
          <p:nvPr/>
        </p:nvSpPr>
        <p:spPr bwMode="auto">
          <a:xfrm>
            <a:off x="3840786" y="851052"/>
            <a:ext cx="836767" cy="307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2000" b="1" dirty="0" smtClean="0"/>
              <a:t>mUNG1</a:t>
            </a:r>
            <a:endParaRPr lang="en-US" altLang="en-US" sz="2000" b="1" dirty="0"/>
          </a:p>
        </p:txBody>
      </p:sp>
      <p:sp>
        <p:nvSpPr>
          <p:cNvPr id="10" name="Line 117"/>
          <p:cNvSpPr>
            <a:spLocks noChangeShapeType="1"/>
          </p:cNvSpPr>
          <p:nvPr/>
        </p:nvSpPr>
        <p:spPr bwMode="auto">
          <a:xfrm>
            <a:off x="1775502" y="1184147"/>
            <a:ext cx="94015" cy="21144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3200"/>
          </a:p>
        </p:txBody>
      </p:sp>
      <p:sp>
        <p:nvSpPr>
          <p:cNvPr id="11" name="Rectangle 118"/>
          <p:cNvSpPr>
            <a:spLocks noChangeArrowheads="1"/>
          </p:cNvSpPr>
          <p:nvPr/>
        </p:nvSpPr>
        <p:spPr bwMode="auto">
          <a:xfrm>
            <a:off x="1468044" y="955325"/>
            <a:ext cx="2513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1400" b="1">
                <a:solidFill>
                  <a:srgbClr val="000000"/>
                </a:solidFill>
              </a:rPr>
              <a:t>LTR</a:t>
            </a:r>
            <a:endParaRPr lang="en-US" altLang="en-US" sz="3200"/>
          </a:p>
        </p:txBody>
      </p:sp>
      <p:sp>
        <p:nvSpPr>
          <p:cNvPr id="12" name="Line 120"/>
          <p:cNvSpPr>
            <a:spLocks noChangeShapeType="1"/>
          </p:cNvSpPr>
          <p:nvPr/>
        </p:nvSpPr>
        <p:spPr bwMode="auto">
          <a:xfrm flipH="1">
            <a:off x="6757806" y="1158830"/>
            <a:ext cx="71147" cy="21144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3200"/>
          </a:p>
        </p:txBody>
      </p:sp>
      <p:sp>
        <p:nvSpPr>
          <p:cNvPr id="13" name="Rectangle 121"/>
          <p:cNvSpPr>
            <a:spLocks noChangeArrowheads="1"/>
          </p:cNvSpPr>
          <p:nvPr/>
        </p:nvSpPr>
        <p:spPr bwMode="auto">
          <a:xfrm>
            <a:off x="6716187" y="897219"/>
            <a:ext cx="2513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1400" b="1" dirty="0">
                <a:solidFill>
                  <a:srgbClr val="000000"/>
                </a:solidFill>
              </a:rPr>
              <a:t>LTR</a:t>
            </a:r>
            <a:endParaRPr lang="en-US" altLang="en-US" sz="3200" dirty="0"/>
          </a:p>
        </p:txBody>
      </p:sp>
      <p:sp>
        <p:nvSpPr>
          <p:cNvPr id="14" name="Line 144"/>
          <p:cNvSpPr>
            <a:spLocks noChangeShapeType="1"/>
          </p:cNvSpPr>
          <p:nvPr/>
        </p:nvSpPr>
        <p:spPr bwMode="auto">
          <a:xfrm>
            <a:off x="2596234" y="1123322"/>
            <a:ext cx="43197" cy="27227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3200"/>
          </a:p>
        </p:txBody>
      </p:sp>
      <p:sp>
        <p:nvSpPr>
          <p:cNvPr id="15" name="Rectangle 145"/>
          <p:cNvSpPr>
            <a:spLocks noChangeArrowheads="1"/>
          </p:cNvSpPr>
          <p:nvPr/>
        </p:nvSpPr>
        <p:spPr bwMode="auto">
          <a:xfrm>
            <a:off x="2316797" y="697163"/>
            <a:ext cx="584423" cy="307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2000" b="1" dirty="0" smtClean="0">
                <a:solidFill>
                  <a:srgbClr val="000000"/>
                </a:solidFill>
              </a:rPr>
              <a:t>Gag</a:t>
            </a:r>
            <a:endParaRPr lang="en-US" altLang="en-US" sz="4400" dirty="0"/>
          </a:p>
        </p:txBody>
      </p:sp>
      <p:sp>
        <p:nvSpPr>
          <p:cNvPr id="16" name="Line 150"/>
          <p:cNvSpPr>
            <a:spLocks noChangeShapeType="1"/>
          </p:cNvSpPr>
          <p:nvPr/>
        </p:nvSpPr>
        <p:spPr bwMode="auto">
          <a:xfrm flipH="1">
            <a:off x="4811960" y="864158"/>
            <a:ext cx="21599" cy="531434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3200"/>
          </a:p>
        </p:txBody>
      </p:sp>
      <p:sp>
        <p:nvSpPr>
          <p:cNvPr id="17" name="Rectangle 151"/>
          <p:cNvSpPr>
            <a:spLocks noChangeArrowheads="1"/>
          </p:cNvSpPr>
          <p:nvPr/>
        </p:nvSpPr>
        <p:spPr bwMode="auto">
          <a:xfrm>
            <a:off x="4601060" y="528092"/>
            <a:ext cx="37163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1400" b="1" dirty="0" smtClean="0">
                <a:solidFill>
                  <a:srgbClr val="000000"/>
                </a:solidFill>
              </a:rPr>
              <a:t>SV40</a:t>
            </a:r>
            <a:endParaRPr lang="en-US" altLang="en-US" sz="3200" baseline="-25000" dirty="0"/>
          </a:p>
        </p:txBody>
      </p:sp>
      <p:sp>
        <p:nvSpPr>
          <p:cNvPr id="19" name="Freeform 110" descr="Wide downward diagonal"/>
          <p:cNvSpPr>
            <a:spLocks/>
          </p:cNvSpPr>
          <p:nvPr/>
        </p:nvSpPr>
        <p:spPr bwMode="auto">
          <a:xfrm>
            <a:off x="5091466" y="1326076"/>
            <a:ext cx="622538" cy="309923"/>
          </a:xfrm>
          <a:custGeom>
            <a:avLst/>
            <a:gdLst>
              <a:gd name="T0" fmla="*/ 493951260 w 245"/>
              <a:gd name="T1" fmla="*/ 269655131 h 107"/>
              <a:gd name="T2" fmla="*/ 617439869 w 245"/>
              <a:gd name="T3" fmla="*/ 133567094 h 107"/>
              <a:gd name="T4" fmla="*/ 493951260 w 245"/>
              <a:gd name="T5" fmla="*/ 0 h 107"/>
              <a:gd name="T6" fmla="*/ 493951260 w 245"/>
              <a:gd name="T7" fmla="*/ 60483572 h 107"/>
              <a:gd name="T8" fmla="*/ 0 w 245"/>
              <a:gd name="T9" fmla="*/ 60483572 h 107"/>
              <a:gd name="T10" fmla="*/ 0 w 245"/>
              <a:gd name="T11" fmla="*/ 209171559 h 107"/>
              <a:gd name="T12" fmla="*/ 493951260 w 245"/>
              <a:gd name="T13" fmla="*/ 209171559 h 107"/>
              <a:gd name="T14" fmla="*/ 493951260 w 245"/>
              <a:gd name="T15" fmla="*/ 269655131 h 107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w 245"/>
              <a:gd name="T25" fmla="*/ 0 h 107"/>
              <a:gd name="T26" fmla="*/ 245 w 245"/>
              <a:gd name="T27" fmla="*/ 107 h 107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45" h="107">
                <a:moveTo>
                  <a:pt x="196" y="107"/>
                </a:moveTo>
                <a:lnTo>
                  <a:pt x="245" y="53"/>
                </a:lnTo>
                <a:lnTo>
                  <a:pt x="196" y="0"/>
                </a:lnTo>
                <a:lnTo>
                  <a:pt x="196" y="24"/>
                </a:lnTo>
                <a:lnTo>
                  <a:pt x="0" y="24"/>
                </a:lnTo>
                <a:lnTo>
                  <a:pt x="0" y="83"/>
                </a:lnTo>
                <a:lnTo>
                  <a:pt x="196" y="83"/>
                </a:lnTo>
                <a:lnTo>
                  <a:pt x="196" y="107"/>
                </a:lnTo>
                <a:close/>
              </a:path>
            </a:pathLst>
          </a:custGeom>
          <a:pattFill prst="wdDnDiag">
            <a:fgClr>
              <a:schemeClr val="tx1"/>
            </a:fgClr>
            <a:bgClr>
              <a:srgbClr val="FFFFFF"/>
            </a:bgClr>
          </a:pattFill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 sz="3200"/>
          </a:p>
        </p:txBody>
      </p:sp>
      <p:sp>
        <p:nvSpPr>
          <p:cNvPr id="20" name="Freeform 113" descr="5%"/>
          <p:cNvSpPr>
            <a:spLocks/>
          </p:cNvSpPr>
          <p:nvPr/>
        </p:nvSpPr>
        <p:spPr bwMode="auto">
          <a:xfrm>
            <a:off x="3777786" y="1326076"/>
            <a:ext cx="744503" cy="309923"/>
          </a:xfrm>
          <a:custGeom>
            <a:avLst/>
            <a:gdLst>
              <a:gd name="T0" fmla="*/ 617436824 w 293"/>
              <a:gd name="T1" fmla="*/ 269655131 h 107"/>
              <a:gd name="T2" fmla="*/ 738404194 w 293"/>
              <a:gd name="T3" fmla="*/ 133567094 h 107"/>
              <a:gd name="T4" fmla="*/ 617436824 w 293"/>
              <a:gd name="T5" fmla="*/ 0 h 107"/>
              <a:gd name="T6" fmla="*/ 617436824 w 293"/>
              <a:gd name="T7" fmla="*/ 60483572 h 107"/>
              <a:gd name="T8" fmla="*/ 0 w 293"/>
              <a:gd name="T9" fmla="*/ 60483572 h 107"/>
              <a:gd name="T10" fmla="*/ 0 w 293"/>
              <a:gd name="T11" fmla="*/ 209171559 h 107"/>
              <a:gd name="T12" fmla="*/ 617436824 w 293"/>
              <a:gd name="T13" fmla="*/ 209171559 h 107"/>
              <a:gd name="T14" fmla="*/ 617436824 w 293"/>
              <a:gd name="T15" fmla="*/ 269655131 h 107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w 293"/>
              <a:gd name="T25" fmla="*/ 0 h 107"/>
              <a:gd name="T26" fmla="*/ 293 w 293"/>
              <a:gd name="T27" fmla="*/ 107 h 107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93" h="107">
                <a:moveTo>
                  <a:pt x="245" y="107"/>
                </a:moveTo>
                <a:lnTo>
                  <a:pt x="293" y="53"/>
                </a:lnTo>
                <a:lnTo>
                  <a:pt x="245" y="0"/>
                </a:lnTo>
                <a:lnTo>
                  <a:pt x="245" y="24"/>
                </a:lnTo>
                <a:lnTo>
                  <a:pt x="0" y="24"/>
                </a:lnTo>
                <a:lnTo>
                  <a:pt x="0" y="83"/>
                </a:lnTo>
                <a:lnTo>
                  <a:pt x="245" y="83"/>
                </a:lnTo>
                <a:lnTo>
                  <a:pt x="245" y="107"/>
                </a:lnTo>
                <a:close/>
              </a:path>
            </a:pathLst>
          </a:custGeom>
          <a:pattFill prst="lgCheck">
            <a:fgClr>
              <a:schemeClr val="tx1"/>
            </a:fgClr>
            <a:bgClr>
              <a:schemeClr val="bg1"/>
            </a:bgClr>
          </a:pattFill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 sz="3200"/>
          </a:p>
        </p:txBody>
      </p:sp>
      <p:sp>
        <p:nvSpPr>
          <p:cNvPr id="21" name="Freeform 116" descr="Small grid"/>
          <p:cNvSpPr>
            <a:spLocks/>
          </p:cNvSpPr>
          <p:nvPr/>
        </p:nvSpPr>
        <p:spPr bwMode="auto">
          <a:xfrm>
            <a:off x="1488372" y="1331869"/>
            <a:ext cx="701308" cy="309923"/>
          </a:xfrm>
          <a:custGeom>
            <a:avLst/>
            <a:gdLst>
              <a:gd name="T0" fmla="*/ 574595625 w 276"/>
              <a:gd name="T1" fmla="*/ 269655131 h 107"/>
              <a:gd name="T2" fmla="*/ 695563125 w 276"/>
              <a:gd name="T3" fmla="*/ 133567094 h 107"/>
              <a:gd name="T4" fmla="*/ 574595625 w 276"/>
              <a:gd name="T5" fmla="*/ 0 h 107"/>
              <a:gd name="T6" fmla="*/ 574595625 w 276"/>
              <a:gd name="T7" fmla="*/ 60483572 h 107"/>
              <a:gd name="T8" fmla="*/ 0 w 276"/>
              <a:gd name="T9" fmla="*/ 60483572 h 107"/>
              <a:gd name="T10" fmla="*/ 0 w 276"/>
              <a:gd name="T11" fmla="*/ 209171559 h 107"/>
              <a:gd name="T12" fmla="*/ 574595625 w 276"/>
              <a:gd name="T13" fmla="*/ 209171559 h 107"/>
              <a:gd name="T14" fmla="*/ 574595625 w 276"/>
              <a:gd name="T15" fmla="*/ 269655131 h 107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w 276"/>
              <a:gd name="T25" fmla="*/ 0 h 107"/>
              <a:gd name="T26" fmla="*/ 276 w 276"/>
              <a:gd name="T27" fmla="*/ 107 h 107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76" h="107">
                <a:moveTo>
                  <a:pt x="228" y="107"/>
                </a:moveTo>
                <a:lnTo>
                  <a:pt x="276" y="53"/>
                </a:lnTo>
                <a:lnTo>
                  <a:pt x="228" y="0"/>
                </a:lnTo>
                <a:lnTo>
                  <a:pt x="228" y="24"/>
                </a:lnTo>
                <a:lnTo>
                  <a:pt x="0" y="24"/>
                </a:lnTo>
                <a:lnTo>
                  <a:pt x="0" y="83"/>
                </a:lnTo>
                <a:lnTo>
                  <a:pt x="228" y="83"/>
                </a:lnTo>
                <a:lnTo>
                  <a:pt x="228" y="107"/>
                </a:lnTo>
                <a:close/>
              </a:path>
            </a:pathLst>
          </a:custGeom>
          <a:pattFill prst="smGrid">
            <a:fgClr>
              <a:schemeClr val="tx1"/>
            </a:fgClr>
            <a:bgClr>
              <a:srgbClr val="FFFFFF"/>
            </a:bgClr>
          </a:pattFill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 sz="3200"/>
          </a:p>
        </p:txBody>
      </p:sp>
      <p:sp>
        <p:nvSpPr>
          <p:cNvPr id="22" name="Freeform 119" descr="Small grid"/>
          <p:cNvSpPr>
            <a:spLocks/>
          </p:cNvSpPr>
          <p:nvPr/>
        </p:nvSpPr>
        <p:spPr bwMode="auto">
          <a:xfrm>
            <a:off x="6400800" y="1326076"/>
            <a:ext cx="714013" cy="309923"/>
          </a:xfrm>
          <a:custGeom>
            <a:avLst/>
            <a:gdLst>
              <a:gd name="T0" fmla="*/ 589717223 w 281"/>
              <a:gd name="T1" fmla="*/ 269655131 h 107"/>
              <a:gd name="T2" fmla="*/ 708165494 w 281"/>
              <a:gd name="T3" fmla="*/ 133567094 h 107"/>
              <a:gd name="T4" fmla="*/ 589717223 w 281"/>
              <a:gd name="T5" fmla="*/ 0 h 107"/>
              <a:gd name="T6" fmla="*/ 589717223 w 281"/>
              <a:gd name="T7" fmla="*/ 60483572 h 107"/>
              <a:gd name="T8" fmla="*/ 0 w 281"/>
              <a:gd name="T9" fmla="*/ 60483572 h 107"/>
              <a:gd name="T10" fmla="*/ 0 w 281"/>
              <a:gd name="T11" fmla="*/ 209171559 h 107"/>
              <a:gd name="T12" fmla="*/ 589717223 w 281"/>
              <a:gd name="T13" fmla="*/ 209171559 h 107"/>
              <a:gd name="T14" fmla="*/ 589717223 w 281"/>
              <a:gd name="T15" fmla="*/ 269655131 h 107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w 281"/>
              <a:gd name="T25" fmla="*/ 0 h 107"/>
              <a:gd name="T26" fmla="*/ 281 w 281"/>
              <a:gd name="T27" fmla="*/ 107 h 107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81" h="107">
                <a:moveTo>
                  <a:pt x="234" y="107"/>
                </a:moveTo>
                <a:lnTo>
                  <a:pt x="281" y="53"/>
                </a:lnTo>
                <a:lnTo>
                  <a:pt x="234" y="0"/>
                </a:lnTo>
                <a:lnTo>
                  <a:pt x="234" y="24"/>
                </a:lnTo>
                <a:lnTo>
                  <a:pt x="0" y="24"/>
                </a:lnTo>
                <a:lnTo>
                  <a:pt x="0" y="83"/>
                </a:lnTo>
                <a:lnTo>
                  <a:pt x="234" y="83"/>
                </a:lnTo>
                <a:lnTo>
                  <a:pt x="234" y="107"/>
                </a:lnTo>
                <a:close/>
              </a:path>
            </a:pathLst>
          </a:custGeom>
          <a:pattFill prst="smGrid">
            <a:fgClr>
              <a:schemeClr val="tx1"/>
            </a:fgClr>
            <a:bgClr>
              <a:srgbClr val="FFFFFF"/>
            </a:bgClr>
          </a:pattFill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 sz="3200"/>
          </a:p>
        </p:txBody>
      </p:sp>
      <p:sp>
        <p:nvSpPr>
          <p:cNvPr id="23" name="Freeform 143" descr="Light vertical"/>
          <p:cNvSpPr>
            <a:spLocks/>
          </p:cNvSpPr>
          <p:nvPr/>
        </p:nvSpPr>
        <p:spPr bwMode="auto">
          <a:xfrm>
            <a:off x="2245581" y="1326076"/>
            <a:ext cx="790242" cy="309923"/>
          </a:xfrm>
          <a:custGeom>
            <a:avLst/>
            <a:gdLst>
              <a:gd name="T0" fmla="*/ 662802559 w 311"/>
              <a:gd name="T1" fmla="*/ 269655131 h 107"/>
              <a:gd name="T2" fmla="*/ 783770181 w 311"/>
              <a:gd name="T3" fmla="*/ 133567094 h 107"/>
              <a:gd name="T4" fmla="*/ 662802559 w 311"/>
              <a:gd name="T5" fmla="*/ 0 h 107"/>
              <a:gd name="T6" fmla="*/ 662802559 w 311"/>
              <a:gd name="T7" fmla="*/ 60483572 h 107"/>
              <a:gd name="T8" fmla="*/ 0 w 311"/>
              <a:gd name="T9" fmla="*/ 60483572 h 107"/>
              <a:gd name="T10" fmla="*/ 0 w 311"/>
              <a:gd name="T11" fmla="*/ 209171559 h 107"/>
              <a:gd name="T12" fmla="*/ 662802559 w 311"/>
              <a:gd name="T13" fmla="*/ 209171559 h 107"/>
              <a:gd name="T14" fmla="*/ 662802559 w 311"/>
              <a:gd name="T15" fmla="*/ 269655131 h 107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w 311"/>
              <a:gd name="T25" fmla="*/ 0 h 107"/>
              <a:gd name="T26" fmla="*/ 311 w 311"/>
              <a:gd name="T27" fmla="*/ 107 h 107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311" h="107">
                <a:moveTo>
                  <a:pt x="263" y="107"/>
                </a:moveTo>
                <a:lnTo>
                  <a:pt x="311" y="53"/>
                </a:lnTo>
                <a:lnTo>
                  <a:pt x="263" y="0"/>
                </a:lnTo>
                <a:lnTo>
                  <a:pt x="263" y="24"/>
                </a:lnTo>
                <a:lnTo>
                  <a:pt x="0" y="24"/>
                </a:lnTo>
                <a:lnTo>
                  <a:pt x="0" y="83"/>
                </a:lnTo>
                <a:lnTo>
                  <a:pt x="263" y="83"/>
                </a:lnTo>
                <a:lnTo>
                  <a:pt x="263" y="107"/>
                </a:lnTo>
                <a:close/>
              </a:path>
            </a:pathLst>
          </a:custGeom>
          <a:pattFill prst="ltVert">
            <a:fgClr>
              <a:schemeClr val="tx1"/>
            </a:fgClr>
            <a:bgClr>
              <a:srgbClr val="FFFFFF"/>
            </a:bgClr>
          </a:pattFill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 sz="3200"/>
          </a:p>
        </p:txBody>
      </p:sp>
      <p:sp>
        <p:nvSpPr>
          <p:cNvPr id="24" name="Freeform 149"/>
          <p:cNvSpPr>
            <a:spLocks/>
          </p:cNvSpPr>
          <p:nvPr/>
        </p:nvSpPr>
        <p:spPr bwMode="auto">
          <a:xfrm>
            <a:off x="4552781" y="1326076"/>
            <a:ext cx="523440" cy="309923"/>
          </a:xfrm>
          <a:custGeom>
            <a:avLst/>
            <a:gdLst>
              <a:gd name="T0" fmla="*/ 395665325 w 206"/>
              <a:gd name="T1" fmla="*/ 269655131 h 107"/>
              <a:gd name="T2" fmla="*/ 519152188 w 206"/>
              <a:gd name="T3" fmla="*/ 133567094 h 107"/>
              <a:gd name="T4" fmla="*/ 395665325 w 206"/>
              <a:gd name="T5" fmla="*/ 0 h 107"/>
              <a:gd name="T6" fmla="*/ 395665325 w 206"/>
              <a:gd name="T7" fmla="*/ 60483572 h 107"/>
              <a:gd name="T8" fmla="*/ 0 w 206"/>
              <a:gd name="T9" fmla="*/ 60483572 h 107"/>
              <a:gd name="T10" fmla="*/ 0 w 206"/>
              <a:gd name="T11" fmla="*/ 209171559 h 107"/>
              <a:gd name="T12" fmla="*/ 395665325 w 206"/>
              <a:gd name="T13" fmla="*/ 209171559 h 107"/>
              <a:gd name="T14" fmla="*/ 395665325 w 206"/>
              <a:gd name="T15" fmla="*/ 269655131 h 107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w 206"/>
              <a:gd name="T25" fmla="*/ 0 h 107"/>
              <a:gd name="T26" fmla="*/ 206 w 206"/>
              <a:gd name="T27" fmla="*/ 107 h 107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06" h="107">
                <a:moveTo>
                  <a:pt x="157" y="107"/>
                </a:moveTo>
                <a:lnTo>
                  <a:pt x="206" y="53"/>
                </a:lnTo>
                <a:lnTo>
                  <a:pt x="157" y="0"/>
                </a:lnTo>
                <a:lnTo>
                  <a:pt x="157" y="24"/>
                </a:lnTo>
                <a:lnTo>
                  <a:pt x="0" y="24"/>
                </a:lnTo>
                <a:lnTo>
                  <a:pt x="0" y="83"/>
                </a:lnTo>
                <a:lnTo>
                  <a:pt x="157" y="83"/>
                </a:lnTo>
                <a:lnTo>
                  <a:pt x="157" y="107"/>
                </a:lnTo>
                <a:close/>
              </a:path>
            </a:pathLst>
          </a:custGeom>
          <a:solidFill>
            <a:schemeClr val="tx1"/>
          </a:solidFill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 sz="3200"/>
          </a:p>
        </p:txBody>
      </p:sp>
      <p:sp>
        <p:nvSpPr>
          <p:cNvPr id="26" name="Right Arrow 25"/>
          <p:cNvSpPr/>
          <p:nvPr/>
        </p:nvSpPr>
        <p:spPr bwMode="auto">
          <a:xfrm>
            <a:off x="3167263" y="1323489"/>
            <a:ext cx="339642" cy="318303"/>
          </a:xfrm>
          <a:prstGeom prst="rightArrow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3200"/>
          </a:p>
        </p:txBody>
      </p:sp>
      <p:sp>
        <p:nvSpPr>
          <p:cNvPr id="27" name="Rectangle 26"/>
          <p:cNvSpPr/>
          <p:nvPr/>
        </p:nvSpPr>
        <p:spPr bwMode="auto">
          <a:xfrm>
            <a:off x="3540191" y="1419201"/>
            <a:ext cx="209645" cy="13889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3200"/>
          </a:p>
        </p:txBody>
      </p:sp>
      <p:cxnSp>
        <p:nvCxnSpPr>
          <p:cNvPr id="28" name="Straight Connector 27"/>
          <p:cNvCxnSpPr/>
          <p:nvPr/>
        </p:nvCxnSpPr>
        <p:spPr bwMode="auto">
          <a:xfrm flipV="1">
            <a:off x="3331028" y="1089239"/>
            <a:ext cx="7622" cy="30635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ectangle 145"/>
          <p:cNvSpPr>
            <a:spLocks noChangeArrowheads="1"/>
          </p:cNvSpPr>
          <p:nvPr/>
        </p:nvSpPr>
        <p:spPr bwMode="auto">
          <a:xfrm>
            <a:off x="3170618" y="843648"/>
            <a:ext cx="32932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1400" b="1" dirty="0">
                <a:solidFill>
                  <a:srgbClr val="000000"/>
                </a:solidFill>
              </a:rPr>
              <a:t>MTS</a:t>
            </a:r>
            <a:endParaRPr lang="en-US" altLang="en-US" sz="3200" dirty="0"/>
          </a:p>
        </p:txBody>
      </p:sp>
      <p:cxnSp>
        <p:nvCxnSpPr>
          <p:cNvPr id="30" name="Straight Connector 29"/>
          <p:cNvCxnSpPr/>
          <p:nvPr/>
        </p:nvCxnSpPr>
        <p:spPr bwMode="auto">
          <a:xfrm flipV="1">
            <a:off x="3666369" y="906874"/>
            <a:ext cx="24120" cy="488712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145"/>
          <p:cNvSpPr>
            <a:spLocks noChangeArrowheads="1"/>
          </p:cNvSpPr>
          <p:nvPr/>
        </p:nvSpPr>
        <p:spPr bwMode="auto">
          <a:xfrm>
            <a:off x="3565334" y="663024"/>
            <a:ext cx="30059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1400" b="1" dirty="0" err="1">
                <a:solidFill>
                  <a:srgbClr val="000000"/>
                </a:solidFill>
              </a:rPr>
              <a:t>myc</a:t>
            </a:r>
            <a:endParaRPr lang="en-US" altLang="en-US" sz="3200" dirty="0"/>
          </a:p>
        </p:txBody>
      </p:sp>
      <p:sp>
        <p:nvSpPr>
          <p:cNvPr id="65" name="TextBox 64"/>
          <p:cNvSpPr txBox="1"/>
          <p:nvPr/>
        </p:nvSpPr>
        <p:spPr>
          <a:xfrm>
            <a:off x="609600" y="19185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66" name="TextBox 65"/>
          <p:cNvSpPr txBox="1"/>
          <p:nvPr/>
        </p:nvSpPr>
        <p:spPr>
          <a:xfrm>
            <a:off x="617616" y="213360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grpSp>
        <p:nvGrpSpPr>
          <p:cNvPr id="4124" name="Group 63"/>
          <p:cNvGrpSpPr>
            <a:grpSpLocks noChangeAspect="1"/>
          </p:cNvGrpSpPr>
          <p:nvPr/>
        </p:nvGrpSpPr>
        <p:grpSpPr bwMode="auto">
          <a:xfrm>
            <a:off x="5308600" y="3556001"/>
            <a:ext cx="3225800" cy="2455864"/>
            <a:chOff x="3344" y="2240"/>
            <a:chExt cx="2032" cy="1547"/>
          </a:xfrm>
        </p:grpSpPr>
        <p:sp>
          <p:nvSpPr>
            <p:cNvPr id="4125" name="AutoShape 62"/>
            <p:cNvSpPr>
              <a:spLocks noChangeAspect="1" noChangeArrowheads="1" noTextEdit="1"/>
            </p:cNvSpPr>
            <p:nvPr/>
          </p:nvSpPr>
          <p:spPr bwMode="auto">
            <a:xfrm>
              <a:off x="3344" y="2352"/>
              <a:ext cx="2032" cy="14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26" name="Freeform 64"/>
            <p:cNvSpPr>
              <a:spLocks/>
            </p:cNvSpPr>
            <p:nvPr/>
          </p:nvSpPr>
          <p:spPr bwMode="auto">
            <a:xfrm>
              <a:off x="3594" y="2432"/>
              <a:ext cx="1234" cy="1237"/>
            </a:xfrm>
            <a:custGeom>
              <a:avLst/>
              <a:gdLst>
                <a:gd name="T0" fmla="*/ 512 w 1234"/>
                <a:gd name="T1" fmla="*/ 8 h 1237"/>
                <a:gd name="T2" fmla="*/ 355 w 1234"/>
                <a:gd name="T3" fmla="*/ 59 h 1237"/>
                <a:gd name="T4" fmla="*/ 216 w 1234"/>
                <a:gd name="T5" fmla="*/ 149 h 1237"/>
                <a:gd name="T6" fmla="*/ 107 w 1234"/>
                <a:gd name="T7" fmla="*/ 272 h 1237"/>
                <a:gd name="T8" fmla="*/ 33 w 1234"/>
                <a:gd name="T9" fmla="*/ 419 h 1237"/>
                <a:gd name="T10" fmla="*/ 1 w 1234"/>
                <a:gd name="T11" fmla="*/ 583 h 1237"/>
                <a:gd name="T12" fmla="*/ 14 w 1234"/>
                <a:gd name="T13" fmla="*/ 747 h 1237"/>
                <a:gd name="T14" fmla="*/ 69 w 1234"/>
                <a:gd name="T15" fmla="*/ 903 h 1237"/>
                <a:gd name="T16" fmla="*/ 164 w 1234"/>
                <a:gd name="T17" fmla="*/ 1039 h 1237"/>
                <a:gd name="T18" fmla="*/ 291 w 1234"/>
                <a:gd name="T19" fmla="*/ 1143 h 1237"/>
                <a:gd name="T20" fmla="*/ 442 w 1234"/>
                <a:gd name="T21" fmla="*/ 1211 h 1237"/>
                <a:gd name="T22" fmla="*/ 605 w 1234"/>
                <a:gd name="T23" fmla="*/ 1237 h 1237"/>
                <a:gd name="T24" fmla="*/ 769 w 1234"/>
                <a:gd name="T25" fmla="*/ 1217 h 1237"/>
                <a:gd name="T26" fmla="*/ 922 w 1234"/>
                <a:gd name="T27" fmla="*/ 1156 h 1237"/>
                <a:gd name="T28" fmla="*/ 1054 w 1234"/>
                <a:gd name="T29" fmla="*/ 1055 h 1237"/>
                <a:gd name="T30" fmla="*/ 1153 w 1234"/>
                <a:gd name="T31" fmla="*/ 923 h 1237"/>
                <a:gd name="T32" fmla="*/ 1215 w 1234"/>
                <a:gd name="T33" fmla="*/ 770 h 1237"/>
                <a:gd name="T34" fmla="*/ 1234 w 1234"/>
                <a:gd name="T35" fmla="*/ 606 h 1237"/>
                <a:gd name="T36" fmla="*/ 1208 w 1234"/>
                <a:gd name="T37" fmla="*/ 443 h 1237"/>
                <a:gd name="T38" fmla="*/ 1140 w 1234"/>
                <a:gd name="T39" fmla="*/ 292 h 1237"/>
                <a:gd name="T40" fmla="*/ 1035 w 1234"/>
                <a:gd name="T41" fmla="*/ 165 h 1237"/>
                <a:gd name="T42" fmla="*/ 901 w 1234"/>
                <a:gd name="T43" fmla="*/ 69 h 1237"/>
                <a:gd name="T44" fmla="*/ 745 w 1234"/>
                <a:gd name="T45" fmla="*/ 13 h 1237"/>
                <a:gd name="T46" fmla="*/ 623 w 1234"/>
                <a:gd name="T47" fmla="*/ 0 h 1237"/>
                <a:gd name="T48" fmla="*/ 730 w 1234"/>
                <a:gd name="T49" fmla="*/ 24 h 1237"/>
                <a:gd name="T50" fmla="*/ 883 w 1234"/>
                <a:gd name="T51" fmla="*/ 75 h 1237"/>
                <a:gd name="T52" fmla="*/ 1018 w 1234"/>
                <a:gd name="T53" fmla="*/ 166 h 1237"/>
                <a:gd name="T54" fmla="*/ 1123 w 1234"/>
                <a:gd name="T55" fmla="*/ 288 h 1237"/>
                <a:gd name="T56" fmla="*/ 1192 w 1234"/>
                <a:gd name="T57" fmla="*/ 434 h 1237"/>
                <a:gd name="T58" fmla="*/ 1220 w 1234"/>
                <a:gd name="T59" fmla="*/ 595 h 1237"/>
                <a:gd name="T60" fmla="*/ 1205 w 1234"/>
                <a:gd name="T61" fmla="*/ 755 h 1237"/>
                <a:gd name="T62" fmla="*/ 1148 w 1234"/>
                <a:gd name="T63" fmla="*/ 907 h 1237"/>
                <a:gd name="T64" fmla="*/ 1052 w 1234"/>
                <a:gd name="T65" fmla="*/ 1037 h 1237"/>
                <a:gd name="T66" fmla="*/ 927 w 1234"/>
                <a:gd name="T67" fmla="*/ 1139 h 1237"/>
                <a:gd name="T68" fmla="*/ 778 w 1234"/>
                <a:gd name="T69" fmla="*/ 1202 h 1237"/>
                <a:gd name="T70" fmla="*/ 618 w 1234"/>
                <a:gd name="T71" fmla="*/ 1224 h 1237"/>
                <a:gd name="T72" fmla="*/ 457 w 1234"/>
                <a:gd name="T73" fmla="*/ 1202 h 1237"/>
                <a:gd name="T74" fmla="*/ 309 w 1234"/>
                <a:gd name="T75" fmla="*/ 1139 h 1237"/>
                <a:gd name="T76" fmla="*/ 182 w 1234"/>
                <a:gd name="T77" fmla="*/ 1039 h 1237"/>
                <a:gd name="T78" fmla="*/ 86 w 1234"/>
                <a:gd name="T79" fmla="*/ 907 h 1237"/>
                <a:gd name="T80" fmla="*/ 29 w 1234"/>
                <a:gd name="T81" fmla="*/ 757 h 1237"/>
                <a:gd name="T82" fmla="*/ 14 w 1234"/>
                <a:gd name="T83" fmla="*/ 595 h 1237"/>
                <a:gd name="T84" fmla="*/ 42 w 1234"/>
                <a:gd name="T85" fmla="*/ 435 h 1237"/>
                <a:gd name="T86" fmla="*/ 110 w 1234"/>
                <a:gd name="T87" fmla="*/ 289 h 1237"/>
                <a:gd name="T88" fmla="*/ 215 w 1234"/>
                <a:gd name="T89" fmla="*/ 166 h 1237"/>
                <a:gd name="T90" fmla="*/ 349 w 1234"/>
                <a:gd name="T91" fmla="*/ 76 h 1237"/>
                <a:gd name="T92" fmla="*/ 502 w 1234"/>
                <a:gd name="T93" fmla="*/ 24 h 1237"/>
                <a:gd name="T94" fmla="*/ 622 w 1234"/>
                <a:gd name="T95" fmla="*/ 13 h 12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1234" h="1237">
                  <a:moveTo>
                    <a:pt x="622" y="0"/>
                  </a:moveTo>
                  <a:lnTo>
                    <a:pt x="567" y="3"/>
                  </a:lnTo>
                  <a:lnTo>
                    <a:pt x="512" y="8"/>
                  </a:lnTo>
                  <a:lnTo>
                    <a:pt x="457" y="21"/>
                  </a:lnTo>
                  <a:lnTo>
                    <a:pt x="405" y="37"/>
                  </a:lnTo>
                  <a:lnTo>
                    <a:pt x="355" y="59"/>
                  </a:lnTo>
                  <a:lnTo>
                    <a:pt x="306" y="84"/>
                  </a:lnTo>
                  <a:lnTo>
                    <a:pt x="260" y="114"/>
                  </a:lnTo>
                  <a:lnTo>
                    <a:pt x="216" y="149"/>
                  </a:lnTo>
                  <a:lnTo>
                    <a:pt x="176" y="186"/>
                  </a:lnTo>
                  <a:lnTo>
                    <a:pt x="138" y="227"/>
                  </a:lnTo>
                  <a:lnTo>
                    <a:pt x="107" y="272"/>
                  </a:lnTo>
                  <a:lnTo>
                    <a:pt x="78" y="320"/>
                  </a:lnTo>
                  <a:lnTo>
                    <a:pt x="53" y="369"/>
                  </a:lnTo>
                  <a:lnTo>
                    <a:pt x="33" y="419"/>
                  </a:lnTo>
                  <a:lnTo>
                    <a:pt x="17" y="473"/>
                  </a:lnTo>
                  <a:lnTo>
                    <a:pt x="7" y="528"/>
                  </a:lnTo>
                  <a:lnTo>
                    <a:pt x="1" y="583"/>
                  </a:lnTo>
                  <a:lnTo>
                    <a:pt x="0" y="638"/>
                  </a:lnTo>
                  <a:lnTo>
                    <a:pt x="4" y="693"/>
                  </a:lnTo>
                  <a:lnTo>
                    <a:pt x="14" y="747"/>
                  </a:lnTo>
                  <a:lnTo>
                    <a:pt x="27" y="800"/>
                  </a:lnTo>
                  <a:lnTo>
                    <a:pt x="46" y="852"/>
                  </a:lnTo>
                  <a:lnTo>
                    <a:pt x="69" y="903"/>
                  </a:lnTo>
                  <a:lnTo>
                    <a:pt x="97" y="951"/>
                  </a:lnTo>
                  <a:lnTo>
                    <a:pt x="128" y="995"/>
                  </a:lnTo>
                  <a:lnTo>
                    <a:pt x="164" y="1039"/>
                  </a:lnTo>
                  <a:lnTo>
                    <a:pt x="203" y="1077"/>
                  </a:lnTo>
                  <a:lnTo>
                    <a:pt x="245" y="1113"/>
                  </a:lnTo>
                  <a:lnTo>
                    <a:pt x="291" y="1143"/>
                  </a:lnTo>
                  <a:lnTo>
                    <a:pt x="339" y="1171"/>
                  </a:lnTo>
                  <a:lnTo>
                    <a:pt x="390" y="1194"/>
                  </a:lnTo>
                  <a:lnTo>
                    <a:pt x="442" y="1211"/>
                  </a:lnTo>
                  <a:lnTo>
                    <a:pt x="495" y="1224"/>
                  </a:lnTo>
                  <a:lnTo>
                    <a:pt x="550" y="1233"/>
                  </a:lnTo>
                  <a:lnTo>
                    <a:pt x="605" y="1237"/>
                  </a:lnTo>
                  <a:lnTo>
                    <a:pt x="660" y="1236"/>
                  </a:lnTo>
                  <a:lnTo>
                    <a:pt x="714" y="1229"/>
                  </a:lnTo>
                  <a:lnTo>
                    <a:pt x="769" y="1217"/>
                  </a:lnTo>
                  <a:lnTo>
                    <a:pt x="821" y="1201"/>
                  </a:lnTo>
                  <a:lnTo>
                    <a:pt x="873" y="1181"/>
                  </a:lnTo>
                  <a:lnTo>
                    <a:pt x="922" y="1156"/>
                  </a:lnTo>
                  <a:lnTo>
                    <a:pt x="969" y="1126"/>
                  </a:lnTo>
                  <a:lnTo>
                    <a:pt x="1012" y="1092"/>
                  </a:lnTo>
                  <a:lnTo>
                    <a:pt x="1054" y="1055"/>
                  </a:lnTo>
                  <a:lnTo>
                    <a:pt x="1090" y="1014"/>
                  </a:lnTo>
                  <a:lnTo>
                    <a:pt x="1124" y="971"/>
                  </a:lnTo>
                  <a:lnTo>
                    <a:pt x="1153" y="923"/>
                  </a:lnTo>
                  <a:lnTo>
                    <a:pt x="1178" y="874"/>
                  </a:lnTo>
                  <a:lnTo>
                    <a:pt x="1200" y="823"/>
                  </a:lnTo>
                  <a:lnTo>
                    <a:pt x="1215" y="770"/>
                  </a:lnTo>
                  <a:lnTo>
                    <a:pt x="1226" y="716"/>
                  </a:lnTo>
                  <a:lnTo>
                    <a:pt x="1233" y="661"/>
                  </a:lnTo>
                  <a:lnTo>
                    <a:pt x="1234" y="606"/>
                  </a:lnTo>
                  <a:lnTo>
                    <a:pt x="1230" y="551"/>
                  </a:lnTo>
                  <a:lnTo>
                    <a:pt x="1221" y="496"/>
                  </a:lnTo>
                  <a:lnTo>
                    <a:pt x="1208" y="443"/>
                  </a:lnTo>
                  <a:lnTo>
                    <a:pt x="1191" y="390"/>
                  </a:lnTo>
                  <a:lnTo>
                    <a:pt x="1168" y="340"/>
                  </a:lnTo>
                  <a:lnTo>
                    <a:pt x="1140" y="292"/>
                  </a:lnTo>
                  <a:lnTo>
                    <a:pt x="1110" y="246"/>
                  </a:lnTo>
                  <a:lnTo>
                    <a:pt x="1074" y="204"/>
                  </a:lnTo>
                  <a:lnTo>
                    <a:pt x="1035" y="165"/>
                  </a:lnTo>
                  <a:lnTo>
                    <a:pt x="993" y="128"/>
                  </a:lnTo>
                  <a:lnTo>
                    <a:pt x="948" y="97"/>
                  </a:lnTo>
                  <a:lnTo>
                    <a:pt x="901" y="69"/>
                  </a:lnTo>
                  <a:lnTo>
                    <a:pt x="850" y="46"/>
                  </a:lnTo>
                  <a:lnTo>
                    <a:pt x="798" y="27"/>
                  </a:lnTo>
                  <a:lnTo>
                    <a:pt x="745" y="13"/>
                  </a:lnTo>
                  <a:lnTo>
                    <a:pt x="690" y="4"/>
                  </a:lnTo>
                  <a:lnTo>
                    <a:pt x="635" y="0"/>
                  </a:lnTo>
                  <a:lnTo>
                    <a:pt x="623" y="0"/>
                  </a:lnTo>
                  <a:lnTo>
                    <a:pt x="623" y="13"/>
                  </a:lnTo>
                  <a:lnTo>
                    <a:pt x="677" y="16"/>
                  </a:lnTo>
                  <a:lnTo>
                    <a:pt x="730" y="24"/>
                  </a:lnTo>
                  <a:lnTo>
                    <a:pt x="782" y="36"/>
                  </a:lnTo>
                  <a:lnTo>
                    <a:pt x="834" y="53"/>
                  </a:lnTo>
                  <a:lnTo>
                    <a:pt x="883" y="75"/>
                  </a:lnTo>
                  <a:lnTo>
                    <a:pt x="931" y="101"/>
                  </a:lnTo>
                  <a:lnTo>
                    <a:pt x="976" y="131"/>
                  </a:lnTo>
                  <a:lnTo>
                    <a:pt x="1018" y="166"/>
                  </a:lnTo>
                  <a:lnTo>
                    <a:pt x="1057" y="204"/>
                  </a:lnTo>
                  <a:lnTo>
                    <a:pt x="1091" y="244"/>
                  </a:lnTo>
                  <a:lnTo>
                    <a:pt x="1123" y="288"/>
                  </a:lnTo>
                  <a:lnTo>
                    <a:pt x="1150" y="335"/>
                  </a:lnTo>
                  <a:lnTo>
                    <a:pt x="1174" y="383"/>
                  </a:lnTo>
                  <a:lnTo>
                    <a:pt x="1192" y="434"/>
                  </a:lnTo>
                  <a:lnTo>
                    <a:pt x="1207" y="487"/>
                  </a:lnTo>
                  <a:lnTo>
                    <a:pt x="1215" y="540"/>
                  </a:lnTo>
                  <a:lnTo>
                    <a:pt x="1220" y="595"/>
                  </a:lnTo>
                  <a:lnTo>
                    <a:pt x="1220" y="648"/>
                  </a:lnTo>
                  <a:lnTo>
                    <a:pt x="1215" y="702"/>
                  </a:lnTo>
                  <a:lnTo>
                    <a:pt x="1205" y="755"/>
                  </a:lnTo>
                  <a:lnTo>
                    <a:pt x="1191" y="807"/>
                  </a:lnTo>
                  <a:lnTo>
                    <a:pt x="1171" y="858"/>
                  </a:lnTo>
                  <a:lnTo>
                    <a:pt x="1148" y="907"/>
                  </a:lnTo>
                  <a:lnTo>
                    <a:pt x="1120" y="954"/>
                  </a:lnTo>
                  <a:lnTo>
                    <a:pt x="1088" y="997"/>
                  </a:lnTo>
                  <a:lnTo>
                    <a:pt x="1052" y="1037"/>
                  </a:lnTo>
                  <a:lnTo>
                    <a:pt x="1013" y="1075"/>
                  </a:lnTo>
                  <a:lnTo>
                    <a:pt x="971" y="1108"/>
                  </a:lnTo>
                  <a:lnTo>
                    <a:pt x="927" y="1139"/>
                  </a:lnTo>
                  <a:lnTo>
                    <a:pt x="879" y="1163"/>
                  </a:lnTo>
                  <a:lnTo>
                    <a:pt x="829" y="1185"/>
                  </a:lnTo>
                  <a:lnTo>
                    <a:pt x="778" y="1202"/>
                  </a:lnTo>
                  <a:lnTo>
                    <a:pt x="725" y="1214"/>
                  </a:lnTo>
                  <a:lnTo>
                    <a:pt x="671" y="1221"/>
                  </a:lnTo>
                  <a:lnTo>
                    <a:pt x="618" y="1224"/>
                  </a:lnTo>
                  <a:lnTo>
                    <a:pt x="563" y="1221"/>
                  </a:lnTo>
                  <a:lnTo>
                    <a:pt x="509" y="1214"/>
                  </a:lnTo>
                  <a:lnTo>
                    <a:pt x="457" y="1202"/>
                  </a:lnTo>
                  <a:lnTo>
                    <a:pt x="405" y="1185"/>
                  </a:lnTo>
                  <a:lnTo>
                    <a:pt x="356" y="1165"/>
                  </a:lnTo>
                  <a:lnTo>
                    <a:pt x="309" y="1139"/>
                  </a:lnTo>
                  <a:lnTo>
                    <a:pt x="264" y="1110"/>
                  </a:lnTo>
                  <a:lnTo>
                    <a:pt x="221" y="1075"/>
                  </a:lnTo>
                  <a:lnTo>
                    <a:pt x="182" y="1039"/>
                  </a:lnTo>
                  <a:lnTo>
                    <a:pt x="147" y="998"/>
                  </a:lnTo>
                  <a:lnTo>
                    <a:pt x="114" y="954"/>
                  </a:lnTo>
                  <a:lnTo>
                    <a:pt x="86" y="907"/>
                  </a:lnTo>
                  <a:lnTo>
                    <a:pt x="63" y="859"/>
                  </a:lnTo>
                  <a:lnTo>
                    <a:pt x="43" y="809"/>
                  </a:lnTo>
                  <a:lnTo>
                    <a:pt x="29" y="757"/>
                  </a:lnTo>
                  <a:lnTo>
                    <a:pt x="19" y="703"/>
                  </a:lnTo>
                  <a:lnTo>
                    <a:pt x="14" y="650"/>
                  </a:lnTo>
                  <a:lnTo>
                    <a:pt x="14" y="595"/>
                  </a:lnTo>
                  <a:lnTo>
                    <a:pt x="19" y="541"/>
                  </a:lnTo>
                  <a:lnTo>
                    <a:pt x="27" y="487"/>
                  </a:lnTo>
                  <a:lnTo>
                    <a:pt x="42" y="435"/>
                  </a:lnTo>
                  <a:lnTo>
                    <a:pt x="60" y="385"/>
                  </a:lnTo>
                  <a:lnTo>
                    <a:pt x="84" y="335"/>
                  </a:lnTo>
                  <a:lnTo>
                    <a:pt x="110" y="289"/>
                  </a:lnTo>
                  <a:lnTo>
                    <a:pt x="141" y="246"/>
                  </a:lnTo>
                  <a:lnTo>
                    <a:pt x="176" y="204"/>
                  </a:lnTo>
                  <a:lnTo>
                    <a:pt x="215" y="166"/>
                  </a:lnTo>
                  <a:lnTo>
                    <a:pt x="257" y="133"/>
                  </a:lnTo>
                  <a:lnTo>
                    <a:pt x="302" y="102"/>
                  </a:lnTo>
                  <a:lnTo>
                    <a:pt x="349" y="76"/>
                  </a:lnTo>
                  <a:lnTo>
                    <a:pt x="398" y="55"/>
                  </a:lnTo>
                  <a:lnTo>
                    <a:pt x="450" y="37"/>
                  </a:lnTo>
                  <a:lnTo>
                    <a:pt x="502" y="24"/>
                  </a:lnTo>
                  <a:lnTo>
                    <a:pt x="556" y="16"/>
                  </a:lnTo>
                  <a:lnTo>
                    <a:pt x="609" y="13"/>
                  </a:lnTo>
                  <a:lnTo>
                    <a:pt x="622" y="13"/>
                  </a:lnTo>
                  <a:lnTo>
                    <a:pt x="622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27" name="Oval 65"/>
            <p:cNvSpPr>
              <a:spLocks noChangeArrowheads="1"/>
            </p:cNvSpPr>
            <p:nvPr/>
          </p:nvSpPr>
          <p:spPr bwMode="auto">
            <a:xfrm>
              <a:off x="3594" y="2432"/>
              <a:ext cx="1226" cy="1229"/>
            </a:xfrm>
            <a:prstGeom prst="ellips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28" name="Oval 66"/>
            <p:cNvSpPr>
              <a:spLocks noChangeArrowheads="1"/>
            </p:cNvSpPr>
            <p:nvPr/>
          </p:nvSpPr>
          <p:spPr bwMode="auto">
            <a:xfrm>
              <a:off x="3607" y="2445"/>
              <a:ext cx="1200" cy="1203"/>
            </a:xfrm>
            <a:prstGeom prst="ellips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29" name="Line 67"/>
            <p:cNvSpPr>
              <a:spLocks noChangeShapeType="1"/>
            </p:cNvSpPr>
            <p:nvPr/>
          </p:nvSpPr>
          <p:spPr bwMode="auto">
            <a:xfrm flipV="1">
              <a:off x="4216" y="243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30" name="Rectangle 68"/>
            <p:cNvSpPr>
              <a:spLocks noChangeArrowheads="1"/>
            </p:cNvSpPr>
            <p:nvPr/>
          </p:nvSpPr>
          <p:spPr bwMode="auto">
            <a:xfrm>
              <a:off x="4030" y="2927"/>
              <a:ext cx="391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MA4008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31" name="Rectangle 69"/>
            <p:cNvSpPr>
              <a:spLocks noChangeArrowheads="1"/>
            </p:cNvSpPr>
            <p:nvPr/>
          </p:nvSpPr>
          <p:spPr bwMode="auto">
            <a:xfrm>
              <a:off x="4017" y="3055"/>
              <a:ext cx="41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itchFamily="49" charset="0"/>
                  <a:cs typeface="Arial" pitchFamily="34" charset="0"/>
                </a:rPr>
                <a:t>6767 bp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32" name="Freeform 70"/>
            <p:cNvSpPr>
              <a:spLocks/>
            </p:cNvSpPr>
            <p:nvPr/>
          </p:nvSpPr>
          <p:spPr bwMode="auto">
            <a:xfrm>
              <a:off x="4049" y="3387"/>
              <a:ext cx="682" cy="307"/>
            </a:xfrm>
            <a:custGeom>
              <a:avLst/>
              <a:gdLst>
                <a:gd name="T0" fmla="*/ 49 w 682"/>
                <a:gd name="T1" fmla="*/ 219 h 307"/>
                <a:gd name="T2" fmla="*/ 0 w 682"/>
                <a:gd name="T3" fmla="*/ 253 h 307"/>
                <a:gd name="T4" fmla="*/ 30 w 682"/>
                <a:gd name="T5" fmla="*/ 307 h 307"/>
                <a:gd name="T6" fmla="*/ 34 w 682"/>
                <a:gd name="T7" fmla="*/ 287 h 307"/>
                <a:gd name="T8" fmla="*/ 91 w 682"/>
                <a:gd name="T9" fmla="*/ 297 h 307"/>
                <a:gd name="T10" fmla="*/ 147 w 682"/>
                <a:gd name="T11" fmla="*/ 300 h 307"/>
                <a:gd name="T12" fmla="*/ 203 w 682"/>
                <a:gd name="T13" fmla="*/ 300 h 307"/>
                <a:gd name="T14" fmla="*/ 259 w 682"/>
                <a:gd name="T15" fmla="*/ 292 h 307"/>
                <a:gd name="T16" fmla="*/ 316 w 682"/>
                <a:gd name="T17" fmla="*/ 281 h 307"/>
                <a:gd name="T18" fmla="*/ 371 w 682"/>
                <a:gd name="T19" fmla="*/ 265 h 307"/>
                <a:gd name="T20" fmla="*/ 423 w 682"/>
                <a:gd name="T21" fmla="*/ 245 h 307"/>
                <a:gd name="T22" fmla="*/ 473 w 682"/>
                <a:gd name="T23" fmla="*/ 219 h 307"/>
                <a:gd name="T24" fmla="*/ 522 w 682"/>
                <a:gd name="T25" fmla="*/ 188 h 307"/>
                <a:gd name="T26" fmla="*/ 567 w 682"/>
                <a:gd name="T27" fmla="*/ 153 h 307"/>
                <a:gd name="T28" fmla="*/ 609 w 682"/>
                <a:gd name="T29" fmla="*/ 116 h 307"/>
                <a:gd name="T30" fmla="*/ 648 w 682"/>
                <a:gd name="T31" fmla="*/ 74 h 307"/>
                <a:gd name="T32" fmla="*/ 682 w 682"/>
                <a:gd name="T33" fmla="*/ 29 h 307"/>
                <a:gd name="T34" fmla="*/ 682 w 682"/>
                <a:gd name="T35" fmla="*/ 29 h 307"/>
                <a:gd name="T36" fmla="*/ 641 w 682"/>
                <a:gd name="T37" fmla="*/ 0 h 307"/>
                <a:gd name="T38" fmla="*/ 609 w 682"/>
                <a:gd name="T39" fmla="*/ 40 h 307"/>
                <a:gd name="T40" fmla="*/ 574 w 682"/>
                <a:gd name="T41" fmla="*/ 80 h 307"/>
                <a:gd name="T42" fmla="*/ 535 w 682"/>
                <a:gd name="T43" fmla="*/ 114 h 307"/>
                <a:gd name="T44" fmla="*/ 493 w 682"/>
                <a:gd name="T45" fmla="*/ 146 h 307"/>
                <a:gd name="T46" fmla="*/ 449 w 682"/>
                <a:gd name="T47" fmla="*/ 175 h 307"/>
                <a:gd name="T48" fmla="*/ 402 w 682"/>
                <a:gd name="T49" fmla="*/ 198 h 307"/>
                <a:gd name="T50" fmla="*/ 353 w 682"/>
                <a:gd name="T51" fmla="*/ 217 h 307"/>
                <a:gd name="T52" fmla="*/ 304 w 682"/>
                <a:gd name="T53" fmla="*/ 233 h 307"/>
                <a:gd name="T54" fmla="*/ 252 w 682"/>
                <a:gd name="T55" fmla="*/ 243 h 307"/>
                <a:gd name="T56" fmla="*/ 200 w 682"/>
                <a:gd name="T57" fmla="*/ 249 h 307"/>
                <a:gd name="T58" fmla="*/ 148 w 682"/>
                <a:gd name="T59" fmla="*/ 250 h 307"/>
                <a:gd name="T60" fmla="*/ 96 w 682"/>
                <a:gd name="T61" fmla="*/ 246 h 307"/>
                <a:gd name="T62" fmla="*/ 44 w 682"/>
                <a:gd name="T63" fmla="*/ 237 h 307"/>
                <a:gd name="T64" fmla="*/ 44 w 682"/>
                <a:gd name="T65" fmla="*/ 237 h 307"/>
                <a:gd name="T66" fmla="*/ 49 w 682"/>
                <a:gd name="T67" fmla="*/ 219 h 3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682" h="307">
                  <a:moveTo>
                    <a:pt x="49" y="219"/>
                  </a:moveTo>
                  <a:lnTo>
                    <a:pt x="0" y="253"/>
                  </a:lnTo>
                  <a:lnTo>
                    <a:pt x="30" y="307"/>
                  </a:lnTo>
                  <a:lnTo>
                    <a:pt x="34" y="287"/>
                  </a:lnTo>
                  <a:lnTo>
                    <a:pt x="91" y="297"/>
                  </a:lnTo>
                  <a:lnTo>
                    <a:pt x="147" y="300"/>
                  </a:lnTo>
                  <a:lnTo>
                    <a:pt x="203" y="300"/>
                  </a:lnTo>
                  <a:lnTo>
                    <a:pt x="259" y="292"/>
                  </a:lnTo>
                  <a:lnTo>
                    <a:pt x="316" y="281"/>
                  </a:lnTo>
                  <a:lnTo>
                    <a:pt x="371" y="265"/>
                  </a:lnTo>
                  <a:lnTo>
                    <a:pt x="423" y="245"/>
                  </a:lnTo>
                  <a:lnTo>
                    <a:pt x="473" y="219"/>
                  </a:lnTo>
                  <a:lnTo>
                    <a:pt x="522" y="188"/>
                  </a:lnTo>
                  <a:lnTo>
                    <a:pt x="567" y="153"/>
                  </a:lnTo>
                  <a:lnTo>
                    <a:pt x="609" y="116"/>
                  </a:lnTo>
                  <a:lnTo>
                    <a:pt x="648" y="74"/>
                  </a:lnTo>
                  <a:lnTo>
                    <a:pt x="682" y="29"/>
                  </a:lnTo>
                  <a:lnTo>
                    <a:pt x="682" y="29"/>
                  </a:lnTo>
                  <a:lnTo>
                    <a:pt x="641" y="0"/>
                  </a:lnTo>
                  <a:lnTo>
                    <a:pt x="609" y="40"/>
                  </a:lnTo>
                  <a:lnTo>
                    <a:pt x="574" y="80"/>
                  </a:lnTo>
                  <a:lnTo>
                    <a:pt x="535" y="114"/>
                  </a:lnTo>
                  <a:lnTo>
                    <a:pt x="493" y="146"/>
                  </a:lnTo>
                  <a:lnTo>
                    <a:pt x="449" y="175"/>
                  </a:lnTo>
                  <a:lnTo>
                    <a:pt x="402" y="198"/>
                  </a:lnTo>
                  <a:lnTo>
                    <a:pt x="353" y="217"/>
                  </a:lnTo>
                  <a:lnTo>
                    <a:pt x="304" y="233"/>
                  </a:lnTo>
                  <a:lnTo>
                    <a:pt x="252" y="243"/>
                  </a:lnTo>
                  <a:lnTo>
                    <a:pt x="200" y="249"/>
                  </a:lnTo>
                  <a:lnTo>
                    <a:pt x="148" y="250"/>
                  </a:lnTo>
                  <a:lnTo>
                    <a:pt x="96" y="246"/>
                  </a:lnTo>
                  <a:lnTo>
                    <a:pt x="44" y="237"/>
                  </a:lnTo>
                  <a:lnTo>
                    <a:pt x="44" y="237"/>
                  </a:lnTo>
                  <a:lnTo>
                    <a:pt x="49" y="219"/>
                  </a:lnTo>
                  <a:close/>
                </a:path>
              </a:pathLst>
            </a:custGeom>
            <a:solidFill>
              <a:srgbClr val="FF66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33" name="Arc 71"/>
            <p:cNvSpPr>
              <a:spLocks/>
            </p:cNvSpPr>
            <p:nvPr/>
          </p:nvSpPr>
          <p:spPr bwMode="auto">
            <a:xfrm>
              <a:off x="4084" y="3047"/>
              <a:ext cx="639" cy="633"/>
            </a:xfrm>
            <a:custGeom>
              <a:avLst/>
              <a:gdLst>
                <a:gd name="G0" fmla="+- 4200 0 0"/>
                <a:gd name="G1" fmla="+- 0 0 0"/>
                <a:gd name="G2" fmla="+- 21600 0 0"/>
                <a:gd name="T0" fmla="*/ 21874 w 21874"/>
                <a:gd name="T1" fmla="*/ 12417 h 21600"/>
                <a:gd name="T2" fmla="*/ 0 w 21874"/>
                <a:gd name="T3" fmla="*/ 21188 h 21600"/>
                <a:gd name="T4" fmla="*/ 4200 w 21874"/>
                <a:gd name="T5" fmla="*/ 0 h 216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874" h="21600" fill="none" extrusionOk="0">
                  <a:moveTo>
                    <a:pt x="21874" y="12417"/>
                  </a:moveTo>
                  <a:cubicBezTo>
                    <a:pt x="17829" y="18173"/>
                    <a:pt x="11235" y="21599"/>
                    <a:pt x="4200" y="21600"/>
                  </a:cubicBezTo>
                  <a:cubicBezTo>
                    <a:pt x="2789" y="21600"/>
                    <a:pt x="1383" y="21461"/>
                    <a:pt x="0" y="21187"/>
                  </a:cubicBezTo>
                </a:path>
                <a:path w="21874" h="21600" stroke="0" extrusionOk="0">
                  <a:moveTo>
                    <a:pt x="21874" y="12417"/>
                  </a:moveTo>
                  <a:cubicBezTo>
                    <a:pt x="17829" y="18173"/>
                    <a:pt x="11235" y="21599"/>
                    <a:pt x="4200" y="21600"/>
                  </a:cubicBezTo>
                  <a:cubicBezTo>
                    <a:pt x="2789" y="21600"/>
                    <a:pt x="1383" y="21461"/>
                    <a:pt x="0" y="21187"/>
                  </a:cubicBezTo>
                  <a:lnTo>
                    <a:pt x="4200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34" name="Arc 72"/>
            <p:cNvSpPr>
              <a:spLocks/>
            </p:cNvSpPr>
            <p:nvPr/>
          </p:nvSpPr>
          <p:spPr bwMode="auto">
            <a:xfrm>
              <a:off x="4094" y="3047"/>
              <a:ext cx="590" cy="584"/>
            </a:xfrm>
            <a:custGeom>
              <a:avLst/>
              <a:gdLst>
                <a:gd name="G0" fmla="+- 4236 0 0"/>
                <a:gd name="G1" fmla="+- 0 0 0"/>
                <a:gd name="G2" fmla="+- 21600 0 0"/>
                <a:gd name="T0" fmla="*/ 21907 w 21907"/>
                <a:gd name="T1" fmla="*/ 12422 h 21600"/>
                <a:gd name="T2" fmla="*/ 0 w 21907"/>
                <a:gd name="T3" fmla="*/ 21181 h 21600"/>
                <a:gd name="T4" fmla="*/ 4236 w 21907"/>
                <a:gd name="T5" fmla="*/ 0 h 216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907" h="21600" fill="none" extrusionOk="0">
                  <a:moveTo>
                    <a:pt x="21906" y="12421"/>
                  </a:moveTo>
                  <a:cubicBezTo>
                    <a:pt x="17862" y="18175"/>
                    <a:pt x="11269" y="21599"/>
                    <a:pt x="4236" y="21600"/>
                  </a:cubicBezTo>
                  <a:cubicBezTo>
                    <a:pt x="2813" y="21600"/>
                    <a:pt x="1394" y="21459"/>
                    <a:pt x="0" y="21180"/>
                  </a:cubicBezTo>
                </a:path>
                <a:path w="21907" h="21600" stroke="0" extrusionOk="0">
                  <a:moveTo>
                    <a:pt x="21906" y="12421"/>
                  </a:moveTo>
                  <a:cubicBezTo>
                    <a:pt x="17862" y="18175"/>
                    <a:pt x="11269" y="21599"/>
                    <a:pt x="4236" y="21600"/>
                  </a:cubicBezTo>
                  <a:cubicBezTo>
                    <a:pt x="2813" y="21600"/>
                    <a:pt x="1394" y="21459"/>
                    <a:pt x="0" y="21180"/>
                  </a:cubicBezTo>
                  <a:lnTo>
                    <a:pt x="4236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35" name="Line 73"/>
            <p:cNvSpPr>
              <a:spLocks noChangeShapeType="1"/>
            </p:cNvSpPr>
            <p:nvPr/>
          </p:nvSpPr>
          <p:spPr bwMode="auto">
            <a:xfrm>
              <a:off x="4690" y="3387"/>
              <a:ext cx="41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36" name="Freeform 74"/>
            <p:cNvSpPr>
              <a:spLocks/>
            </p:cNvSpPr>
            <p:nvPr/>
          </p:nvSpPr>
          <p:spPr bwMode="auto">
            <a:xfrm>
              <a:off x="4049" y="3606"/>
              <a:ext cx="49" cy="88"/>
            </a:xfrm>
            <a:custGeom>
              <a:avLst/>
              <a:gdLst>
                <a:gd name="T0" fmla="*/ 31 w 34"/>
                <a:gd name="T1" fmla="*/ 13 h 61"/>
                <a:gd name="T2" fmla="*/ 34 w 34"/>
                <a:gd name="T3" fmla="*/ 0 h 61"/>
                <a:gd name="T4" fmla="*/ 0 w 34"/>
                <a:gd name="T5" fmla="*/ 24 h 61"/>
                <a:gd name="T6" fmla="*/ 21 w 34"/>
                <a:gd name="T7" fmla="*/ 61 h 61"/>
                <a:gd name="T8" fmla="*/ 24 w 34"/>
                <a:gd name="T9" fmla="*/ 47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4" h="61">
                  <a:moveTo>
                    <a:pt x="31" y="13"/>
                  </a:moveTo>
                  <a:lnTo>
                    <a:pt x="34" y="0"/>
                  </a:lnTo>
                  <a:lnTo>
                    <a:pt x="0" y="24"/>
                  </a:lnTo>
                  <a:lnTo>
                    <a:pt x="21" y="61"/>
                  </a:lnTo>
                  <a:lnTo>
                    <a:pt x="24" y="47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37" name="Line 75"/>
            <p:cNvSpPr>
              <a:spLocks noChangeShapeType="1"/>
            </p:cNvSpPr>
            <p:nvPr/>
          </p:nvSpPr>
          <p:spPr bwMode="auto">
            <a:xfrm flipH="1">
              <a:off x="4427" y="3633"/>
              <a:ext cx="177" cy="16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38" name="Rectangle 76"/>
            <p:cNvSpPr>
              <a:spLocks noChangeArrowheads="1"/>
            </p:cNvSpPr>
            <p:nvPr/>
          </p:nvSpPr>
          <p:spPr bwMode="auto">
            <a:xfrm>
              <a:off x="4609" y="3635"/>
              <a:ext cx="495" cy="1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smtClean="0">
                  <a:ln>
                    <a:noFill/>
                  </a:ln>
                  <a:solidFill>
                    <a:srgbClr val="800000"/>
                  </a:solidFill>
                  <a:effectLst/>
                  <a:latin typeface="Arial" pitchFamily="34" charset="0"/>
                  <a:cs typeface="Arial" pitchFamily="34" charset="0"/>
                </a:rPr>
                <a:t>UL12 M18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39" name="Freeform 77"/>
            <p:cNvSpPr>
              <a:spLocks/>
            </p:cNvSpPr>
            <p:nvPr/>
          </p:nvSpPr>
          <p:spPr bwMode="auto">
            <a:xfrm>
              <a:off x="3568" y="2559"/>
              <a:ext cx="271" cy="415"/>
            </a:xfrm>
            <a:custGeom>
              <a:avLst/>
              <a:gdLst>
                <a:gd name="T0" fmla="*/ 239 w 271"/>
                <a:gd name="T1" fmla="*/ 0 h 415"/>
                <a:gd name="T2" fmla="*/ 196 w 271"/>
                <a:gd name="T3" fmla="*/ 38 h 415"/>
                <a:gd name="T4" fmla="*/ 157 w 271"/>
                <a:gd name="T5" fmla="*/ 80 h 415"/>
                <a:gd name="T6" fmla="*/ 123 w 271"/>
                <a:gd name="T7" fmla="*/ 124 h 415"/>
                <a:gd name="T8" fmla="*/ 92 w 271"/>
                <a:gd name="T9" fmla="*/ 172 h 415"/>
                <a:gd name="T10" fmla="*/ 66 w 271"/>
                <a:gd name="T11" fmla="*/ 223 h 415"/>
                <a:gd name="T12" fmla="*/ 45 w 271"/>
                <a:gd name="T13" fmla="*/ 276 h 415"/>
                <a:gd name="T14" fmla="*/ 29 w 271"/>
                <a:gd name="T15" fmla="*/ 330 h 415"/>
                <a:gd name="T16" fmla="*/ 19 w 271"/>
                <a:gd name="T17" fmla="*/ 372 h 415"/>
                <a:gd name="T18" fmla="*/ 0 w 271"/>
                <a:gd name="T19" fmla="*/ 368 h 415"/>
                <a:gd name="T20" fmla="*/ 37 w 271"/>
                <a:gd name="T21" fmla="*/ 415 h 415"/>
                <a:gd name="T22" fmla="*/ 88 w 271"/>
                <a:gd name="T23" fmla="*/ 385 h 415"/>
                <a:gd name="T24" fmla="*/ 69 w 271"/>
                <a:gd name="T25" fmla="*/ 381 h 415"/>
                <a:gd name="T26" fmla="*/ 81 w 271"/>
                <a:gd name="T27" fmla="*/ 330 h 415"/>
                <a:gd name="T28" fmla="*/ 97 w 271"/>
                <a:gd name="T29" fmla="*/ 279 h 415"/>
                <a:gd name="T30" fmla="*/ 118 w 271"/>
                <a:gd name="T31" fmla="*/ 232 h 415"/>
                <a:gd name="T32" fmla="*/ 143 w 271"/>
                <a:gd name="T33" fmla="*/ 185 h 415"/>
                <a:gd name="T34" fmla="*/ 173 w 271"/>
                <a:gd name="T35" fmla="*/ 142 h 415"/>
                <a:gd name="T36" fmla="*/ 205 w 271"/>
                <a:gd name="T37" fmla="*/ 101 h 415"/>
                <a:gd name="T38" fmla="*/ 242 w 271"/>
                <a:gd name="T39" fmla="*/ 64 h 415"/>
                <a:gd name="T40" fmla="*/ 271 w 271"/>
                <a:gd name="T41" fmla="*/ 39 h 415"/>
                <a:gd name="T42" fmla="*/ 239 w 271"/>
                <a:gd name="T43" fmla="*/ 0 h 4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271" h="415">
                  <a:moveTo>
                    <a:pt x="239" y="0"/>
                  </a:moveTo>
                  <a:lnTo>
                    <a:pt x="196" y="38"/>
                  </a:lnTo>
                  <a:lnTo>
                    <a:pt x="157" y="80"/>
                  </a:lnTo>
                  <a:lnTo>
                    <a:pt x="123" y="124"/>
                  </a:lnTo>
                  <a:lnTo>
                    <a:pt x="92" y="172"/>
                  </a:lnTo>
                  <a:lnTo>
                    <a:pt x="66" y="223"/>
                  </a:lnTo>
                  <a:lnTo>
                    <a:pt x="45" y="276"/>
                  </a:lnTo>
                  <a:lnTo>
                    <a:pt x="29" y="330"/>
                  </a:lnTo>
                  <a:lnTo>
                    <a:pt x="19" y="372"/>
                  </a:lnTo>
                  <a:lnTo>
                    <a:pt x="0" y="368"/>
                  </a:lnTo>
                  <a:lnTo>
                    <a:pt x="37" y="415"/>
                  </a:lnTo>
                  <a:lnTo>
                    <a:pt x="88" y="385"/>
                  </a:lnTo>
                  <a:lnTo>
                    <a:pt x="69" y="381"/>
                  </a:lnTo>
                  <a:lnTo>
                    <a:pt x="81" y="330"/>
                  </a:lnTo>
                  <a:lnTo>
                    <a:pt x="97" y="279"/>
                  </a:lnTo>
                  <a:lnTo>
                    <a:pt x="118" y="232"/>
                  </a:lnTo>
                  <a:lnTo>
                    <a:pt x="143" y="185"/>
                  </a:lnTo>
                  <a:lnTo>
                    <a:pt x="173" y="142"/>
                  </a:lnTo>
                  <a:lnTo>
                    <a:pt x="205" y="101"/>
                  </a:lnTo>
                  <a:lnTo>
                    <a:pt x="242" y="64"/>
                  </a:lnTo>
                  <a:lnTo>
                    <a:pt x="271" y="39"/>
                  </a:lnTo>
                  <a:lnTo>
                    <a:pt x="239" y="0"/>
                  </a:lnTo>
                  <a:close/>
                </a:path>
              </a:pathLst>
            </a:custGeom>
            <a:solidFill>
              <a:srgbClr val="FF66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0" name="Arc 78"/>
            <p:cNvSpPr>
              <a:spLocks/>
            </p:cNvSpPr>
            <p:nvPr/>
          </p:nvSpPr>
          <p:spPr bwMode="auto">
            <a:xfrm>
              <a:off x="3587" y="2558"/>
              <a:ext cx="620" cy="489"/>
            </a:xfrm>
            <a:custGeom>
              <a:avLst/>
              <a:gdLst>
                <a:gd name="G0" fmla="+- 21233 0 0"/>
                <a:gd name="G1" fmla="+- 16689 0 0"/>
                <a:gd name="G2" fmla="+- 21600 0 0"/>
                <a:gd name="T0" fmla="*/ 0 w 21233"/>
                <a:gd name="T1" fmla="*/ 12726 h 16689"/>
                <a:gd name="T2" fmla="*/ 7521 w 21233"/>
                <a:gd name="T3" fmla="*/ 0 h 16689"/>
                <a:gd name="T4" fmla="*/ 21233 w 21233"/>
                <a:gd name="T5" fmla="*/ 16689 h 166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233" h="16689" fill="none" extrusionOk="0">
                  <a:moveTo>
                    <a:pt x="-1" y="12725"/>
                  </a:moveTo>
                  <a:cubicBezTo>
                    <a:pt x="931" y="7731"/>
                    <a:pt x="3594" y="3225"/>
                    <a:pt x="7520" y="-1"/>
                  </a:cubicBezTo>
                </a:path>
                <a:path w="21233" h="16689" stroke="0" extrusionOk="0">
                  <a:moveTo>
                    <a:pt x="-1" y="12725"/>
                  </a:moveTo>
                  <a:cubicBezTo>
                    <a:pt x="931" y="7731"/>
                    <a:pt x="3594" y="3225"/>
                    <a:pt x="7520" y="-1"/>
                  </a:cubicBezTo>
                  <a:lnTo>
                    <a:pt x="21233" y="16689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1" name="Arc 79"/>
            <p:cNvSpPr>
              <a:spLocks/>
            </p:cNvSpPr>
            <p:nvPr/>
          </p:nvSpPr>
          <p:spPr bwMode="auto">
            <a:xfrm>
              <a:off x="3636" y="2597"/>
              <a:ext cx="572" cy="450"/>
            </a:xfrm>
            <a:custGeom>
              <a:avLst/>
              <a:gdLst>
                <a:gd name="G0" fmla="+- 21233 0 0"/>
                <a:gd name="G1" fmla="+- 16665 0 0"/>
                <a:gd name="G2" fmla="+- 21600 0 0"/>
                <a:gd name="T0" fmla="*/ 0 w 21233"/>
                <a:gd name="T1" fmla="*/ 12700 h 16665"/>
                <a:gd name="T2" fmla="*/ 7491 w 21233"/>
                <a:gd name="T3" fmla="*/ 0 h 16665"/>
                <a:gd name="T4" fmla="*/ 21233 w 21233"/>
                <a:gd name="T5" fmla="*/ 16665 h 166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233" h="16665" fill="none" extrusionOk="0">
                  <a:moveTo>
                    <a:pt x="0" y="12700"/>
                  </a:moveTo>
                  <a:cubicBezTo>
                    <a:pt x="930" y="7719"/>
                    <a:pt x="3581" y="3223"/>
                    <a:pt x="7491" y="0"/>
                  </a:cubicBezTo>
                </a:path>
                <a:path w="21233" h="16665" stroke="0" extrusionOk="0">
                  <a:moveTo>
                    <a:pt x="0" y="12700"/>
                  </a:moveTo>
                  <a:cubicBezTo>
                    <a:pt x="930" y="7719"/>
                    <a:pt x="3581" y="3223"/>
                    <a:pt x="7491" y="0"/>
                  </a:cubicBezTo>
                  <a:lnTo>
                    <a:pt x="21233" y="16665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2" name="Line 80"/>
            <p:cNvSpPr>
              <a:spLocks noChangeShapeType="1"/>
            </p:cNvSpPr>
            <p:nvPr/>
          </p:nvSpPr>
          <p:spPr bwMode="auto">
            <a:xfrm flipH="1" flipV="1">
              <a:off x="3807" y="2559"/>
              <a:ext cx="32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3" name="Freeform 81"/>
            <p:cNvSpPr>
              <a:spLocks/>
            </p:cNvSpPr>
            <p:nvPr/>
          </p:nvSpPr>
          <p:spPr bwMode="auto">
            <a:xfrm>
              <a:off x="3568" y="2927"/>
              <a:ext cx="88" cy="47"/>
            </a:xfrm>
            <a:custGeom>
              <a:avLst/>
              <a:gdLst>
                <a:gd name="T0" fmla="*/ 48 w 61"/>
                <a:gd name="T1" fmla="*/ 9 h 33"/>
                <a:gd name="T2" fmla="*/ 61 w 61"/>
                <a:gd name="T3" fmla="*/ 12 h 33"/>
                <a:gd name="T4" fmla="*/ 26 w 61"/>
                <a:gd name="T5" fmla="*/ 33 h 33"/>
                <a:gd name="T6" fmla="*/ 0 w 61"/>
                <a:gd name="T7" fmla="*/ 0 h 33"/>
                <a:gd name="T8" fmla="*/ 13 w 61"/>
                <a:gd name="T9" fmla="*/ 3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1" h="33">
                  <a:moveTo>
                    <a:pt x="48" y="9"/>
                  </a:moveTo>
                  <a:lnTo>
                    <a:pt x="61" y="12"/>
                  </a:lnTo>
                  <a:lnTo>
                    <a:pt x="26" y="33"/>
                  </a:lnTo>
                  <a:lnTo>
                    <a:pt x="0" y="0"/>
                  </a:lnTo>
                  <a:lnTo>
                    <a:pt x="13" y="3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4" name="Line 82"/>
            <p:cNvSpPr>
              <a:spLocks noChangeShapeType="1"/>
            </p:cNvSpPr>
            <p:nvPr/>
          </p:nvSpPr>
          <p:spPr bwMode="auto">
            <a:xfrm flipV="1">
              <a:off x="3540" y="2744"/>
              <a:ext cx="114" cy="44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5" name="Rectangle 83"/>
            <p:cNvSpPr>
              <a:spLocks noChangeArrowheads="1"/>
            </p:cNvSpPr>
            <p:nvPr/>
          </p:nvSpPr>
          <p:spPr bwMode="auto">
            <a:xfrm>
              <a:off x="3363" y="2677"/>
              <a:ext cx="219" cy="1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smtClean="0">
                  <a:ln>
                    <a:noFill/>
                  </a:ln>
                  <a:solidFill>
                    <a:srgbClr val="800000"/>
                  </a:solidFill>
                  <a:effectLst/>
                  <a:latin typeface="Arial" pitchFamily="34" charset="0"/>
                  <a:cs typeface="Arial" pitchFamily="34" charset="0"/>
                </a:rPr>
                <a:t>amp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46" name="Freeform 84"/>
            <p:cNvSpPr>
              <a:spLocks/>
            </p:cNvSpPr>
            <p:nvPr/>
          </p:nvSpPr>
          <p:spPr bwMode="auto">
            <a:xfrm>
              <a:off x="4500" y="2497"/>
              <a:ext cx="301" cy="324"/>
            </a:xfrm>
            <a:custGeom>
              <a:avLst/>
              <a:gdLst>
                <a:gd name="T0" fmla="*/ 220 w 301"/>
                <a:gd name="T1" fmla="*/ 307 h 324"/>
                <a:gd name="T2" fmla="*/ 276 w 301"/>
                <a:gd name="T3" fmla="*/ 324 h 324"/>
                <a:gd name="T4" fmla="*/ 301 w 301"/>
                <a:gd name="T5" fmla="*/ 268 h 324"/>
                <a:gd name="T6" fmla="*/ 282 w 301"/>
                <a:gd name="T7" fmla="*/ 276 h 324"/>
                <a:gd name="T8" fmla="*/ 256 w 301"/>
                <a:gd name="T9" fmla="*/ 226 h 324"/>
                <a:gd name="T10" fmla="*/ 224 w 301"/>
                <a:gd name="T11" fmla="*/ 178 h 324"/>
                <a:gd name="T12" fmla="*/ 190 w 301"/>
                <a:gd name="T13" fmla="*/ 134 h 324"/>
                <a:gd name="T14" fmla="*/ 149 w 301"/>
                <a:gd name="T15" fmla="*/ 92 h 324"/>
                <a:gd name="T16" fmla="*/ 107 w 301"/>
                <a:gd name="T17" fmla="*/ 55 h 324"/>
                <a:gd name="T18" fmla="*/ 61 w 301"/>
                <a:gd name="T19" fmla="*/ 21 h 324"/>
                <a:gd name="T20" fmla="*/ 26 w 301"/>
                <a:gd name="T21" fmla="*/ 0 h 324"/>
                <a:gd name="T22" fmla="*/ 0 w 301"/>
                <a:gd name="T23" fmla="*/ 45 h 324"/>
                <a:gd name="T24" fmla="*/ 45 w 301"/>
                <a:gd name="T25" fmla="*/ 72 h 324"/>
                <a:gd name="T26" fmla="*/ 87 w 301"/>
                <a:gd name="T27" fmla="*/ 104 h 324"/>
                <a:gd name="T28" fmla="*/ 126 w 301"/>
                <a:gd name="T29" fmla="*/ 139 h 324"/>
                <a:gd name="T30" fmla="*/ 161 w 301"/>
                <a:gd name="T31" fmla="*/ 178 h 324"/>
                <a:gd name="T32" fmla="*/ 193 w 301"/>
                <a:gd name="T33" fmla="*/ 220 h 324"/>
                <a:gd name="T34" fmla="*/ 220 w 301"/>
                <a:gd name="T35" fmla="*/ 265 h 324"/>
                <a:gd name="T36" fmla="*/ 237 w 301"/>
                <a:gd name="T37" fmla="*/ 298 h 324"/>
                <a:gd name="T38" fmla="*/ 220 w 301"/>
                <a:gd name="T39" fmla="*/ 307 h 3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01" h="324">
                  <a:moveTo>
                    <a:pt x="220" y="307"/>
                  </a:moveTo>
                  <a:lnTo>
                    <a:pt x="276" y="324"/>
                  </a:lnTo>
                  <a:lnTo>
                    <a:pt x="301" y="268"/>
                  </a:lnTo>
                  <a:lnTo>
                    <a:pt x="282" y="276"/>
                  </a:lnTo>
                  <a:lnTo>
                    <a:pt x="256" y="226"/>
                  </a:lnTo>
                  <a:lnTo>
                    <a:pt x="224" y="178"/>
                  </a:lnTo>
                  <a:lnTo>
                    <a:pt x="190" y="134"/>
                  </a:lnTo>
                  <a:lnTo>
                    <a:pt x="149" y="92"/>
                  </a:lnTo>
                  <a:lnTo>
                    <a:pt x="107" y="55"/>
                  </a:lnTo>
                  <a:lnTo>
                    <a:pt x="61" y="21"/>
                  </a:lnTo>
                  <a:lnTo>
                    <a:pt x="26" y="0"/>
                  </a:lnTo>
                  <a:lnTo>
                    <a:pt x="0" y="45"/>
                  </a:lnTo>
                  <a:lnTo>
                    <a:pt x="45" y="72"/>
                  </a:lnTo>
                  <a:lnTo>
                    <a:pt x="87" y="104"/>
                  </a:lnTo>
                  <a:lnTo>
                    <a:pt x="126" y="139"/>
                  </a:lnTo>
                  <a:lnTo>
                    <a:pt x="161" y="178"/>
                  </a:lnTo>
                  <a:lnTo>
                    <a:pt x="193" y="220"/>
                  </a:lnTo>
                  <a:lnTo>
                    <a:pt x="220" y="265"/>
                  </a:lnTo>
                  <a:lnTo>
                    <a:pt x="237" y="298"/>
                  </a:lnTo>
                  <a:lnTo>
                    <a:pt x="220" y="307"/>
                  </a:lnTo>
                  <a:close/>
                </a:path>
              </a:pathLst>
            </a:custGeom>
            <a:solidFill>
              <a:srgbClr val="FF66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7" name="Arc 85"/>
            <p:cNvSpPr>
              <a:spLocks/>
            </p:cNvSpPr>
            <p:nvPr/>
          </p:nvSpPr>
          <p:spPr bwMode="auto">
            <a:xfrm>
              <a:off x="4207" y="2500"/>
              <a:ext cx="570" cy="547"/>
            </a:xfrm>
            <a:custGeom>
              <a:avLst/>
              <a:gdLst>
                <a:gd name="G0" fmla="+- 0 0 0"/>
                <a:gd name="G1" fmla="+- 18673 0 0"/>
                <a:gd name="G2" fmla="+- 21600 0 0"/>
                <a:gd name="T0" fmla="*/ 10856 w 19508"/>
                <a:gd name="T1" fmla="*/ 0 h 18673"/>
                <a:gd name="T2" fmla="*/ 19508 w 19508"/>
                <a:gd name="T3" fmla="*/ 9399 h 18673"/>
                <a:gd name="T4" fmla="*/ 0 w 19508"/>
                <a:gd name="T5" fmla="*/ 18673 h 186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508" h="18673" fill="none" extrusionOk="0">
                  <a:moveTo>
                    <a:pt x="10856" y="-1"/>
                  </a:moveTo>
                  <a:cubicBezTo>
                    <a:pt x="14621" y="2188"/>
                    <a:pt x="17637" y="5465"/>
                    <a:pt x="19507" y="9399"/>
                  </a:cubicBezTo>
                </a:path>
                <a:path w="19508" h="18673" stroke="0" extrusionOk="0">
                  <a:moveTo>
                    <a:pt x="10856" y="-1"/>
                  </a:moveTo>
                  <a:cubicBezTo>
                    <a:pt x="14621" y="2188"/>
                    <a:pt x="17637" y="5465"/>
                    <a:pt x="19507" y="9399"/>
                  </a:cubicBezTo>
                  <a:lnTo>
                    <a:pt x="0" y="18673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8" name="Arc 86"/>
            <p:cNvSpPr>
              <a:spLocks/>
            </p:cNvSpPr>
            <p:nvPr/>
          </p:nvSpPr>
          <p:spPr bwMode="auto">
            <a:xfrm>
              <a:off x="4208" y="2542"/>
              <a:ext cx="525" cy="505"/>
            </a:xfrm>
            <a:custGeom>
              <a:avLst/>
              <a:gdLst>
                <a:gd name="G0" fmla="+- 0 0 0"/>
                <a:gd name="G1" fmla="+- 18683 0 0"/>
                <a:gd name="G2" fmla="+- 21600 0 0"/>
                <a:gd name="T0" fmla="*/ 10840 w 19513"/>
                <a:gd name="T1" fmla="*/ 0 h 18683"/>
                <a:gd name="T2" fmla="*/ 19513 w 19513"/>
                <a:gd name="T3" fmla="*/ 9420 h 18683"/>
                <a:gd name="T4" fmla="*/ 0 w 19513"/>
                <a:gd name="T5" fmla="*/ 18683 h 186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513" h="18683" fill="none" extrusionOk="0">
                  <a:moveTo>
                    <a:pt x="10839" y="0"/>
                  </a:moveTo>
                  <a:cubicBezTo>
                    <a:pt x="14616" y="2191"/>
                    <a:pt x="17640" y="5475"/>
                    <a:pt x="19512" y="9420"/>
                  </a:cubicBezTo>
                </a:path>
                <a:path w="19513" h="18683" stroke="0" extrusionOk="0">
                  <a:moveTo>
                    <a:pt x="10839" y="0"/>
                  </a:moveTo>
                  <a:cubicBezTo>
                    <a:pt x="14616" y="2191"/>
                    <a:pt x="17640" y="5475"/>
                    <a:pt x="19512" y="9420"/>
                  </a:cubicBezTo>
                  <a:lnTo>
                    <a:pt x="0" y="18683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9" name="Line 87"/>
            <p:cNvSpPr>
              <a:spLocks noChangeShapeType="1"/>
            </p:cNvSpPr>
            <p:nvPr/>
          </p:nvSpPr>
          <p:spPr bwMode="auto">
            <a:xfrm flipV="1">
              <a:off x="4500" y="2497"/>
              <a:ext cx="26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50" name="Freeform 88"/>
            <p:cNvSpPr>
              <a:spLocks/>
            </p:cNvSpPr>
            <p:nvPr/>
          </p:nvSpPr>
          <p:spPr bwMode="auto">
            <a:xfrm>
              <a:off x="4720" y="2765"/>
              <a:ext cx="81" cy="56"/>
            </a:xfrm>
            <a:custGeom>
              <a:avLst/>
              <a:gdLst>
                <a:gd name="T0" fmla="*/ 12 w 56"/>
                <a:gd name="T1" fmla="*/ 21 h 39"/>
                <a:gd name="T2" fmla="*/ 0 w 56"/>
                <a:gd name="T3" fmla="*/ 27 h 39"/>
                <a:gd name="T4" fmla="*/ 39 w 56"/>
                <a:gd name="T5" fmla="*/ 39 h 39"/>
                <a:gd name="T6" fmla="*/ 56 w 56"/>
                <a:gd name="T7" fmla="*/ 0 h 39"/>
                <a:gd name="T8" fmla="*/ 43 w 56"/>
                <a:gd name="T9" fmla="*/ 6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6" h="39">
                  <a:moveTo>
                    <a:pt x="12" y="21"/>
                  </a:moveTo>
                  <a:lnTo>
                    <a:pt x="0" y="27"/>
                  </a:lnTo>
                  <a:lnTo>
                    <a:pt x="39" y="39"/>
                  </a:lnTo>
                  <a:lnTo>
                    <a:pt x="56" y="0"/>
                  </a:lnTo>
                  <a:lnTo>
                    <a:pt x="43" y="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51" name="Line 89"/>
            <p:cNvSpPr>
              <a:spLocks noChangeShapeType="1"/>
            </p:cNvSpPr>
            <p:nvPr/>
          </p:nvSpPr>
          <p:spPr bwMode="auto">
            <a:xfrm flipH="1">
              <a:off x="4690" y="2573"/>
              <a:ext cx="102" cy="58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52" name="Rectangle 90"/>
            <p:cNvSpPr>
              <a:spLocks noChangeArrowheads="1"/>
            </p:cNvSpPr>
            <p:nvPr/>
          </p:nvSpPr>
          <p:spPr bwMode="auto">
            <a:xfrm>
              <a:off x="4796" y="2462"/>
              <a:ext cx="279" cy="1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smtClean="0">
                  <a:ln>
                    <a:noFill/>
                  </a:ln>
                  <a:solidFill>
                    <a:srgbClr val="800000"/>
                  </a:solidFill>
                  <a:effectLst/>
                  <a:latin typeface="Arial" pitchFamily="34" charset="0"/>
                  <a:cs typeface="Arial" pitchFamily="34" charset="0"/>
                </a:rPr>
                <a:t>EGFP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53" name="Arc 91"/>
            <p:cNvSpPr>
              <a:spLocks/>
            </p:cNvSpPr>
            <p:nvPr/>
          </p:nvSpPr>
          <p:spPr bwMode="auto">
            <a:xfrm>
              <a:off x="3956" y="3046"/>
              <a:ext cx="251" cy="484"/>
            </a:xfrm>
            <a:custGeom>
              <a:avLst/>
              <a:gdLst>
                <a:gd name="G0" fmla="+- 10723 0 0"/>
                <a:gd name="G1" fmla="+- 0 0 0"/>
                <a:gd name="G2" fmla="+- 21600 0 0"/>
                <a:gd name="T0" fmla="*/ 4235 w 10723"/>
                <a:gd name="T1" fmla="*/ 20603 h 20603"/>
                <a:gd name="T2" fmla="*/ 0 w 10723"/>
                <a:gd name="T3" fmla="*/ 18750 h 20603"/>
                <a:gd name="T4" fmla="*/ 10723 w 10723"/>
                <a:gd name="T5" fmla="*/ 0 h 206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23" h="20603" fill="none" extrusionOk="0">
                  <a:moveTo>
                    <a:pt x="4235" y="20602"/>
                  </a:moveTo>
                  <a:cubicBezTo>
                    <a:pt x="2761" y="20138"/>
                    <a:pt x="1341" y="19517"/>
                    <a:pt x="-1" y="18750"/>
                  </a:cubicBezTo>
                </a:path>
                <a:path w="10723" h="20603" stroke="0" extrusionOk="0">
                  <a:moveTo>
                    <a:pt x="4235" y="20602"/>
                  </a:moveTo>
                  <a:cubicBezTo>
                    <a:pt x="2761" y="20138"/>
                    <a:pt x="1341" y="19517"/>
                    <a:pt x="-1" y="18750"/>
                  </a:cubicBezTo>
                  <a:lnTo>
                    <a:pt x="10723" y="0"/>
                  </a:lnTo>
                  <a:close/>
                </a:path>
              </a:pathLst>
            </a:custGeom>
            <a:noFill/>
            <a:ln w="14288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54" name="Line 92"/>
            <p:cNvSpPr>
              <a:spLocks noChangeShapeType="1"/>
            </p:cNvSpPr>
            <p:nvPr/>
          </p:nvSpPr>
          <p:spPr bwMode="auto">
            <a:xfrm flipV="1">
              <a:off x="3805" y="3516"/>
              <a:ext cx="197" cy="136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55" name="Rectangle 93"/>
            <p:cNvSpPr>
              <a:spLocks noChangeArrowheads="1"/>
            </p:cNvSpPr>
            <p:nvPr/>
          </p:nvSpPr>
          <p:spPr bwMode="auto">
            <a:xfrm>
              <a:off x="3588" y="3652"/>
              <a:ext cx="250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0" u="none" strike="noStrike" cap="none" normalizeH="0" baseline="0" dirty="0" smtClean="0">
                  <a:ln>
                    <a:noFill/>
                  </a:ln>
                  <a:solidFill>
                    <a:srgbClr val="800080"/>
                  </a:solidFill>
                  <a:effectLst/>
                  <a:latin typeface="Arial" pitchFamily="34" charset="0"/>
                  <a:cs typeface="Arial" pitchFamily="34" charset="0"/>
                </a:rPr>
                <a:t>BGH </a:t>
              </a:r>
              <a:r>
                <a:rPr kumimoji="0" lang="en-US" altLang="en-US" sz="900" b="1" i="0" u="none" strike="noStrike" cap="none" normalizeH="0" baseline="0" dirty="0" err="1" smtClean="0">
                  <a:ln>
                    <a:noFill/>
                  </a:ln>
                  <a:solidFill>
                    <a:srgbClr val="800080"/>
                  </a:solidFill>
                  <a:effectLst/>
                  <a:latin typeface="Arial" pitchFamily="34" charset="0"/>
                  <a:cs typeface="Arial" pitchFamily="34" charset="0"/>
                </a:rPr>
                <a:t>pA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57" name="Freeform 94"/>
            <p:cNvSpPr>
              <a:spLocks/>
            </p:cNvSpPr>
            <p:nvPr/>
          </p:nvSpPr>
          <p:spPr bwMode="auto">
            <a:xfrm>
              <a:off x="4717" y="2999"/>
              <a:ext cx="129" cy="359"/>
            </a:xfrm>
            <a:custGeom>
              <a:avLst/>
              <a:gdLst>
                <a:gd name="T0" fmla="*/ 0 w 129"/>
                <a:gd name="T1" fmla="*/ 303 h 359"/>
                <a:gd name="T2" fmla="*/ 22 w 129"/>
                <a:gd name="T3" fmla="*/ 359 h 359"/>
                <a:gd name="T4" fmla="*/ 81 w 129"/>
                <a:gd name="T5" fmla="*/ 343 h 359"/>
                <a:gd name="T6" fmla="*/ 62 w 129"/>
                <a:gd name="T7" fmla="*/ 334 h 359"/>
                <a:gd name="T8" fmla="*/ 85 w 129"/>
                <a:gd name="T9" fmla="*/ 282 h 359"/>
                <a:gd name="T10" fmla="*/ 104 w 129"/>
                <a:gd name="T11" fmla="*/ 229 h 359"/>
                <a:gd name="T12" fmla="*/ 117 w 129"/>
                <a:gd name="T13" fmla="*/ 174 h 359"/>
                <a:gd name="T14" fmla="*/ 126 w 129"/>
                <a:gd name="T15" fmla="*/ 117 h 359"/>
                <a:gd name="T16" fmla="*/ 129 w 129"/>
                <a:gd name="T17" fmla="*/ 59 h 359"/>
                <a:gd name="T18" fmla="*/ 127 w 129"/>
                <a:gd name="T19" fmla="*/ 3 h 359"/>
                <a:gd name="T20" fmla="*/ 127 w 129"/>
                <a:gd name="T21" fmla="*/ 0 h 359"/>
                <a:gd name="T22" fmla="*/ 77 w 129"/>
                <a:gd name="T23" fmla="*/ 4 h 359"/>
                <a:gd name="T24" fmla="*/ 79 w 129"/>
                <a:gd name="T25" fmla="*/ 56 h 359"/>
                <a:gd name="T26" fmla="*/ 77 w 129"/>
                <a:gd name="T27" fmla="*/ 109 h 359"/>
                <a:gd name="T28" fmla="*/ 69 w 129"/>
                <a:gd name="T29" fmla="*/ 161 h 359"/>
                <a:gd name="T30" fmla="*/ 56 w 129"/>
                <a:gd name="T31" fmla="*/ 211 h 359"/>
                <a:gd name="T32" fmla="*/ 40 w 129"/>
                <a:gd name="T33" fmla="*/ 262 h 359"/>
                <a:gd name="T34" fmla="*/ 19 w 129"/>
                <a:gd name="T35" fmla="*/ 310 h 359"/>
                <a:gd name="T36" fmla="*/ 17 w 129"/>
                <a:gd name="T37" fmla="*/ 313 h 359"/>
                <a:gd name="T38" fmla="*/ 0 w 129"/>
                <a:gd name="T39" fmla="*/ 303 h 3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129" h="359">
                  <a:moveTo>
                    <a:pt x="0" y="303"/>
                  </a:moveTo>
                  <a:lnTo>
                    <a:pt x="22" y="359"/>
                  </a:lnTo>
                  <a:lnTo>
                    <a:pt x="81" y="343"/>
                  </a:lnTo>
                  <a:lnTo>
                    <a:pt x="62" y="334"/>
                  </a:lnTo>
                  <a:lnTo>
                    <a:pt x="85" y="282"/>
                  </a:lnTo>
                  <a:lnTo>
                    <a:pt x="104" y="229"/>
                  </a:lnTo>
                  <a:lnTo>
                    <a:pt x="117" y="174"/>
                  </a:lnTo>
                  <a:lnTo>
                    <a:pt x="126" y="117"/>
                  </a:lnTo>
                  <a:lnTo>
                    <a:pt x="129" y="59"/>
                  </a:lnTo>
                  <a:lnTo>
                    <a:pt x="127" y="3"/>
                  </a:lnTo>
                  <a:lnTo>
                    <a:pt x="127" y="0"/>
                  </a:lnTo>
                  <a:lnTo>
                    <a:pt x="77" y="4"/>
                  </a:lnTo>
                  <a:lnTo>
                    <a:pt x="79" y="56"/>
                  </a:lnTo>
                  <a:lnTo>
                    <a:pt x="77" y="109"/>
                  </a:lnTo>
                  <a:lnTo>
                    <a:pt x="69" y="161"/>
                  </a:lnTo>
                  <a:lnTo>
                    <a:pt x="56" y="211"/>
                  </a:lnTo>
                  <a:lnTo>
                    <a:pt x="40" y="262"/>
                  </a:lnTo>
                  <a:lnTo>
                    <a:pt x="19" y="310"/>
                  </a:lnTo>
                  <a:lnTo>
                    <a:pt x="17" y="313"/>
                  </a:lnTo>
                  <a:lnTo>
                    <a:pt x="0" y="303"/>
                  </a:lnTo>
                  <a:close/>
                </a:path>
              </a:pathLst>
            </a:custGeom>
            <a:pattFill prst="openDmnd">
              <a:fgClr>
                <a:srgbClr val="000080"/>
              </a:fgClr>
              <a:bgClr>
                <a:srgbClr val="FFFFFF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58" name="Arc 95"/>
            <p:cNvSpPr>
              <a:spLocks/>
            </p:cNvSpPr>
            <p:nvPr/>
          </p:nvSpPr>
          <p:spPr bwMode="auto">
            <a:xfrm>
              <a:off x="4207" y="3000"/>
              <a:ext cx="631" cy="330"/>
            </a:xfrm>
            <a:custGeom>
              <a:avLst/>
              <a:gdLst>
                <a:gd name="G0" fmla="+- 0 0 0"/>
                <a:gd name="G1" fmla="+- 1619 0 0"/>
                <a:gd name="G2" fmla="+- 21600 0 0"/>
                <a:gd name="T0" fmla="*/ 21539 w 21600"/>
                <a:gd name="T1" fmla="*/ 0 h 11260"/>
                <a:gd name="T2" fmla="*/ 19329 w 21600"/>
                <a:gd name="T3" fmla="*/ 11260 h 11260"/>
                <a:gd name="T4" fmla="*/ 0 w 21600"/>
                <a:gd name="T5" fmla="*/ 1619 h 112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00" h="11260" fill="none" extrusionOk="0">
                  <a:moveTo>
                    <a:pt x="21539" y="-1"/>
                  </a:moveTo>
                  <a:cubicBezTo>
                    <a:pt x="21579" y="538"/>
                    <a:pt x="21600" y="1078"/>
                    <a:pt x="21600" y="1619"/>
                  </a:cubicBezTo>
                  <a:cubicBezTo>
                    <a:pt x="21600" y="4965"/>
                    <a:pt x="20822" y="8265"/>
                    <a:pt x="19329" y="11260"/>
                  </a:cubicBezTo>
                </a:path>
                <a:path w="21600" h="11260" stroke="0" extrusionOk="0">
                  <a:moveTo>
                    <a:pt x="21539" y="-1"/>
                  </a:moveTo>
                  <a:cubicBezTo>
                    <a:pt x="21579" y="538"/>
                    <a:pt x="21600" y="1078"/>
                    <a:pt x="21600" y="1619"/>
                  </a:cubicBezTo>
                  <a:cubicBezTo>
                    <a:pt x="21600" y="4965"/>
                    <a:pt x="20822" y="8265"/>
                    <a:pt x="19329" y="11260"/>
                  </a:cubicBezTo>
                  <a:lnTo>
                    <a:pt x="0" y="1619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59" name="Arc 96"/>
            <p:cNvSpPr>
              <a:spLocks/>
            </p:cNvSpPr>
            <p:nvPr/>
          </p:nvSpPr>
          <p:spPr bwMode="auto">
            <a:xfrm>
              <a:off x="4208" y="3003"/>
              <a:ext cx="582" cy="305"/>
            </a:xfrm>
            <a:custGeom>
              <a:avLst/>
              <a:gdLst>
                <a:gd name="G0" fmla="+- 0 0 0"/>
                <a:gd name="G1" fmla="+- 1612 0 0"/>
                <a:gd name="G2" fmla="+- 21600 0 0"/>
                <a:gd name="T0" fmla="*/ 21540 w 21600"/>
                <a:gd name="T1" fmla="*/ 0 h 11304"/>
                <a:gd name="T2" fmla="*/ 19304 w 21600"/>
                <a:gd name="T3" fmla="*/ 11304 h 11304"/>
                <a:gd name="T4" fmla="*/ 0 w 21600"/>
                <a:gd name="T5" fmla="*/ 1612 h 113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00" h="11304" fill="none" extrusionOk="0">
                  <a:moveTo>
                    <a:pt x="21539" y="0"/>
                  </a:moveTo>
                  <a:cubicBezTo>
                    <a:pt x="21579" y="536"/>
                    <a:pt x="21600" y="1074"/>
                    <a:pt x="21600" y="1612"/>
                  </a:cubicBezTo>
                  <a:cubicBezTo>
                    <a:pt x="21600" y="4977"/>
                    <a:pt x="20813" y="8296"/>
                    <a:pt x="19303" y="11303"/>
                  </a:cubicBezTo>
                </a:path>
                <a:path w="21600" h="11304" stroke="0" extrusionOk="0">
                  <a:moveTo>
                    <a:pt x="21539" y="0"/>
                  </a:moveTo>
                  <a:cubicBezTo>
                    <a:pt x="21579" y="536"/>
                    <a:pt x="21600" y="1074"/>
                    <a:pt x="21600" y="1612"/>
                  </a:cubicBezTo>
                  <a:cubicBezTo>
                    <a:pt x="21600" y="4977"/>
                    <a:pt x="20813" y="8296"/>
                    <a:pt x="19303" y="11303"/>
                  </a:cubicBezTo>
                  <a:lnTo>
                    <a:pt x="0" y="1612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0" name="Line 97"/>
            <p:cNvSpPr>
              <a:spLocks noChangeShapeType="1"/>
            </p:cNvSpPr>
            <p:nvPr/>
          </p:nvSpPr>
          <p:spPr bwMode="auto">
            <a:xfrm flipV="1">
              <a:off x="4794" y="2999"/>
              <a:ext cx="50" cy="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1" name="Freeform 98"/>
            <p:cNvSpPr>
              <a:spLocks/>
            </p:cNvSpPr>
            <p:nvPr/>
          </p:nvSpPr>
          <p:spPr bwMode="auto">
            <a:xfrm>
              <a:off x="4717" y="3302"/>
              <a:ext cx="81" cy="56"/>
            </a:xfrm>
            <a:custGeom>
              <a:avLst/>
              <a:gdLst>
                <a:gd name="T0" fmla="*/ 12 w 56"/>
                <a:gd name="T1" fmla="*/ 7 h 39"/>
                <a:gd name="T2" fmla="*/ 0 w 56"/>
                <a:gd name="T3" fmla="*/ 0 h 39"/>
                <a:gd name="T4" fmla="*/ 15 w 56"/>
                <a:gd name="T5" fmla="*/ 39 h 39"/>
                <a:gd name="T6" fmla="*/ 56 w 56"/>
                <a:gd name="T7" fmla="*/ 28 h 39"/>
                <a:gd name="T8" fmla="*/ 43 w 56"/>
                <a:gd name="T9" fmla="*/ 22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6" h="39">
                  <a:moveTo>
                    <a:pt x="12" y="7"/>
                  </a:moveTo>
                  <a:lnTo>
                    <a:pt x="0" y="0"/>
                  </a:lnTo>
                  <a:lnTo>
                    <a:pt x="15" y="39"/>
                  </a:lnTo>
                  <a:lnTo>
                    <a:pt x="56" y="28"/>
                  </a:lnTo>
                  <a:lnTo>
                    <a:pt x="43" y="22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2" name="Line 99"/>
            <p:cNvSpPr>
              <a:spLocks noChangeShapeType="1"/>
            </p:cNvSpPr>
            <p:nvPr/>
          </p:nvSpPr>
          <p:spPr bwMode="auto">
            <a:xfrm flipH="1" flipV="1">
              <a:off x="4830" y="3192"/>
              <a:ext cx="91" cy="27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3" name="Rectangle 100"/>
            <p:cNvSpPr>
              <a:spLocks noChangeArrowheads="1"/>
            </p:cNvSpPr>
            <p:nvPr/>
          </p:nvSpPr>
          <p:spPr bwMode="auto">
            <a:xfrm>
              <a:off x="4925" y="3217"/>
              <a:ext cx="198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Arial" pitchFamily="34" charset="0"/>
                  <a:cs typeface="Arial" pitchFamily="34" charset="0"/>
                </a:rPr>
                <a:t>CMV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64" name="Freeform 101"/>
            <p:cNvSpPr>
              <a:spLocks/>
            </p:cNvSpPr>
            <p:nvPr/>
          </p:nvSpPr>
          <p:spPr bwMode="auto">
            <a:xfrm>
              <a:off x="4362" y="2436"/>
              <a:ext cx="149" cy="104"/>
            </a:xfrm>
            <a:custGeom>
              <a:avLst/>
              <a:gdLst>
                <a:gd name="T0" fmla="*/ 94 w 149"/>
                <a:gd name="T1" fmla="*/ 104 h 104"/>
                <a:gd name="T2" fmla="*/ 149 w 149"/>
                <a:gd name="T3" fmla="*/ 81 h 104"/>
                <a:gd name="T4" fmla="*/ 133 w 149"/>
                <a:gd name="T5" fmla="*/ 22 h 104"/>
                <a:gd name="T6" fmla="*/ 124 w 149"/>
                <a:gd name="T7" fmla="*/ 40 h 104"/>
                <a:gd name="T8" fmla="*/ 72 w 149"/>
                <a:gd name="T9" fmla="*/ 17 h 104"/>
                <a:gd name="T10" fmla="*/ 17 w 149"/>
                <a:gd name="T11" fmla="*/ 0 h 104"/>
                <a:gd name="T12" fmla="*/ 13 w 149"/>
                <a:gd name="T13" fmla="*/ 0 h 104"/>
                <a:gd name="T14" fmla="*/ 0 w 149"/>
                <a:gd name="T15" fmla="*/ 48 h 104"/>
                <a:gd name="T16" fmla="*/ 50 w 149"/>
                <a:gd name="T17" fmla="*/ 64 h 104"/>
                <a:gd name="T18" fmla="*/ 98 w 149"/>
                <a:gd name="T19" fmla="*/ 84 h 104"/>
                <a:gd name="T20" fmla="*/ 102 w 149"/>
                <a:gd name="T21" fmla="*/ 85 h 104"/>
                <a:gd name="T22" fmla="*/ 94 w 149"/>
                <a:gd name="T23" fmla="*/ 104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149" h="104">
                  <a:moveTo>
                    <a:pt x="94" y="104"/>
                  </a:moveTo>
                  <a:lnTo>
                    <a:pt x="149" y="81"/>
                  </a:lnTo>
                  <a:lnTo>
                    <a:pt x="133" y="22"/>
                  </a:lnTo>
                  <a:lnTo>
                    <a:pt x="124" y="40"/>
                  </a:lnTo>
                  <a:lnTo>
                    <a:pt x="72" y="17"/>
                  </a:lnTo>
                  <a:lnTo>
                    <a:pt x="17" y="0"/>
                  </a:lnTo>
                  <a:lnTo>
                    <a:pt x="13" y="0"/>
                  </a:lnTo>
                  <a:lnTo>
                    <a:pt x="0" y="48"/>
                  </a:lnTo>
                  <a:lnTo>
                    <a:pt x="50" y="64"/>
                  </a:lnTo>
                  <a:lnTo>
                    <a:pt x="98" y="84"/>
                  </a:lnTo>
                  <a:lnTo>
                    <a:pt x="102" y="85"/>
                  </a:lnTo>
                  <a:lnTo>
                    <a:pt x="94" y="104"/>
                  </a:lnTo>
                  <a:close/>
                </a:path>
              </a:pathLst>
            </a:custGeom>
            <a:pattFill prst="openDmnd">
              <a:fgClr>
                <a:srgbClr val="000080"/>
              </a:fgClr>
              <a:bgClr>
                <a:srgbClr val="FFFFFF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5" name="Arc 102"/>
            <p:cNvSpPr>
              <a:spLocks/>
            </p:cNvSpPr>
            <p:nvPr/>
          </p:nvSpPr>
          <p:spPr bwMode="auto">
            <a:xfrm>
              <a:off x="4207" y="2437"/>
              <a:ext cx="278" cy="610"/>
            </a:xfrm>
            <a:custGeom>
              <a:avLst/>
              <a:gdLst>
                <a:gd name="G0" fmla="+- 0 0 0"/>
                <a:gd name="G1" fmla="+- 20824 0 0"/>
                <a:gd name="G2" fmla="+- 21600 0 0"/>
                <a:gd name="T0" fmla="*/ 5739 w 9501"/>
                <a:gd name="T1" fmla="*/ 0 h 20824"/>
                <a:gd name="T2" fmla="*/ 9501 w 9501"/>
                <a:gd name="T3" fmla="*/ 1426 h 20824"/>
                <a:gd name="T4" fmla="*/ 0 w 9501"/>
                <a:gd name="T5" fmla="*/ 20824 h 208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01" h="20824" fill="none" extrusionOk="0">
                  <a:moveTo>
                    <a:pt x="5738" y="0"/>
                  </a:moveTo>
                  <a:cubicBezTo>
                    <a:pt x="7034" y="357"/>
                    <a:pt x="8294" y="834"/>
                    <a:pt x="9501" y="1425"/>
                  </a:cubicBezTo>
                </a:path>
                <a:path w="9501" h="20824" stroke="0" extrusionOk="0">
                  <a:moveTo>
                    <a:pt x="5738" y="0"/>
                  </a:moveTo>
                  <a:cubicBezTo>
                    <a:pt x="7034" y="357"/>
                    <a:pt x="8294" y="834"/>
                    <a:pt x="9501" y="1425"/>
                  </a:cubicBezTo>
                  <a:lnTo>
                    <a:pt x="0" y="20824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6" name="Arc 103"/>
            <p:cNvSpPr>
              <a:spLocks/>
            </p:cNvSpPr>
            <p:nvPr/>
          </p:nvSpPr>
          <p:spPr bwMode="auto">
            <a:xfrm>
              <a:off x="4208" y="2484"/>
              <a:ext cx="255" cy="563"/>
            </a:xfrm>
            <a:custGeom>
              <a:avLst/>
              <a:gdLst>
                <a:gd name="G0" fmla="+- 0 0 0"/>
                <a:gd name="G1" fmla="+- 20830 0 0"/>
                <a:gd name="G2" fmla="+- 21600 0 0"/>
                <a:gd name="T0" fmla="*/ 5717 w 9479"/>
                <a:gd name="T1" fmla="*/ 0 h 20830"/>
                <a:gd name="T2" fmla="*/ 9479 w 9479"/>
                <a:gd name="T3" fmla="*/ 1421 h 20830"/>
                <a:gd name="T4" fmla="*/ 0 w 9479"/>
                <a:gd name="T5" fmla="*/ 20830 h 208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79" h="20830" fill="none" extrusionOk="0">
                  <a:moveTo>
                    <a:pt x="5716" y="0"/>
                  </a:moveTo>
                  <a:cubicBezTo>
                    <a:pt x="7012" y="355"/>
                    <a:pt x="8271" y="831"/>
                    <a:pt x="9478" y="1421"/>
                  </a:cubicBezTo>
                </a:path>
                <a:path w="9479" h="20830" stroke="0" extrusionOk="0">
                  <a:moveTo>
                    <a:pt x="5716" y="0"/>
                  </a:moveTo>
                  <a:cubicBezTo>
                    <a:pt x="7012" y="355"/>
                    <a:pt x="8271" y="831"/>
                    <a:pt x="9478" y="1421"/>
                  </a:cubicBezTo>
                  <a:lnTo>
                    <a:pt x="0" y="2083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7" name="Line 104"/>
            <p:cNvSpPr>
              <a:spLocks noChangeShapeType="1"/>
            </p:cNvSpPr>
            <p:nvPr/>
          </p:nvSpPr>
          <p:spPr bwMode="auto">
            <a:xfrm flipV="1">
              <a:off x="4362" y="2436"/>
              <a:ext cx="13" cy="4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8" name="Freeform 105"/>
            <p:cNvSpPr>
              <a:spLocks/>
            </p:cNvSpPr>
            <p:nvPr/>
          </p:nvSpPr>
          <p:spPr bwMode="auto">
            <a:xfrm>
              <a:off x="4456" y="2458"/>
              <a:ext cx="55" cy="82"/>
            </a:xfrm>
            <a:custGeom>
              <a:avLst/>
              <a:gdLst>
                <a:gd name="T0" fmla="*/ 6 w 38"/>
                <a:gd name="T1" fmla="*/ 44 h 57"/>
                <a:gd name="T2" fmla="*/ 0 w 38"/>
                <a:gd name="T3" fmla="*/ 57 h 57"/>
                <a:gd name="T4" fmla="*/ 38 w 38"/>
                <a:gd name="T5" fmla="*/ 41 h 57"/>
                <a:gd name="T6" fmla="*/ 27 w 38"/>
                <a:gd name="T7" fmla="*/ 0 h 57"/>
                <a:gd name="T8" fmla="*/ 21 w 38"/>
                <a:gd name="T9" fmla="*/ 13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8" h="57">
                  <a:moveTo>
                    <a:pt x="6" y="44"/>
                  </a:moveTo>
                  <a:lnTo>
                    <a:pt x="0" y="57"/>
                  </a:lnTo>
                  <a:lnTo>
                    <a:pt x="38" y="41"/>
                  </a:lnTo>
                  <a:lnTo>
                    <a:pt x="27" y="0"/>
                  </a:lnTo>
                  <a:lnTo>
                    <a:pt x="21" y="13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9" name="Line 106"/>
            <p:cNvSpPr>
              <a:spLocks noChangeShapeType="1"/>
            </p:cNvSpPr>
            <p:nvPr/>
          </p:nvSpPr>
          <p:spPr bwMode="auto">
            <a:xfrm flipH="1">
              <a:off x="4451" y="2364"/>
              <a:ext cx="145" cy="97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70" name="Rectangle 107"/>
            <p:cNvSpPr>
              <a:spLocks noChangeArrowheads="1"/>
            </p:cNvSpPr>
            <p:nvPr/>
          </p:nvSpPr>
          <p:spPr bwMode="auto">
            <a:xfrm>
              <a:off x="4628" y="2240"/>
              <a:ext cx="184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Arial" pitchFamily="34" charset="0"/>
                  <a:cs typeface="Arial" pitchFamily="34" charset="0"/>
                </a:rPr>
                <a:t>RSV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71" name="Freeform 108"/>
            <p:cNvSpPr>
              <a:spLocks/>
            </p:cNvSpPr>
            <p:nvPr/>
          </p:nvSpPr>
          <p:spPr bwMode="auto">
            <a:xfrm>
              <a:off x="3597" y="3226"/>
              <a:ext cx="122" cy="168"/>
            </a:xfrm>
            <a:custGeom>
              <a:avLst/>
              <a:gdLst>
                <a:gd name="T0" fmla="*/ 85 w 122"/>
                <a:gd name="T1" fmla="*/ 23 h 168"/>
                <a:gd name="T2" fmla="*/ 30 w 122"/>
                <a:gd name="T3" fmla="*/ 0 h 168"/>
                <a:gd name="T4" fmla="*/ 0 w 122"/>
                <a:gd name="T5" fmla="*/ 55 h 168"/>
                <a:gd name="T6" fmla="*/ 18 w 122"/>
                <a:gd name="T7" fmla="*/ 48 h 168"/>
                <a:gd name="T8" fmla="*/ 42 w 122"/>
                <a:gd name="T9" fmla="*/ 100 h 168"/>
                <a:gd name="T10" fmla="*/ 68 w 122"/>
                <a:gd name="T11" fmla="*/ 151 h 168"/>
                <a:gd name="T12" fmla="*/ 79 w 122"/>
                <a:gd name="T13" fmla="*/ 168 h 168"/>
                <a:gd name="T14" fmla="*/ 122 w 122"/>
                <a:gd name="T15" fmla="*/ 142 h 168"/>
                <a:gd name="T16" fmla="*/ 95 w 122"/>
                <a:gd name="T17" fmla="*/ 96 h 168"/>
                <a:gd name="T18" fmla="*/ 73 w 122"/>
                <a:gd name="T19" fmla="*/ 50 h 168"/>
                <a:gd name="T20" fmla="*/ 66 w 122"/>
                <a:gd name="T21" fmla="*/ 31 h 168"/>
                <a:gd name="T22" fmla="*/ 85 w 122"/>
                <a:gd name="T23" fmla="*/ 23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122" h="168">
                  <a:moveTo>
                    <a:pt x="85" y="23"/>
                  </a:moveTo>
                  <a:lnTo>
                    <a:pt x="30" y="0"/>
                  </a:lnTo>
                  <a:lnTo>
                    <a:pt x="0" y="55"/>
                  </a:lnTo>
                  <a:lnTo>
                    <a:pt x="18" y="48"/>
                  </a:lnTo>
                  <a:lnTo>
                    <a:pt x="42" y="100"/>
                  </a:lnTo>
                  <a:lnTo>
                    <a:pt x="68" y="151"/>
                  </a:lnTo>
                  <a:lnTo>
                    <a:pt x="79" y="168"/>
                  </a:lnTo>
                  <a:lnTo>
                    <a:pt x="122" y="142"/>
                  </a:lnTo>
                  <a:lnTo>
                    <a:pt x="95" y="96"/>
                  </a:lnTo>
                  <a:lnTo>
                    <a:pt x="73" y="50"/>
                  </a:lnTo>
                  <a:lnTo>
                    <a:pt x="66" y="31"/>
                  </a:lnTo>
                  <a:lnTo>
                    <a:pt x="85" y="23"/>
                  </a:lnTo>
                  <a:close/>
                </a:path>
              </a:pathLst>
            </a:custGeom>
            <a:solidFill>
              <a:srgbClr val="3399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72" name="Arc 109"/>
            <p:cNvSpPr>
              <a:spLocks/>
            </p:cNvSpPr>
            <p:nvPr/>
          </p:nvSpPr>
          <p:spPr bwMode="auto">
            <a:xfrm>
              <a:off x="3618" y="3047"/>
              <a:ext cx="589" cy="345"/>
            </a:xfrm>
            <a:custGeom>
              <a:avLst/>
              <a:gdLst>
                <a:gd name="G0" fmla="+- 20174 0 0"/>
                <a:gd name="G1" fmla="+- 0 0 0"/>
                <a:gd name="G2" fmla="+- 21600 0 0"/>
                <a:gd name="T0" fmla="*/ 2080 w 20174"/>
                <a:gd name="T1" fmla="*/ 11796 h 11796"/>
                <a:gd name="T2" fmla="*/ 0 w 20174"/>
                <a:gd name="T3" fmla="*/ 7717 h 11796"/>
                <a:gd name="T4" fmla="*/ 20174 w 20174"/>
                <a:gd name="T5" fmla="*/ 0 h 117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174" h="11796" fill="none" extrusionOk="0">
                  <a:moveTo>
                    <a:pt x="2079" y="11796"/>
                  </a:moveTo>
                  <a:cubicBezTo>
                    <a:pt x="1243" y="10514"/>
                    <a:pt x="546" y="9146"/>
                    <a:pt x="-1" y="7717"/>
                  </a:cubicBezTo>
                </a:path>
                <a:path w="20174" h="11796" stroke="0" extrusionOk="0">
                  <a:moveTo>
                    <a:pt x="2079" y="11796"/>
                  </a:moveTo>
                  <a:cubicBezTo>
                    <a:pt x="1243" y="10514"/>
                    <a:pt x="546" y="9146"/>
                    <a:pt x="-1" y="7717"/>
                  </a:cubicBezTo>
                  <a:lnTo>
                    <a:pt x="20174" y="0"/>
                  </a:lnTo>
                  <a:close/>
                </a:path>
              </a:pathLst>
            </a:custGeom>
            <a:noFill/>
            <a:ln w="14288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73" name="Arc 110"/>
            <p:cNvSpPr>
              <a:spLocks/>
            </p:cNvSpPr>
            <p:nvPr/>
          </p:nvSpPr>
          <p:spPr bwMode="auto">
            <a:xfrm>
              <a:off x="3665" y="3047"/>
              <a:ext cx="543" cy="319"/>
            </a:xfrm>
            <a:custGeom>
              <a:avLst/>
              <a:gdLst>
                <a:gd name="G0" fmla="+- 20164 0 0"/>
                <a:gd name="G1" fmla="+- 0 0 0"/>
                <a:gd name="G2" fmla="+- 21600 0 0"/>
                <a:gd name="T0" fmla="*/ 2088 w 20164"/>
                <a:gd name="T1" fmla="*/ 11825 h 11825"/>
                <a:gd name="T2" fmla="*/ 0 w 20164"/>
                <a:gd name="T3" fmla="*/ 7743 h 11825"/>
                <a:gd name="T4" fmla="*/ 20164 w 20164"/>
                <a:gd name="T5" fmla="*/ 0 h 118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164" h="11825" fill="none" extrusionOk="0">
                  <a:moveTo>
                    <a:pt x="2088" y="11824"/>
                  </a:moveTo>
                  <a:cubicBezTo>
                    <a:pt x="1249" y="10542"/>
                    <a:pt x="549" y="9173"/>
                    <a:pt x="-1" y="7743"/>
                  </a:cubicBezTo>
                </a:path>
                <a:path w="20164" h="11825" stroke="0" extrusionOk="0">
                  <a:moveTo>
                    <a:pt x="2088" y="11824"/>
                  </a:moveTo>
                  <a:cubicBezTo>
                    <a:pt x="1249" y="10542"/>
                    <a:pt x="549" y="9173"/>
                    <a:pt x="-1" y="7743"/>
                  </a:cubicBezTo>
                  <a:lnTo>
                    <a:pt x="20164" y="0"/>
                  </a:lnTo>
                  <a:close/>
                </a:path>
              </a:pathLst>
            </a:custGeom>
            <a:noFill/>
            <a:ln w="14288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74" name="Line 111"/>
            <p:cNvSpPr>
              <a:spLocks noChangeShapeType="1"/>
            </p:cNvSpPr>
            <p:nvPr/>
          </p:nvSpPr>
          <p:spPr bwMode="auto">
            <a:xfrm flipH="1">
              <a:off x="3676" y="3368"/>
              <a:ext cx="43" cy="26"/>
            </a:xfrm>
            <a:prstGeom prst="line">
              <a:avLst/>
            </a:prstGeom>
            <a:noFill/>
            <a:ln w="14288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75" name="Freeform 112"/>
            <p:cNvSpPr>
              <a:spLocks/>
            </p:cNvSpPr>
            <p:nvPr/>
          </p:nvSpPr>
          <p:spPr bwMode="auto">
            <a:xfrm>
              <a:off x="3597" y="3226"/>
              <a:ext cx="85" cy="55"/>
            </a:xfrm>
            <a:custGeom>
              <a:avLst/>
              <a:gdLst>
                <a:gd name="T0" fmla="*/ 46 w 59"/>
                <a:gd name="T1" fmla="*/ 21 h 38"/>
                <a:gd name="T2" fmla="*/ 59 w 59"/>
                <a:gd name="T3" fmla="*/ 16 h 38"/>
                <a:gd name="T4" fmla="*/ 21 w 59"/>
                <a:gd name="T5" fmla="*/ 0 h 38"/>
                <a:gd name="T6" fmla="*/ 0 w 59"/>
                <a:gd name="T7" fmla="*/ 38 h 38"/>
                <a:gd name="T8" fmla="*/ 13 w 59"/>
                <a:gd name="T9" fmla="*/ 33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9" h="38">
                  <a:moveTo>
                    <a:pt x="46" y="21"/>
                  </a:moveTo>
                  <a:lnTo>
                    <a:pt x="59" y="16"/>
                  </a:lnTo>
                  <a:lnTo>
                    <a:pt x="21" y="0"/>
                  </a:lnTo>
                  <a:lnTo>
                    <a:pt x="0" y="38"/>
                  </a:lnTo>
                  <a:lnTo>
                    <a:pt x="13" y="33"/>
                  </a:lnTo>
                </a:path>
              </a:pathLst>
            </a:custGeom>
            <a:noFill/>
            <a:ln w="14288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76" name="Line 113"/>
            <p:cNvSpPr>
              <a:spLocks noChangeShapeType="1"/>
            </p:cNvSpPr>
            <p:nvPr/>
          </p:nvSpPr>
          <p:spPr bwMode="auto">
            <a:xfrm flipV="1">
              <a:off x="3539" y="3317"/>
              <a:ext cx="95" cy="8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77" name="Rectangle 114"/>
            <p:cNvSpPr>
              <a:spLocks noChangeArrowheads="1"/>
            </p:cNvSpPr>
            <p:nvPr/>
          </p:nvSpPr>
          <p:spPr bwMode="auto">
            <a:xfrm>
              <a:off x="3439" y="3322"/>
              <a:ext cx="12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Arial" pitchFamily="34" charset="0"/>
                  <a:cs typeface="Arial" pitchFamily="34" charset="0"/>
                </a:rPr>
                <a:t>ori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78" name="Arc 115"/>
            <p:cNvSpPr>
              <a:spLocks/>
            </p:cNvSpPr>
            <p:nvPr/>
          </p:nvSpPr>
          <p:spPr bwMode="auto">
            <a:xfrm>
              <a:off x="4207" y="2861"/>
              <a:ext cx="490" cy="185"/>
            </a:xfrm>
            <a:custGeom>
              <a:avLst/>
              <a:gdLst>
                <a:gd name="G0" fmla="+- 0 0 0"/>
                <a:gd name="G1" fmla="+- 7870 0 0"/>
                <a:gd name="G2" fmla="+- 21600 0 0"/>
                <a:gd name="T0" fmla="*/ 20115 w 20930"/>
                <a:gd name="T1" fmla="*/ 0 h 7870"/>
                <a:gd name="T2" fmla="*/ 20930 w 20930"/>
                <a:gd name="T3" fmla="*/ 2532 h 7870"/>
                <a:gd name="T4" fmla="*/ 0 w 20930"/>
                <a:gd name="T5" fmla="*/ 7870 h 78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930" h="7870" fill="none" extrusionOk="0">
                  <a:moveTo>
                    <a:pt x="20115" y="-1"/>
                  </a:moveTo>
                  <a:cubicBezTo>
                    <a:pt x="20438" y="826"/>
                    <a:pt x="20710" y="1672"/>
                    <a:pt x="20930" y="2531"/>
                  </a:cubicBezTo>
                </a:path>
                <a:path w="20930" h="7870" stroke="0" extrusionOk="0">
                  <a:moveTo>
                    <a:pt x="20115" y="-1"/>
                  </a:moveTo>
                  <a:cubicBezTo>
                    <a:pt x="20438" y="826"/>
                    <a:pt x="20710" y="1672"/>
                    <a:pt x="20930" y="2531"/>
                  </a:cubicBezTo>
                  <a:lnTo>
                    <a:pt x="0" y="7870"/>
                  </a:lnTo>
                  <a:close/>
                </a:path>
              </a:pathLst>
            </a:custGeom>
            <a:noFill/>
            <a:ln w="19050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79" name="Line 116"/>
            <p:cNvSpPr>
              <a:spLocks noChangeShapeType="1"/>
            </p:cNvSpPr>
            <p:nvPr/>
          </p:nvSpPr>
          <p:spPr bwMode="auto">
            <a:xfrm flipH="1">
              <a:off x="4694" y="2867"/>
              <a:ext cx="266" cy="22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80" name="Rectangle 117"/>
            <p:cNvSpPr>
              <a:spLocks noChangeArrowheads="1"/>
            </p:cNvSpPr>
            <p:nvPr/>
          </p:nvSpPr>
          <p:spPr bwMode="auto">
            <a:xfrm>
              <a:off x="4962" y="2803"/>
              <a:ext cx="282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7030A0"/>
                  </a:solidFill>
                  <a:effectLst/>
                  <a:latin typeface="Arial" pitchFamily="34" charset="0"/>
                  <a:cs typeface="Arial" pitchFamily="34" charset="0"/>
                </a:rPr>
                <a:t>SV40 </a:t>
              </a:r>
              <a:r>
                <a:rPr kumimoji="0" lang="en-US" altLang="en-US" sz="800" b="1" i="0" u="none" strike="noStrike" cap="none" normalizeH="0" baseline="0" dirty="0" err="1" smtClean="0">
                  <a:ln>
                    <a:noFill/>
                  </a:ln>
                  <a:solidFill>
                    <a:srgbClr val="7030A0"/>
                  </a:solidFill>
                  <a:effectLst/>
                  <a:latin typeface="Arial" pitchFamily="34" charset="0"/>
                  <a:cs typeface="Arial" pitchFamily="34" charset="0"/>
                </a:rPr>
                <a:t>pA</a:t>
              </a: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7030A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1" i="0" u="none" strike="noStrike" cap="none" normalizeH="0" baseline="0" dirty="0" smtClean="0">
                <a:ln>
                  <a:noFill/>
                </a:ln>
                <a:solidFill>
                  <a:srgbClr val="7030A0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182" name="AutoShape 120"/>
          <p:cNvSpPr>
            <a:spLocks noChangeAspect="1" noChangeArrowheads="1" noTextEdit="1"/>
          </p:cNvSpPr>
          <p:nvPr/>
        </p:nvSpPr>
        <p:spPr bwMode="auto">
          <a:xfrm>
            <a:off x="815975" y="3587750"/>
            <a:ext cx="4094163" cy="28432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4183" name="Freeform 122"/>
          <p:cNvSpPr>
            <a:spLocks/>
          </p:cNvSpPr>
          <p:nvPr/>
        </p:nvSpPr>
        <p:spPr bwMode="auto">
          <a:xfrm>
            <a:off x="1501775" y="3878263"/>
            <a:ext cx="1930400" cy="1928813"/>
          </a:xfrm>
          <a:custGeom>
            <a:avLst/>
            <a:gdLst>
              <a:gd name="T0" fmla="*/ 505 w 1216"/>
              <a:gd name="T1" fmla="*/ 9 h 1215"/>
              <a:gd name="T2" fmla="*/ 350 w 1216"/>
              <a:gd name="T3" fmla="*/ 59 h 1215"/>
              <a:gd name="T4" fmla="*/ 214 w 1216"/>
              <a:gd name="T5" fmla="*/ 147 h 1215"/>
              <a:gd name="T6" fmla="*/ 106 w 1216"/>
              <a:gd name="T7" fmla="*/ 267 h 1215"/>
              <a:gd name="T8" fmla="*/ 33 w 1216"/>
              <a:gd name="T9" fmla="*/ 412 h 1215"/>
              <a:gd name="T10" fmla="*/ 2 w 1216"/>
              <a:gd name="T11" fmla="*/ 571 h 1215"/>
              <a:gd name="T12" fmla="*/ 15 w 1216"/>
              <a:gd name="T13" fmla="*/ 733 h 1215"/>
              <a:gd name="T14" fmla="*/ 69 w 1216"/>
              <a:gd name="T15" fmla="*/ 887 h 1215"/>
              <a:gd name="T16" fmla="*/ 162 w 1216"/>
              <a:gd name="T17" fmla="*/ 1020 h 1215"/>
              <a:gd name="T18" fmla="*/ 288 w 1216"/>
              <a:gd name="T19" fmla="*/ 1123 h 1215"/>
              <a:gd name="T20" fmla="*/ 436 w 1216"/>
              <a:gd name="T21" fmla="*/ 1189 h 1215"/>
              <a:gd name="T22" fmla="*/ 596 w 1216"/>
              <a:gd name="T23" fmla="*/ 1215 h 1215"/>
              <a:gd name="T24" fmla="*/ 758 w 1216"/>
              <a:gd name="T25" fmla="*/ 1195 h 1215"/>
              <a:gd name="T26" fmla="*/ 909 w 1216"/>
              <a:gd name="T27" fmla="*/ 1135 h 1215"/>
              <a:gd name="T28" fmla="*/ 1039 w 1216"/>
              <a:gd name="T29" fmla="*/ 1036 h 1215"/>
              <a:gd name="T30" fmla="*/ 1137 w 1216"/>
              <a:gd name="T31" fmla="*/ 907 h 1215"/>
              <a:gd name="T32" fmla="*/ 1196 w 1216"/>
              <a:gd name="T33" fmla="*/ 756 h 1215"/>
              <a:gd name="T34" fmla="*/ 1216 w 1216"/>
              <a:gd name="T35" fmla="*/ 596 h 1215"/>
              <a:gd name="T36" fmla="*/ 1191 w 1216"/>
              <a:gd name="T37" fmla="*/ 435 h 1215"/>
              <a:gd name="T38" fmla="*/ 1124 w 1216"/>
              <a:gd name="T39" fmla="*/ 287 h 1215"/>
              <a:gd name="T40" fmla="*/ 1020 w 1216"/>
              <a:gd name="T41" fmla="*/ 162 h 1215"/>
              <a:gd name="T42" fmla="*/ 888 w 1216"/>
              <a:gd name="T43" fmla="*/ 68 h 1215"/>
              <a:gd name="T44" fmla="*/ 734 w 1216"/>
              <a:gd name="T45" fmla="*/ 13 h 1215"/>
              <a:gd name="T46" fmla="*/ 615 w 1216"/>
              <a:gd name="T47" fmla="*/ 0 h 1215"/>
              <a:gd name="T48" fmla="*/ 720 w 1216"/>
              <a:gd name="T49" fmla="*/ 24 h 1215"/>
              <a:gd name="T50" fmla="*/ 871 w 1216"/>
              <a:gd name="T51" fmla="*/ 74 h 1215"/>
              <a:gd name="T52" fmla="*/ 1003 w 1216"/>
              <a:gd name="T53" fmla="*/ 164 h 1215"/>
              <a:gd name="T54" fmla="*/ 1107 w 1216"/>
              <a:gd name="T55" fmla="*/ 283 h 1215"/>
              <a:gd name="T56" fmla="*/ 1175 w 1216"/>
              <a:gd name="T57" fmla="*/ 427 h 1215"/>
              <a:gd name="T58" fmla="*/ 1202 w 1216"/>
              <a:gd name="T59" fmla="*/ 584 h 1215"/>
              <a:gd name="T60" fmla="*/ 1188 w 1216"/>
              <a:gd name="T61" fmla="*/ 742 h 1215"/>
              <a:gd name="T62" fmla="*/ 1131 w 1216"/>
              <a:gd name="T63" fmla="*/ 891 h 1215"/>
              <a:gd name="T64" fmla="*/ 1037 w 1216"/>
              <a:gd name="T65" fmla="*/ 1019 h 1215"/>
              <a:gd name="T66" fmla="*/ 913 w 1216"/>
              <a:gd name="T67" fmla="*/ 1118 h 1215"/>
              <a:gd name="T68" fmla="*/ 767 w 1216"/>
              <a:gd name="T69" fmla="*/ 1180 h 1215"/>
              <a:gd name="T70" fmla="*/ 609 w 1216"/>
              <a:gd name="T71" fmla="*/ 1202 h 1215"/>
              <a:gd name="T72" fmla="*/ 451 w 1216"/>
              <a:gd name="T73" fmla="*/ 1181 h 1215"/>
              <a:gd name="T74" fmla="*/ 305 w 1216"/>
              <a:gd name="T75" fmla="*/ 1118 h 1215"/>
              <a:gd name="T76" fmla="*/ 180 w 1216"/>
              <a:gd name="T77" fmla="*/ 1020 h 1215"/>
              <a:gd name="T78" fmla="*/ 86 w 1216"/>
              <a:gd name="T79" fmla="*/ 891 h 1215"/>
              <a:gd name="T80" fmla="*/ 29 w 1216"/>
              <a:gd name="T81" fmla="*/ 743 h 1215"/>
              <a:gd name="T82" fmla="*/ 13 w 1216"/>
              <a:gd name="T83" fmla="*/ 584 h 1215"/>
              <a:gd name="T84" fmla="*/ 42 w 1216"/>
              <a:gd name="T85" fmla="*/ 428 h 1215"/>
              <a:gd name="T86" fmla="*/ 108 w 1216"/>
              <a:gd name="T87" fmla="*/ 284 h 1215"/>
              <a:gd name="T88" fmla="*/ 212 w 1216"/>
              <a:gd name="T89" fmla="*/ 164 h 1215"/>
              <a:gd name="T90" fmla="*/ 345 w 1216"/>
              <a:gd name="T91" fmla="*/ 76 h 1215"/>
              <a:gd name="T92" fmla="*/ 495 w 1216"/>
              <a:gd name="T93" fmla="*/ 24 h 1215"/>
              <a:gd name="T94" fmla="*/ 613 w 1216"/>
              <a:gd name="T95" fmla="*/ 13 h 12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</a:cxnLst>
            <a:rect l="0" t="0" r="r" b="b"/>
            <a:pathLst>
              <a:path w="1216" h="1215">
                <a:moveTo>
                  <a:pt x="613" y="0"/>
                </a:moveTo>
                <a:lnTo>
                  <a:pt x="559" y="3"/>
                </a:lnTo>
                <a:lnTo>
                  <a:pt x="505" y="9"/>
                </a:lnTo>
                <a:lnTo>
                  <a:pt x="451" y="22"/>
                </a:lnTo>
                <a:lnTo>
                  <a:pt x="400" y="37"/>
                </a:lnTo>
                <a:lnTo>
                  <a:pt x="350" y="59"/>
                </a:lnTo>
                <a:lnTo>
                  <a:pt x="302" y="83"/>
                </a:lnTo>
                <a:lnTo>
                  <a:pt x="256" y="113"/>
                </a:lnTo>
                <a:lnTo>
                  <a:pt x="214" y="147"/>
                </a:lnTo>
                <a:lnTo>
                  <a:pt x="174" y="184"/>
                </a:lnTo>
                <a:lnTo>
                  <a:pt x="137" y="223"/>
                </a:lnTo>
                <a:lnTo>
                  <a:pt x="106" y="267"/>
                </a:lnTo>
                <a:lnTo>
                  <a:pt x="77" y="313"/>
                </a:lnTo>
                <a:lnTo>
                  <a:pt x="53" y="363"/>
                </a:lnTo>
                <a:lnTo>
                  <a:pt x="33" y="412"/>
                </a:lnTo>
                <a:lnTo>
                  <a:pt x="17" y="465"/>
                </a:lnTo>
                <a:lnTo>
                  <a:pt x="7" y="517"/>
                </a:lnTo>
                <a:lnTo>
                  <a:pt x="2" y="571"/>
                </a:lnTo>
                <a:lnTo>
                  <a:pt x="0" y="627"/>
                </a:lnTo>
                <a:lnTo>
                  <a:pt x="5" y="681"/>
                </a:lnTo>
                <a:lnTo>
                  <a:pt x="15" y="733"/>
                </a:lnTo>
                <a:lnTo>
                  <a:pt x="27" y="786"/>
                </a:lnTo>
                <a:lnTo>
                  <a:pt x="46" y="837"/>
                </a:lnTo>
                <a:lnTo>
                  <a:pt x="69" y="887"/>
                </a:lnTo>
                <a:lnTo>
                  <a:pt x="96" y="934"/>
                </a:lnTo>
                <a:lnTo>
                  <a:pt x="127" y="978"/>
                </a:lnTo>
                <a:lnTo>
                  <a:pt x="162" y="1020"/>
                </a:lnTo>
                <a:lnTo>
                  <a:pt x="201" y="1057"/>
                </a:lnTo>
                <a:lnTo>
                  <a:pt x="242" y="1093"/>
                </a:lnTo>
                <a:lnTo>
                  <a:pt x="288" y="1123"/>
                </a:lnTo>
                <a:lnTo>
                  <a:pt x="335" y="1150"/>
                </a:lnTo>
                <a:lnTo>
                  <a:pt x="384" y="1172"/>
                </a:lnTo>
                <a:lnTo>
                  <a:pt x="436" y="1189"/>
                </a:lnTo>
                <a:lnTo>
                  <a:pt x="488" y="1202"/>
                </a:lnTo>
                <a:lnTo>
                  <a:pt x="542" y="1211"/>
                </a:lnTo>
                <a:lnTo>
                  <a:pt x="596" y="1215"/>
                </a:lnTo>
                <a:lnTo>
                  <a:pt x="650" y="1214"/>
                </a:lnTo>
                <a:lnTo>
                  <a:pt x="704" y="1207"/>
                </a:lnTo>
                <a:lnTo>
                  <a:pt x="758" y="1195"/>
                </a:lnTo>
                <a:lnTo>
                  <a:pt x="810" y="1180"/>
                </a:lnTo>
                <a:lnTo>
                  <a:pt x="861" y="1160"/>
                </a:lnTo>
                <a:lnTo>
                  <a:pt x="909" y="1135"/>
                </a:lnTo>
                <a:lnTo>
                  <a:pt x="955" y="1106"/>
                </a:lnTo>
                <a:lnTo>
                  <a:pt x="997" y="1073"/>
                </a:lnTo>
                <a:lnTo>
                  <a:pt x="1039" y="1036"/>
                </a:lnTo>
                <a:lnTo>
                  <a:pt x="1074" y="996"/>
                </a:lnTo>
                <a:lnTo>
                  <a:pt x="1107" y="954"/>
                </a:lnTo>
                <a:lnTo>
                  <a:pt x="1137" y="907"/>
                </a:lnTo>
                <a:lnTo>
                  <a:pt x="1161" y="858"/>
                </a:lnTo>
                <a:lnTo>
                  <a:pt x="1181" y="809"/>
                </a:lnTo>
                <a:lnTo>
                  <a:pt x="1196" y="756"/>
                </a:lnTo>
                <a:lnTo>
                  <a:pt x="1208" y="704"/>
                </a:lnTo>
                <a:lnTo>
                  <a:pt x="1215" y="650"/>
                </a:lnTo>
                <a:lnTo>
                  <a:pt x="1216" y="596"/>
                </a:lnTo>
                <a:lnTo>
                  <a:pt x="1212" y="542"/>
                </a:lnTo>
                <a:lnTo>
                  <a:pt x="1204" y="488"/>
                </a:lnTo>
                <a:lnTo>
                  <a:pt x="1191" y="435"/>
                </a:lnTo>
                <a:lnTo>
                  <a:pt x="1172" y="384"/>
                </a:lnTo>
                <a:lnTo>
                  <a:pt x="1151" y="334"/>
                </a:lnTo>
                <a:lnTo>
                  <a:pt x="1124" y="287"/>
                </a:lnTo>
                <a:lnTo>
                  <a:pt x="1094" y="242"/>
                </a:lnTo>
                <a:lnTo>
                  <a:pt x="1058" y="201"/>
                </a:lnTo>
                <a:lnTo>
                  <a:pt x="1020" y="162"/>
                </a:lnTo>
                <a:lnTo>
                  <a:pt x="979" y="127"/>
                </a:lnTo>
                <a:lnTo>
                  <a:pt x="935" y="95"/>
                </a:lnTo>
                <a:lnTo>
                  <a:pt x="888" y="68"/>
                </a:lnTo>
                <a:lnTo>
                  <a:pt x="838" y="46"/>
                </a:lnTo>
                <a:lnTo>
                  <a:pt x="787" y="27"/>
                </a:lnTo>
                <a:lnTo>
                  <a:pt x="734" y="13"/>
                </a:lnTo>
                <a:lnTo>
                  <a:pt x="680" y="5"/>
                </a:lnTo>
                <a:lnTo>
                  <a:pt x="626" y="0"/>
                </a:lnTo>
                <a:lnTo>
                  <a:pt x="615" y="0"/>
                </a:lnTo>
                <a:lnTo>
                  <a:pt x="615" y="13"/>
                </a:lnTo>
                <a:lnTo>
                  <a:pt x="667" y="16"/>
                </a:lnTo>
                <a:lnTo>
                  <a:pt x="720" y="24"/>
                </a:lnTo>
                <a:lnTo>
                  <a:pt x="771" y="36"/>
                </a:lnTo>
                <a:lnTo>
                  <a:pt x="822" y="53"/>
                </a:lnTo>
                <a:lnTo>
                  <a:pt x="871" y="74"/>
                </a:lnTo>
                <a:lnTo>
                  <a:pt x="918" y="100"/>
                </a:lnTo>
                <a:lnTo>
                  <a:pt x="962" y="130"/>
                </a:lnTo>
                <a:lnTo>
                  <a:pt x="1003" y="164"/>
                </a:lnTo>
                <a:lnTo>
                  <a:pt x="1041" y="201"/>
                </a:lnTo>
                <a:lnTo>
                  <a:pt x="1076" y="240"/>
                </a:lnTo>
                <a:lnTo>
                  <a:pt x="1107" y="283"/>
                </a:lnTo>
                <a:lnTo>
                  <a:pt x="1134" y="330"/>
                </a:lnTo>
                <a:lnTo>
                  <a:pt x="1157" y="377"/>
                </a:lnTo>
                <a:lnTo>
                  <a:pt x="1175" y="427"/>
                </a:lnTo>
                <a:lnTo>
                  <a:pt x="1189" y="479"/>
                </a:lnTo>
                <a:lnTo>
                  <a:pt x="1198" y="530"/>
                </a:lnTo>
                <a:lnTo>
                  <a:pt x="1202" y="584"/>
                </a:lnTo>
                <a:lnTo>
                  <a:pt x="1202" y="637"/>
                </a:lnTo>
                <a:lnTo>
                  <a:pt x="1198" y="689"/>
                </a:lnTo>
                <a:lnTo>
                  <a:pt x="1188" y="742"/>
                </a:lnTo>
                <a:lnTo>
                  <a:pt x="1174" y="793"/>
                </a:lnTo>
                <a:lnTo>
                  <a:pt x="1154" y="843"/>
                </a:lnTo>
                <a:lnTo>
                  <a:pt x="1131" y="891"/>
                </a:lnTo>
                <a:lnTo>
                  <a:pt x="1104" y="937"/>
                </a:lnTo>
                <a:lnTo>
                  <a:pt x="1073" y="979"/>
                </a:lnTo>
                <a:lnTo>
                  <a:pt x="1037" y="1019"/>
                </a:lnTo>
                <a:lnTo>
                  <a:pt x="999" y="1056"/>
                </a:lnTo>
                <a:lnTo>
                  <a:pt x="958" y="1089"/>
                </a:lnTo>
                <a:lnTo>
                  <a:pt x="913" y="1118"/>
                </a:lnTo>
                <a:lnTo>
                  <a:pt x="866" y="1143"/>
                </a:lnTo>
                <a:lnTo>
                  <a:pt x="817" y="1164"/>
                </a:lnTo>
                <a:lnTo>
                  <a:pt x="767" y="1180"/>
                </a:lnTo>
                <a:lnTo>
                  <a:pt x="714" y="1192"/>
                </a:lnTo>
                <a:lnTo>
                  <a:pt x="662" y="1199"/>
                </a:lnTo>
                <a:lnTo>
                  <a:pt x="609" y="1202"/>
                </a:lnTo>
                <a:lnTo>
                  <a:pt x="555" y="1199"/>
                </a:lnTo>
                <a:lnTo>
                  <a:pt x="502" y="1192"/>
                </a:lnTo>
                <a:lnTo>
                  <a:pt x="451" y="1181"/>
                </a:lnTo>
                <a:lnTo>
                  <a:pt x="400" y="1164"/>
                </a:lnTo>
                <a:lnTo>
                  <a:pt x="352" y="1144"/>
                </a:lnTo>
                <a:lnTo>
                  <a:pt x="305" y="1118"/>
                </a:lnTo>
                <a:lnTo>
                  <a:pt x="261" y="1089"/>
                </a:lnTo>
                <a:lnTo>
                  <a:pt x="218" y="1056"/>
                </a:lnTo>
                <a:lnTo>
                  <a:pt x="180" y="1020"/>
                </a:lnTo>
                <a:lnTo>
                  <a:pt x="144" y="979"/>
                </a:lnTo>
                <a:lnTo>
                  <a:pt x="113" y="937"/>
                </a:lnTo>
                <a:lnTo>
                  <a:pt x="86" y="891"/>
                </a:lnTo>
                <a:lnTo>
                  <a:pt x="63" y="844"/>
                </a:lnTo>
                <a:lnTo>
                  <a:pt x="43" y="794"/>
                </a:lnTo>
                <a:lnTo>
                  <a:pt x="29" y="743"/>
                </a:lnTo>
                <a:lnTo>
                  <a:pt x="19" y="691"/>
                </a:lnTo>
                <a:lnTo>
                  <a:pt x="15" y="638"/>
                </a:lnTo>
                <a:lnTo>
                  <a:pt x="13" y="584"/>
                </a:lnTo>
                <a:lnTo>
                  <a:pt x="19" y="532"/>
                </a:lnTo>
                <a:lnTo>
                  <a:pt x="27" y="479"/>
                </a:lnTo>
                <a:lnTo>
                  <a:pt x="42" y="428"/>
                </a:lnTo>
                <a:lnTo>
                  <a:pt x="60" y="378"/>
                </a:lnTo>
                <a:lnTo>
                  <a:pt x="81" y="330"/>
                </a:lnTo>
                <a:lnTo>
                  <a:pt x="108" y="284"/>
                </a:lnTo>
                <a:lnTo>
                  <a:pt x="140" y="242"/>
                </a:lnTo>
                <a:lnTo>
                  <a:pt x="174" y="201"/>
                </a:lnTo>
                <a:lnTo>
                  <a:pt x="212" y="164"/>
                </a:lnTo>
                <a:lnTo>
                  <a:pt x="254" y="130"/>
                </a:lnTo>
                <a:lnTo>
                  <a:pt x="298" y="101"/>
                </a:lnTo>
                <a:lnTo>
                  <a:pt x="345" y="76"/>
                </a:lnTo>
                <a:lnTo>
                  <a:pt x="393" y="53"/>
                </a:lnTo>
                <a:lnTo>
                  <a:pt x="444" y="37"/>
                </a:lnTo>
                <a:lnTo>
                  <a:pt x="495" y="24"/>
                </a:lnTo>
                <a:lnTo>
                  <a:pt x="548" y="16"/>
                </a:lnTo>
                <a:lnTo>
                  <a:pt x="601" y="13"/>
                </a:lnTo>
                <a:lnTo>
                  <a:pt x="613" y="13"/>
                </a:lnTo>
                <a:lnTo>
                  <a:pt x="613" y="0"/>
                </a:lnTo>
                <a:close/>
              </a:path>
            </a:pathLst>
          </a:custGeom>
          <a:solidFill>
            <a:srgbClr val="C0C0C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84" name="Oval 123"/>
          <p:cNvSpPr>
            <a:spLocks noChangeArrowheads="1"/>
          </p:cNvSpPr>
          <p:nvPr/>
        </p:nvSpPr>
        <p:spPr bwMode="auto">
          <a:xfrm>
            <a:off x="1501775" y="3878263"/>
            <a:ext cx="1917700" cy="1916113"/>
          </a:xfrm>
          <a:prstGeom prst="ellips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85" name="Oval 124"/>
          <p:cNvSpPr>
            <a:spLocks noChangeArrowheads="1"/>
          </p:cNvSpPr>
          <p:nvPr/>
        </p:nvSpPr>
        <p:spPr bwMode="auto">
          <a:xfrm>
            <a:off x="1522413" y="3898900"/>
            <a:ext cx="1876425" cy="1874838"/>
          </a:xfrm>
          <a:prstGeom prst="ellips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86" name="Line 125"/>
          <p:cNvSpPr>
            <a:spLocks noChangeShapeType="1"/>
          </p:cNvSpPr>
          <p:nvPr/>
        </p:nvSpPr>
        <p:spPr bwMode="auto">
          <a:xfrm flipV="1">
            <a:off x="2474913" y="3878263"/>
            <a:ext cx="0" cy="206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87" name="Rectangle 126"/>
          <p:cNvSpPr>
            <a:spLocks noChangeArrowheads="1"/>
          </p:cNvSpPr>
          <p:nvPr/>
        </p:nvSpPr>
        <p:spPr bwMode="auto">
          <a:xfrm>
            <a:off x="2216150" y="4686300"/>
            <a:ext cx="528638" cy="193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MA379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188" name="Rectangle 127"/>
          <p:cNvSpPr>
            <a:spLocks noChangeArrowheads="1"/>
          </p:cNvSpPr>
          <p:nvPr/>
        </p:nvSpPr>
        <p:spPr bwMode="auto">
          <a:xfrm>
            <a:off x="2136775" y="4879975"/>
            <a:ext cx="6508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itchFamily="49" charset="0"/>
                <a:cs typeface="Arial" pitchFamily="34" charset="0"/>
              </a:rPr>
              <a:t>7117 bp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189" name="Freeform 128"/>
          <p:cNvSpPr>
            <a:spLocks/>
          </p:cNvSpPr>
          <p:nvPr/>
        </p:nvSpPr>
        <p:spPr bwMode="auto">
          <a:xfrm>
            <a:off x="2944813" y="3990975"/>
            <a:ext cx="92075" cy="117475"/>
          </a:xfrm>
          <a:custGeom>
            <a:avLst/>
            <a:gdLst>
              <a:gd name="T0" fmla="*/ 9 w 58"/>
              <a:gd name="T1" fmla="*/ 74 h 74"/>
              <a:gd name="T2" fmla="*/ 54 w 58"/>
              <a:gd name="T3" fmla="*/ 53 h 74"/>
              <a:gd name="T4" fmla="*/ 58 w 58"/>
              <a:gd name="T5" fmla="*/ 0 h 74"/>
              <a:gd name="T6" fmla="*/ 47 w 58"/>
              <a:gd name="T7" fmla="*/ 17 h 74"/>
              <a:gd name="T8" fmla="*/ 26 w 58"/>
              <a:gd name="T9" fmla="*/ 3 h 74"/>
              <a:gd name="T10" fmla="*/ 0 w 58"/>
              <a:gd name="T11" fmla="*/ 46 h 74"/>
              <a:gd name="T12" fmla="*/ 20 w 58"/>
              <a:gd name="T13" fmla="*/ 59 h 74"/>
              <a:gd name="T14" fmla="*/ 9 w 58"/>
              <a:gd name="T15" fmla="*/ 74 h 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58" h="74">
                <a:moveTo>
                  <a:pt x="9" y="74"/>
                </a:moveTo>
                <a:lnTo>
                  <a:pt x="54" y="53"/>
                </a:lnTo>
                <a:lnTo>
                  <a:pt x="58" y="0"/>
                </a:lnTo>
                <a:lnTo>
                  <a:pt x="47" y="17"/>
                </a:lnTo>
                <a:lnTo>
                  <a:pt x="26" y="3"/>
                </a:lnTo>
                <a:lnTo>
                  <a:pt x="0" y="46"/>
                </a:lnTo>
                <a:lnTo>
                  <a:pt x="20" y="59"/>
                </a:lnTo>
                <a:lnTo>
                  <a:pt x="9" y="74"/>
                </a:lnTo>
                <a:close/>
              </a:path>
            </a:pathLst>
          </a:custGeom>
          <a:solidFill>
            <a:srgbClr val="FF66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90" name="Arc 129"/>
          <p:cNvSpPr>
            <a:spLocks/>
          </p:cNvSpPr>
          <p:nvPr/>
        </p:nvSpPr>
        <p:spPr bwMode="auto">
          <a:xfrm>
            <a:off x="2460625" y="4000500"/>
            <a:ext cx="555625" cy="836613"/>
          </a:xfrm>
          <a:custGeom>
            <a:avLst/>
            <a:gdLst>
              <a:gd name="G0" fmla="+- 0 0 0"/>
              <a:gd name="G1" fmla="+- 18325 0 0"/>
              <a:gd name="G2" fmla="+- 21600 0 0"/>
              <a:gd name="T0" fmla="*/ 11435 w 12166"/>
              <a:gd name="T1" fmla="*/ 0 h 18325"/>
              <a:gd name="T2" fmla="*/ 12166 w 12166"/>
              <a:gd name="T3" fmla="*/ 477 h 18325"/>
              <a:gd name="T4" fmla="*/ 0 w 12166"/>
              <a:gd name="T5" fmla="*/ 18325 h 183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166" h="18325" fill="none" extrusionOk="0">
                <a:moveTo>
                  <a:pt x="11434" y="0"/>
                </a:moveTo>
                <a:cubicBezTo>
                  <a:pt x="11681" y="154"/>
                  <a:pt x="11925" y="313"/>
                  <a:pt x="12165" y="477"/>
                </a:cubicBezTo>
              </a:path>
              <a:path w="12166" h="18325" stroke="0" extrusionOk="0">
                <a:moveTo>
                  <a:pt x="11434" y="0"/>
                </a:moveTo>
                <a:cubicBezTo>
                  <a:pt x="11681" y="154"/>
                  <a:pt x="11925" y="313"/>
                  <a:pt x="12165" y="477"/>
                </a:cubicBezTo>
                <a:lnTo>
                  <a:pt x="0" y="18325"/>
                </a:lnTo>
                <a:close/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91" name="Arc 130"/>
          <p:cNvSpPr>
            <a:spLocks/>
          </p:cNvSpPr>
          <p:nvPr/>
        </p:nvSpPr>
        <p:spPr bwMode="auto">
          <a:xfrm>
            <a:off x="2462213" y="4067175"/>
            <a:ext cx="512763" cy="769938"/>
          </a:xfrm>
          <a:custGeom>
            <a:avLst/>
            <a:gdLst>
              <a:gd name="G0" fmla="+- 0 0 0"/>
              <a:gd name="G1" fmla="+- 18332 0 0"/>
              <a:gd name="G2" fmla="+- 21600 0 0"/>
              <a:gd name="T0" fmla="*/ 11423 w 12175"/>
              <a:gd name="T1" fmla="*/ 0 h 18332"/>
              <a:gd name="T2" fmla="*/ 12175 w 12175"/>
              <a:gd name="T3" fmla="*/ 490 h 18332"/>
              <a:gd name="T4" fmla="*/ 0 w 12175"/>
              <a:gd name="T5" fmla="*/ 18332 h 183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175" h="18332" fill="none" extrusionOk="0">
                <a:moveTo>
                  <a:pt x="11423" y="-1"/>
                </a:moveTo>
                <a:cubicBezTo>
                  <a:pt x="11677" y="157"/>
                  <a:pt x="11927" y="321"/>
                  <a:pt x="12174" y="490"/>
                </a:cubicBezTo>
              </a:path>
              <a:path w="12175" h="18332" stroke="0" extrusionOk="0">
                <a:moveTo>
                  <a:pt x="11423" y="-1"/>
                </a:moveTo>
                <a:cubicBezTo>
                  <a:pt x="11677" y="157"/>
                  <a:pt x="11927" y="321"/>
                  <a:pt x="12174" y="490"/>
                </a:cubicBezTo>
                <a:lnTo>
                  <a:pt x="0" y="18332"/>
                </a:lnTo>
                <a:close/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92" name="Line 131"/>
          <p:cNvSpPr>
            <a:spLocks noChangeShapeType="1"/>
          </p:cNvSpPr>
          <p:nvPr/>
        </p:nvSpPr>
        <p:spPr bwMode="auto">
          <a:xfrm flipV="1">
            <a:off x="2944813" y="3995738"/>
            <a:ext cx="41275" cy="682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93" name="Freeform 132"/>
          <p:cNvSpPr>
            <a:spLocks/>
          </p:cNvSpPr>
          <p:nvPr/>
        </p:nvSpPr>
        <p:spPr bwMode="auto">
          <a:xfrm>
            <a:off x="2959100" y="3990975"/>
            <a:ext cx="77788" cy="117475"/>
          </a:xfrm>
          <a:custGeom>
            <a:avLst/>
            <a:gdLst>
              <a:gd name="T0" fmla="*/ 8 w 35"/>
              <a:gd name="T1" fmla="*/ 41 h 52"/>
              <a:gd name="T2" fmla="*/ 0 w 35"/>
              <a:gd name="T3" fmla="*/ 52 h 52"/>
              <a:gd name="T4" fmla="*/ 32 w 35"/>
              <a:gd name="T5" fmla="*/ 37 h 52"/>
              <a:gd name="T6" fmla="*/ 35 w 35"/>
              <a:gd name="T7" fmla="*/ 0 h 52"/>
              <a:gd name="T8" fmla="*/ 27 w 35"/>
              <a:gd name="T9" fmla="*/ 12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5" h="52">
                <a:moveTo>
                  <a:pt x="8" y="41"/>
                </a:moveTo>
                <a:lnTo>
                  <a:pt x="0" y="52"/>
                </a:lnTo>
                <a:lnTo>
                  <a:pt x="32" y="37"/>
                </a:lnTo>
                <a:lnTo>
                  <a:pt x="35" y="0"/>
                </a:lnTo>
                <a:lnTo>
                  <a:pt x="27" y="12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94" name="Line 133"/>
          <p:cNvSpPr>
            <a:spLocks noChangeShapeType="1"/>
          </p:cNvSpPr>
          <p:nvPr/>
        </p:nvSpPr>
        <p:spPr bwMode="auto">
          <a:xfrm flipH="1">
            <a:off x="3019425" y="3935413"/>
            <a:ext cx="304800" cy="82550"/>
          </a:xfrm>
          <a:prstGeom prst="line">
            <a:avLst/>
          </a:prstGeom>
          <a:noFill/>
          <a:ln w="0">
            <a:solidFill>
              <a:srgbClr val="C0804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95" name="Rectangle 134"/>
          <p:cNvSpPr>
            <a:spLocks noChangeArrowheads="1"/>
          </p:cNvSpPr>
          <p:nvPr/>
        </p:nvSpPr>
        <p:spPr bwMode="auto">
          <a:xfrm>
            <a:off x="3330575" y="3762375"/>
            <a:ext cx="352661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300" b="1" i="0" u="none" strike="noStrike" cap="none" normalizeH="0" baseline="0" dirty="0" smtClean="0">
                <a:ln>
                  <a:noFill/>
                </a:ln>
                <a:solidFill>
                  <a:srgbClr val="800000"/>
                </a:solidFill>
                <a:effectLst/>
                <a:latin typeface="Arial" pitchFamily="34" charset="0"/>
                <a:cs typeface="Arial" pitchFamily="34" charset="0"/>
              </a:rPr>
              <a:t>MTS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196" name="Line 135"/>
          <p:cNvSpPr>
            <a:spLocks noChangeShapeType="1"/>
          </p:cNvSpPr>
          <p:nvPr/>
        </p:nvSpPr>
        <p:spPr bwMode="auto">
          <a:xfrm flipH="1">
            <a:off x="2987675" y="4014788"/>
            <a:ext cx="88900" cy="119063"/>
          </a:xfrm>
          <a:prstGeom prst="line">
            <a:avLst/>
          </a:prstGeom>
          <a:noFill/>
          <a:ln w="17463">
            <a:solidFill>
              <a:srgbClr val="000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97" name="Line 136"/>
          <p:cNvSpPr>
            <a:spLocks noChangeShapeType="1"/>
          </p:cNvSpPr>
          <p:nvPr/>
        </p:nvSpPr>
        <p:spPr bwMode="auto">
          <a:xfrm flipH="1" flipV="1">
            <a:off x="3076575" y="4014788"/>
            <a:ext cx="396875" cy="85725"/>
          </a:xfrm>
          <a:prstGeom prst="line">
            <a:avLst/>
          </a:prstGeom>
          <a:noFill/>
          <a:ln w="0">
            <a:solidFill>
              <a:srgbClr val="C0804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98" name="Rectangle 137"/>
          <p:cNvSpPr>
            <a:spLocks noChangeArrowheads="1"/>
          </p:cNvSpPr>
          <p:nvPr/>
        </p:nvSpPr>
        <p:spPr bwMode="auto">
          <a:xfrm>
            <a:off x="3479800" y="3927475"/>
            <a:ext cx="33342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300" b="1" i="0" u="none" strike="noStrike" cap="none" normalizeH="0" baseline="0" dirty="0" err="1" smtClean="0">
                <a:ln>
                  <a:noFill/>
                </a:ln>
                <a:solidFill>
                  <a:srgbClr val="800000"/>
                </a:solidFill>
                <a:effectLst/>
                <a:latin typeface="Arial" pitchFamily="34" charset="0"/>
                <a:cs typeface="Arial" pitchFamily="34" charset="0"/>
              </a:rPr>
              <a:t>myc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199" name="Freeform 138"/>
          <p:cNvSpPr>
            <a:spLocks/>
          </p:cNvSpPr>
          <p:nvPr/>
        </p:nvSpPr>
        <p:spPr bwMode="auto">
          <a:xfrm>
            <a:off x="2933700" y="4186238"/>
            <a:ext cx="338138" cy="419100"/>
          </a:xfrm>
          <a:custGeom>
            <a:avLst/>
            <a:gdLst>
              <a:gd name="T0" fmla="*/ 131 w 213"/>
              <a:gd name="T1" fmla="*/ 244 h 264"/>
              <a:gd name="T2" fmla="*/ 185 w 213"/>
              <a:gd name="T3" fmla="*/ 264 h 264"/>
              <a:gd name="T4" fmla="*/ 213 w 213"/>
              <a:gd name="T5" fmla="*/ 210 h 264"/>
              <a:gd name="T6" fmla="*/ 195 w 213"/>
              <a:gd name="T7" fmla="*/ 217 h 264"/>
              <a:gd name="T8" fmla="*/ 174 w 213"/>
              <a:gd name="T9" fmla="*/ 170 h 264"/>
              <a:gd name="T10" fmla="*/ 148 w 213"/>
              <a:gd name="T11" fmla="*/ 126 h 264"/>
              <a:gd name="T12" fmla="*/ 118 w 213"/>
              <a:gd name="T13" fmla="*/ 85 h 264"/>
              <a:gd name="T14" fmla="*/ 84 w 213"/>
              <a:gd name="T15" fmla="*/ 46 h 264"/>
              <a:gd name="T16" fmla="*/ 46 w 213"/>
              <a:gd name="T17" fmla="*/ 11 h 264"/>
              <a:gd name="T18" fmla="*/ 31 w 213"/>
              <a:gd name="T19" fmla="*/ 0 h 264"/>
              <a:gd name="T20" fmla="*/ 0 w 213"/>
              <a:gd name="T21" fmla="*/ 38 h 264"/>
              <a:gd name="T22" fmla="*/ 36 w 213"/>
              <a:gd name="T23" fmla="*/ 69 h 264"/>
              <a:gd name="T24" fmla="*/ 68 w 213"/>
              <a:gd name="T25" fmla="*/ 102 h 264"/>
              <a:gd name="T26" fmla="*/ 97 w 213"/>
              <a:gd name="T27" fmla="*/ 139 h 264"/>
              <a:gd name="T28" fmla="*/ 122 w 213"/>
              <a:gd name="T29" fmla="*/ 179 h 264"/>
              <a:gd name="T30" fmla="*/ 142 w 213"/>
              <a:gd name="T31" fmla="*/ 221 h 264"/>
              <a:gd name="T32" fmla="*/ 149 w 213"/>
              <a:gd name="T33" fmla="*/ 235 h 264"/>
              <a:gd name="T34" fmla="*/ 131 w 213"/>
              <a:gd name="T35" fmla="*/ 244 h 2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213" h="264">
                <a:moveTo>
                  <a:pt x="131" y="244"/>
                </a:moveTo>
                <a:lnTo>
                  <a:pt x="185" y="264"/>
                </a:lnTo>
                <a:lnTo>
                  <a:pt x="213" y="210"/>
                </a:lnTo>
                <a:lnTo>
                  <a:pt x="195" y="217"/>
                </a:lnTo>
                <a:lnTo>
                  <a:pt x="174" y="170"/>
                </a:lnTo>
                <a:lnTo>
                  <a:pt x="148" y="126"/>
                </a:lnTo>
                <a:lnTo>
                  <a:pt x="118" y="85"/>
                </a:lnTo>
                <a:lnTo>
                  <a:pt x="84" y="46"/>
                </a:lnTo>
                <a:lnTo>
                  <a:pt x="46" y="11"/>
                </a:lnTo>
                <a:lnTo>
                  <a:pt x="31" y="0"/>
                </a:lnTo>
                <a:lnTo>
                  <a:pt x="0" y="38"/>
                </a:lnTo>
                <a:lnTo>
                  <a:pt x="36" y="69"/>
                </a:lnTo>
                <a:lnTo>
                  <a:pt x="68" y="102"/>
                </a:lnTo>
                <a:lnTo>
                  <a:pt x="97" y="139"/>
                </a:lnTo>
                <a:lnTo>
                  <a:pt x="122" y="179"/>
                </a:lnTo>
                <a:lnTo>
                  <a:pt x="142" y="221"/>
                </a:lnTo>
                <a:lnTo>
                  <a:pt x="149" y="235"/>
                </a:lnTo>
                <a:lnTo>
                  <a:pt x="131" y="244"/>
                </a:lnTo>
                <a:close/>
              </a:path>
            </a:pathLst>
          </a:custGeom>
          <a:solidFill>
            <a:srgbClr val="FF66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00" name="Arc 139"/>
          <p:cNvSpPr>
            <a:spLocks/>
          </p:cNvSpPr>
          <p:nvPr/>
        </p:nvSpPr>
        <p:spPr bwMode="auto">
          <a:xfrm>
            <a:off x="2462213" y="4187825"/>
            <a:ext cx="773113" cy="649288"/>
          </a:xfrm>
          <a:custGeom>
            <a:avLst/>
            <a:gdLst>
              <a:gd name="G0" fmla="+- 0 0 0"/>
              <a:gd name="G1" fmla="+- 16873 0 0"/>
              <a:gd name="G2" fmla="+- 21600 0 0"/>
              <a:gd name="T0" fmla="*/ 13486 w 20106"/>
              <a:gd name="T1" fmla="*/ 0 h 16873"/>
              <a:gd name="T2" fmla="*/ 20106 w 20106"/>
              <a:gd name="T3" fmla="*/ 8978 h 16873"/>
              <a:gd name="T4" fmla="*/ 0 w 20106"/>
              <a:gd name="T5" fmla="*/ 16873 h 168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106" h="16873" fill="none" extrusionOk="0">
                <a:moveTo>
                  <a:pt x="13485" y="0"/>
                </a:moveTo>
                <a:cubicBezTo>
                  <a:pt x="16440" y="2361"/>
                  <a:pt x="18723" y="5457"/>
                  <a:pt x="20105" y="8978"/>
                </a:cubicBezTo>
              </a:path>
              <a:path w="20106" h="16873" stroke="0" extrusionOk="0">
                <a:moveTo>
                  <a:pt x="13485" y="0"/>
                </a:moveTo>
                <a:cubicBezTo>
                  <a:pt x="16440" y="2361"/>
                  <a:pt x="18723" y="5457"/>
                  <a:pt x="20105" y="8978"/>
                </a:cubicBezTo>
                <a:lnTo>
                  <a:pt x="0" y="16873"/>
                </a:lnTo>
                <a:close/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01" name="Arc 140"/>
          <p:cNvSpPr>
            <a:spLocks/>
          </p:cNvSpPr>
          <p:nvPr/>
        </p:nvSpPr>
        <p:spPr bwMode="auto">
          <a:xfrm>
            <a:off x="2462213" y="4249738"/>
            <a:ext cx="700088" cy="587375"/>
          </a:xfrm>
          <a:custGeom>
            <a:avLst/>
            <a:gdLst>
              <a:gd name="G0" fmla="+- 0 0 0"/>
              <a:gd name="G1" fmla="+- 16887 0 0"/>
              <a:gd name="G2" fmla="+- 21600 0 0"/>
              <a:gd name="T0" fmla="*/ 13468 w 20105"/>
              <a:gd name="T1" fmla="*/ 0 h 16887"/>
              <a:gd name="T2" fmla="*/ 20105 w 20105"/>
              <a:gd name="T3" fmla="*/ 8990 h 16887"/>
              <a:gd name="T4" fmla="*/ 0 w 20105"/>
              <a:gd name="T5" fmla="*/ 16887 h 168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105" h="16887" fill="none" extrusionOk="0">
                <a:moveTo>
                  <a:pt x="13468" y="-1"/>
                </a:moveTo>
                <a:cubicBezTo>
                  <a:pt x="16430" y="2362"/>
                  <a:pt x="18719" y="5463"/>
                  <a:pt x="20104" y="8990"/>
                </a:cubicBezTo>
              </a:path>
              <a:path w="20105" h="16887" stroke="0" extrusionOk="0">
                <a:moveTo>
                  <a:pt x="13468" y="-1"/>
                </a:moveTo>
                <a:cubicBezTo>
                  <a:pt x="16430" y="2362"/>
                  <a:pt x="18719" y="5463"/>
                  <a:pt x="20104" y="8990"/>
                </a:cubicBezTo>
                <a:lnTo>
                  <a:pt x="0" y="16887"/>
                </a:lnTo>
                <a:close/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02" name="Line 141"/>
          <p:cNvSpPr>
            <a:spLocks noChangeShapeType="1"/>
          </p:cNvSpPr>
          <p:nvPr/>
        </p:nvSpPr>
        <p:spPr bwMode="auto">
          <a:xfrm flipV="1">
            <a:off x="2933700" y="4186238"/>
            <a:ext cx="49213" cy="603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03" name="Freeform 142"/>
          <p:cNvSpPr>
            <a:spLocks/>
          </p:cNvSpPr>
          <p:nvPr/>
        </p:nvSpPr>
        <p:spPr bwMode="auto">
          <a:xfrm>
            <a:off x="3141663" y="4519613"/>
            <a:ext cx="130175" cy="85725"/>
          </a:xfrm>
          <a:custGeom>
            <a:avLst/>
            <a:gdLst>
              <a:gd name="T0" fmla="*/ 13 w 58"/>
              <a:gd name="T1" fmla="*/ 18 h 38"/>
              <a:gd name="T2" fmla="*/ 0 w 58"/>
              <a:gd name="T3" fmla="*/ 24 h 38"/>
              <a:gd name="T4" fmla="*/ 38 w 58"/>
              <a:gd name="T5" fmla="*/ 38 h 38"/>
              <a:gd name="T6" fmla="*/ 58 w 58"/>
              <a:gd name="T7" fmla="*/ 0 h 38"/>
              <a:gd name="T8" fmla="*/ 45 w 58"/>
              <a:gd name="T9" fmla="*/ 5 h 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38">
                <a:moveTo>
                  <a:pt x="13" y="18"/>
                </a:moveTo>
                <a:lnTo>
                  <a:pt x="0" y="24"/>
                </a:lnTo>
                <a:lnTo>
                  <a:pt x="38" y="38"/>
                </a:lnTo>
                <a:lnTo>
                  <a:pt x="58" y="0"/>
                </a:lnTo>
                <a:lnTo>
                  <a:pt x="45" y="5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04" name="Line 143"/>
          <p:cNvSpPr>
            <a:spLocks noChangeShapeType="1"/>
          </p:cNvSpPr>
          <p:nvPr/>
        </p:nvSpPr>
        <p:spPr bwMode="auto">
          <a:xfrm flipH="1">
            <a:off x="3137105" y="4301332"/>
            <a:ext cx="431800" cy="101600"/>
          </a:xfrm>
          <a:prstGeom prst="line">
            <a:avLst/>
          </a:prstGeom>
          <a:noFill/>
          <a:ln w="0">
            <a:solidFill>
              <a:srgbClr val="C0804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05" name="Rectangle 144"/>
          <p:cNvSpPr>
            <a:spLocks noChangeArrowheads="1"/>
          </p:cNvSpPr>
          <p:nvPr/>
        </p:nvSpPr>
        <p:spPr bwMode="auto">
          <a:xfrm>
            <a:off x="3602038" y="4187826"/>
            <a:ext cx="61074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300" b="1" i="0" u="none" strike="noStrike" cap="none" normalizeH="0" baseline="0" dirty="0" smtClean="0">
                <a:ln>
                  <a:noFill/>
                </a:ln>
                <a:solidFill>
                  <a:srgbClr val="800000"/>
                </a:solidFill>
                <a:effectLst/>
                <a:latin typeface="Arial" pitchFamily="34" charset="0"/>
                <a:cs typeface="Arial" pitchFamily="34" charset="0"/>
              </a:rPr>
              <a:t>mUNG1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206" name="Freeform 145"/>
          <p:cNvSpPr>
            <a:spLocks/>
          </p:cNvSpPr>
          <p:nvPr/>
        </p:nvSpPr>
        <p:spPr bwMode="auto">
          <a:xfrm>
            <a:off x="1473200" y="4457700"/>
            <a:ext cx="165100" cy="663575"/>
          </a:xfrm>
          <a:custGeom>
            <a:avLst/>
            <a:gdLst>
              <a:gd name="T0" fmla="*/ 104 w 104"/>
              <a:gd name="T1" fmla="*/ 52 h 418"/>
              <a:gd name="T2" fmla="*/ 77 w 104"/>
              <a:gd name="T3" fmla="*/ 0 h 418"/>
              <a:gd name="T4" fmla="*/ 20 w 104"/>
              <a:gd name="T5" fmla="*/ 22 h 418"/>
              <a:gd name="T6" fmla="*/ 38 w 104"/>
              <a:gd name="T7" fmla="*/ 27 h 418"/>
              <a:gd name="T8" fmla="*/ 21 w 104"/>
              <a:gd name="T9" fmla="*/ 81 h 418"/>
              <a:gd name="T10" fmla="*/ 10 w 104"/>
              <a:gd name="T11" fmla="*/ 135 h 418"/>
              <a:gd name="T12" fmla="*/ 3 w 104"/>
              <a:gd name="T13" fmla="*/ 191 h 418"/>
              <a:gd name="T14" fmla="*/ 0 w 104"/>
              <a:gd name="T15" fmla="*/ 248 h 418"/>
              <a:gd name="T16" fmla="*/ 3 w 104"/>
              <a:gd name="T17" fmla="*/ 303 h 418"/>
              <a:gd name="T18" fmla="*/ 11 w 104"/>
              <a:gd name="T19" fmla="*/ 358 h 418"/>
              <a:gd name="T20" fmla="*/ 24 w 104"/>
              <a:gd name="T21" fmla="*/ 412 h 418"/>
              <a:gd name="T22" fmla="*/ 25 w 104"/>
              <a:gd name="T23" fmla="*/ 418 h 418"/>
              <a:gd name="T24" fmla="*/ 74 w 104"/>
              <a:gd name="T25" fmla="*/ 404 h 418"/>
              <a:gd name="T26" fmla="*/ 61 w 104"/>
              <a:gd name="T27" fmla="*/ 354 h 418"/>
              <a:gd name="T28" fmla="*/ 52 w 104"/>
              <a:gd name="T29" fmla="*/ 303 h 418"/>
              <a:gd name="T30" fmla="*/ 50 w 104"/>
              <a:gd name="T31" fmla="*/ 252 h 418"/>
              <a:gd name="T32" fmla="*/ 51 w 104"/>
              <a:gd name="T33" fmla="*/ 201 h 418"/>
              <a:gd name="T34" fmla="*/ 57 w 104"/>
              <a:gd name="T35" fmla="*/ 150 h 418"/>
              <a:gd name="T36" fmla="*/ 68 w 104"/>
              <a:gd name="T37" fmla="*/ 98 h 418"/>
              <a:gd name="T38" fmla="*/ 82 w 104"/>
              <a:gd name="T39" fmla="*/ 50 h 418"/>
              <a:gd name="T40" fmla="*/ 85 w 104"/>
              <a:gd name="T41" fmla="*/ 44 h 418"/>
              <a:gd name="T42" fmla="*/ 104 w 104"/>
              <a:gd name="T43" fmla="*/ 52 h 4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</a:cxnLst>
            <a:rect l="0" t="0" r="r" b="b"/>
            <a:pathLst>
              <a:path w="104" h="418">
                <a:moveTo>
                  <a:pt x="104" y="52"/>
                </a:moveTo>
                <a:lnTo>
                  <a:pt x="77" y="0"/>
                </a:lnTo>
                <a:lnTo>
                  <a:pt x="20" y="22"/>
                </a:lnTo>
                <a:lnTo>
                  <a:pt x="38" y="27"/>
                </a:lnTo>
                <a:lnTo>
                  <a:pt x="21" y="81"/>
                </a:lnTo>
                <a:lnTo>
                  <a:pt x="10" y="135"/>
                </a:lnTo>
                <a:lnTo>
                  <a:pt x="3" y="191"/>
                </a:lnTo>
                <a:lnTo>
                  <a:pt x="0" y="248"/>
                </a:lnTo>
                <a:lnTo>
                  <a:pt x="3" y="303"/>
                </a:lnTo>
                <a:lnTo>
                  <a:pt x="11" y="358"/>
                </a:lnTo>
                <a:lnTo>
                  <a:pt x="24" y="412"/>
                </a:lnTo>
                <a:lnTo>
                  <a:pt x="25" y="418"/>
                </a:lnTo>
                <a:lnTo>
                  <a:pt x="74" y="404"/>
                </a:lnTo>
                <a:lnTo>
                  <a:pt x="61" y="354"/>
                </a:lnTo>
                <a:lnTo>
                  <a:pt x="52" y="303"/>
                </a:lnTo>
                <a:lnTo>
                  <a:pt x="50" y="252"/>
                </a:lnTo>
                <a:lnTo>
                  <a:pt x="51" y="201"/>
                </a:lnTo>
                <a:lnTo>
                  <a:pt x="57" y="150"/>
                </a:lnTo>
                <a:lnTo>
                  <a:pt x="68" y="98"/>
                </a:lnTo>
                <a:lnTo>
                  <a:pt x="82" y="50"/>
                </a:lnTo>
                <a:lnTo>
                  <a:pt x="85" y="44"/>
                </a:lnTo>
                <a:lnTo>
                  <a:pt x="104" y="52"/>
                </a:lnTo>
                <a:close/>
              </a:path>
            </a:pathLst>
          </a:custGeom>
          <a:solidFill>
            <a:srgbClr val="FF66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07" name="Arc 146"/>
          <p:cNvSpPr>
            <a:spLocks/>
          </p:cNvSpPr>
          <p:nvPr/>
        </p:nvSpPr>
        <p:spPr bwMode="auto">
          <a:xfrm>
            <a:off x="1473200" y="4500563"/>
            <a:ext cx="987425" cy="620713"/>
          </a:xfrm>
          <a:custGeom>
            <a:avLst/>
            <a:gdLst>
              <a:gd name="G0" fmla="+- 21600 0 0"/>
              <a:gd name="G1" fmla="+- 7376 0 0"/>
              <a:gd name="G2" fmla="+- 21600 0 0"/>
              <a:gd name="T0" fmla="*/ 911 w 21600"/>
              <a:gd name="T1" fmla="*/ 13584 h 13584"/>
              <a:gd name="T2" fmla="*/ 1298 w 21600"/>
              <a:gd name="T3" fmla="*/ 0 h 13584"/>
              <a:gd name="T4" fmla="*/ 21600 w 21600"/>
              <a:gd name="T5" fmla="*/ 7376 h 135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600" h="13584" fill="none" extrusionOk="0">
                <a:moveTo>
                  <a:pt x="911" y="13583"/>
                </a:moveTo>
                <a:cubicBezTo>
                  <a:pt x="307" y="11569"/>
                  <a:pt x="0" y="9478"/>
                  <a:pt x="0" y="7376"/>
                </a:cubicBezTo>
                <a:cubicBezTo>
                  <a:pt x="-1" y="4860"/>
                  <a:pt x="439" y="2364"/>
                  <a:pt x="1298" y="0"/>
                </a:cubicBezTo>
              </a:path>
              <a:path w="21600" h="13584" stroke="0" extrusionOk="0">
                <a:moveTo>
                  <a:pt x="911" y="13583"/>
                </a:moveTo>
                <a:cubicBezTo>
                  <a:pt x="307" y="11569"/>
                  <a:pt x="0" y="9478"/>
                  <a:pt x="0" y="7376"/>
                </a:cubicBezTo>
                <a:cubicBezTo>
                  <a:pt x="-1" y="4860"/>
                  <a:pt x="439" y="2364"/>
                  <a:pt x="1298" y="0"/>
                </a:cubicBezTo>
                <a:lnTo>
                  <a:pt x="21600" y="7376"/>
                </a:lnTo>
                <a:close/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08" name="Arc 147"/>
          <p:cNvSpPr>
            <a:spLocks/>
          </p:cNvSpPr>
          <p:nvPr/>
        </p:nvSpPr>
        <p:spPr bwMode="auto">
          <a:xfrm>
            <a:off x="1552575" y="4527550"/>
            <a:ext cx="909638" cy="571500"/>
          </a:xfrm>
          <a:custGeom>
            <a:avLst/>
            <a:gdLst>
              <a:gd name="G0" fmla="+- 21600 0 0"/>
              <a:gd name="G1" fmla="+- 7372 0 0"/>
              <a:gd name="G2" fmla="+- 21600 0 0"/>
              <a:gd name="T0" fmla="*/ 917 w 21600"/>
              <a:gd name="T1" fmla="*/ 13599 h 13599"/>
              <a:gd name="T2" fmla="*/ 1297 w 21600"/>
              <a:gd name="T3" fmla="*/ 0 h 13599"/>
              <a:gd name="T4" fmla="*/ 21600 w 21600"/>
              <a:gd name="T5" fmla="*/ 7372 h 1359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600" h="13599" fill="none" extrusionOk="0">
                <a:moveTo>
                  <a:pt x="917" y="13598"/>
                </a:moveTo>
                <a:cubicBezTo>
                  <a:pt x="308" y="11579"/>
                  <a:pt x="0" y="9481"/>
                  <a:pt x="0" y="7372"/>
                </a:cubicBezTo>
                <a:cubicBezTo>
                  <a:pt x="-1" y="4857"/>
                  <a:pt x="438" y="2363"/>
                  <a:pt x="1296" y="-1"/>
                </a:cubicBezTo>
              </a:path>
              <a:path w="21600" h="13599" stroke="0" extrusionOk="0">
                <a:moveTo>
                  <a:pt x="917" y="13598"/>
                </a:moveTo>
                <a:cubicBezTo>
                  <a:pt x="308" y="11579"/>
                  <a:pt x="0" y="9481"/>
                  <a:pt x="0" y="7372"/>
                </a:cubicBezTo>
                <a:cubicBezTo>
                  <a:pt x="-1" y="4857"/>
                  <a:pt x="438" y="2363"/>
                  <a:pt x="1296" y="-1"/>
                </a:cubicBezTo>
                <a:lnTo>
                  <a:pt x="21600" y="7372"/>
                </a:lnTo>
                <a:close/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09" name="Line 148"/>
          <p:cNvSpPr>
            <a:spLocks noChangeShapeType="1"/>
          </p:cNvSpPr>
          <p:nvPr/>
        </p:nvSpPr>
        <p:spPr bwMode="auto">
          <a:xfrm flipH="1">
            <a:off x="1512888" y="5099050"/>
            <a:ext cx="77788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10" name="Freeform 149"/>
          <p:cNvSpPr>
            <a:spLocks/>
          </p:cNvSpPr>
          <p:nvPr/>
        </p:nvSpPr>
        <p:spPr bwMode="auto">
          <a:xfrm>
            <a:off x="1504950" y="4457700"/>
            <a:ext cx="133350" cy="82550"/>
          </a:xfrm>
          <a:custGeom>
            <a:avLst/>
            <a:gdLst>
              <a:gd name="T0" fmla="*/ 46 w 59"/>
              <a:gd name="T1" fmla="*/ 31 h 36"/>
              <a:gd name="T2" fmla="*/ 59 w 59"/>
              <a:gd name="T3" fmla="*/ 36 h 36"/>
              <a:gd name="T4" fmla="*/ 40 w 59"/>
              <a:gd name="T5" fmla="*/ 0 h 36"/>
              <a:gd name="T6" fmla="*/ 0 w 59"/>
              <a:gd name="T7" fmla="*/ 15 h 36"/>
              <a:gd name="T8" fmla="*/ 13 w 59"/>
              <a:gd name="T9" fmla="*/ 19 h 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9" h="36">
                <a:moveTo>
                  <a:pt x="46" y="31"/>
                </a:moveTo>
                <a:lnTo>
                  <a:pt x="59" y="36"/>
                </a:lnTo>
                <a:lnTo>
                  <a:pt x="40" y="0"/>
                </a:lnTo>
                <a:lnTo>
                  <a:pt x="0" y="15"/>
                </a:lnTo>
                <a:lnTo>
                  <a:pt x="13" y="19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11" name="Line 150"/>
          <p:cNvSpPr>
            <a:spLocks noChangeShapeType="1"/>
          </p:cNvSpPr>
          <p:nvPr/>
        </p:nvSpPr>
        <p:spPr bwMode="auto">
          <a:xfrm>
            <a:off x="1181100" y="4765675"/>
            <a:ext cx="293688" cy="11113"/>
          </a:xfrm>
          <a:prstGeom prst="line">
            <a:avLst/>
          </a:prstGeom>
          <a:noFill/>
          <a:ln w="0">
            <a:solidFill>
              <a:srgbClr val="C0804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12" name="Rectangle 151"/>
          <p:cNvSpPr>
            <a:spLocks noChangeArrowheads="1"/>
          </p:cNvSpPr>
          <p:nvPr/>
        </p:nvSpPr>
        <p:spPr bwMode="auto">
          <a:xfrm>
            <a:off x="849313" y="4592638"/>
            <a:ext cx="315792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300" b="1" i="0" u="none" strike="noStrike" cap="none" normalizeH="0" baseline="0" dirty="0" smtClean="0">
                <a:ln>
                  <a:noFill/>
                </a:ln>
                <a:solidFill>
                  <a:srgbClr val="800000"/>
                </a:solidFill>
                <a:effectLst/>
                <a:latin typeface="Arial" pitchFamily="34" charset="0"/>
                <a:cs typeface="Arial" pitchFamily="34" charset="0"/>
              </a:rPr>
              <a:t>Neo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213" name="Freeform 152"/>
          <p:cNvSpPr>
            <a:spLocks/>
          </p:cNvSpPr>
          <p:nvPr/>
        </p:nvSpPr>
        <p:spPr bwMode="auto">
          <a:xfrm>
            <a:off x="3019425" y="5114925"/>
            <a:ext cx="409575" cy="519113"/>
          </a:xfrm>
          <a:custGeom>
            <a:avLst/>
            <a:gdLst>
              <a:gd name="T0" fmla="*/ 30 w 258"/>
              <a:gd name="T1" fmla="*/ 327 h 327"/>
              <a:gd name="T2" fmla="*/ 73 w 258"/>
              <a:gd name="T3" fmla="*/ 291 h 327"/>
              <a:gd name="T4" fmla="*/ 112 w 258"/>
              <a:gd name="T5" fmla="*/ 251 h 327"/>
              <a:gd name="T6" fmla="*/ 148 w 258"/>
              <a:gd name="T7" fmla="*/ 209 h 327"/>
              <a:gd name="T8" fmla="*/ 181 w 258"/>
              <a:gd name="T9" fmla="*/ 163 h 327"/>
              <a:gd name="T10" fmla="*/ 209 w 258"/>
              <a:gd name="T11" fmla="*/ 115 h 327"/>
              <a:gd name="T12" fmla="*/ 232 w 258"/>
              <a:gd name="T13" fmla="*/ 64 h 327"/>
              <a:gd name="T14" fmla="*/ 239 w 258"/>
              <a:gd name="T15" fmla="*/ 45 h 327"/>
              <a:gd name="T16" fmla="*/ 258 w 258"/>
              <a:gd name="T17" fmla="*/ 52 h 327"/>
              <a:gd name="T18" fmla="*/ 228 w 258"/>
              <a:gd name="T19" fmla="*/ 0 h 327"/>
              <a:gd name="T20" fmla="*/ 174 w 258"/>
              <a:gd name="T21" fmla="*/ 21 h 327"/>
              <a:gd name="T22" fmla="*/ 192 w 258"/>
              <a:gd name="T23" fmla="*/ 28 h 327"/>
              <a:gd name="T24" fmla="*/ 172 w 258"/>
              <a:gd name="T25" fmla="*/ 75 h 327"/>
              <a:gd name="T26" fmla="*/ 148 w 258"/>
              <a:gd name="T27" fmla="*/ 121 h 327"/>
              <a:gd name="T28" fmla="*/ 121 w 258"/>
              <a:gd name="T29" fmla="*/ 165 h 327"/>
              <a:gd name="T30" fmla="*/ 88 w 258"/>
              <a:gd name="T31" fmla="*/ 204 h 327"/>
              <a:gd name="T32" fmla="*/ 53 w 258"/>
              <a:gd name="T33" fmla="*/ 243 h 327"/>
              <a:gd name="T34" fmla="*/ 14 w 258"/>
              <a:gd name="T35" fmla="*/ 277 h 327"/>
              <a:gd name="T36" fmla="*/ 0 w 258"/>
              <a:gd name="T37" fmla="*/ 287 h 327"/>
              <a:gd name="T38" fmla="*/ 30 w 258"/>
              <a:gd name="T39" fmla="*/ 327 h 3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258" h="327">
                <a:moveTo>
                  <a:pt x="30" y="327"/>
                </a:moveTo>
                <a:lnTo>
                  <a:pt x="73" y="291"/>
                </a:lnTo>
                <a:lnTo>
                  <a:pt x="112" y="251"/>
                </a:lnTo>
                <a:lnTo>
                  <a:pt x="148" y="209"/>
                </a:lnTo>
                <a:lnTo>
                  <a:pt x="181" y="163"/>
                </a:lnTo>
                <a:lnTo>
                  <a:pt x="209" y="115"/>
                </a:lnTo>
                <a:lnTo>
                  <a:pt x="232" y="64"/>
                </a:lnTo>
                <a:lnTo>
                  <a:pt x="239" y="45"/>
                </a:lnTo>
                <a:lnTo>
                  <a:pt x="258" y="52"/>
                </a:lnTo>
                <a:lnTo>
                  <a:pt x="228" y="0"/>
                </a:lnTo>
                <a:lnTo>
                  <a:pt x="174" y="21"/>
                </a:lnTo>
                <a:lnTo>
                  <a:pt x="192" y="28"/>
                </a:lnTo>
                <a:lnTo>
                  <a:pt x="172" y="75"/>
                </a:lnTo>
                <a:lnTo>
                  <a:pt x="148" y="121"/>
                </a:lnTo>
                <a:lnTo>
                  <a:pt x="121" y="165"/>
                </a:lnTo>
                <a:lnTo>
                  <a:pt x="88" y="204"/>
                </a:lnTo>
                <a:lnTo>
                  <a:pt x="53" y="243"/>
                </a:lnTo>
                <a:lnTo>
                  <a:pt x="14" y="277"/>
                </a:lnTo>
                <a:lnTo>
                  <a:pt x="0" y="287"/>
                </a:lnTo>
                <a:lnTo>
                  <a:pt x="30" y="327"/>
                </a:lnTo>
                <a:close/>
              </a:path>
            </a:pathLst>
          </a:custGeom>
          <a:solidFill>
            <a:srgbClr val="FF66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15" name="Arc 153"/>
          <p:cNvSpPr>
            <a:spLocks/>
          </p:cNvSpPr>
          <p:nvPr/>
        </p:nvSpPr>
        <p:spPr bwMode="auto">
          <a:xfrm>
            <a:off x="2460625" y="4837113"/>
            <a:ext cx="925513" cy="785813"/>
          </a:xfrm>
          <a:custGeom>
            <a:avLst/>
            <a:gdLst>
              <a:gd name="G0" fmla="+- 0 0 0"/>
              <a:gd name="G1" fmla="+- 0 0 0"/>
              <a:gd name="G2" fmla="+- 21600 0 0"/>
              <a:gd name="T0" fmla="*/ 20241 w 20241"/>
              <a:gd name="T1" fmla="*/ 7541 h 17194"/>
              <a:gd name="T2" fmla="*/ 13074 w 20241"/>
              <a:gd name="T3" fmla="*/ 17194 h 17194"/>
              <a:gd name="T4" fmla="*/ 0 w 20241"/>
              <a:gd name="T5" fmla="*/ 0 h 171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241" h="17194" fill="none" extrusionOk="0">
                <a:moveTo>
                  <a:pt x="20240" y="7540"/>
                </a:moveTo>
                <a:cubicBezTo>
                  <a:pt x="18813" y="11372"/>
                  <a:pt x="16328" y="14719"/>
                  <a:pt x="13073" y="17193"/>
                </a:cubicBezTo>
              </a:path>
              <a:path w="20241" h="17194" stroke="0" extrusionOk="0">
                <a:moveTo>
                  <a:pt x="20240" y="7540"/>
                </a:moveTo>
                <a:cubicBezTo>
                  <a:pt x="18813" y="11372"/>
                  <a:pt x="16328" y="14719"/>
                  <a:pt x="13073" y="17193"/>
                </a:cubicBezTo>
                <a:lnTo>
                  <a:pt x="0" y="0"/>
                </a:lnTo>
                <a:close/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16" name="Arc 154"/>
          <p:cNvSpPr>
            <a:spLocks/>
          </p:cNvSpPr>
          <p:nvPr/>
        </p:nvSpPr>
        <p:spPr bwMode="auto">
          <a:xfrm>
            <a:off x="2462213" y="4837113"/>
            <a:ext cx="850900" cy="722313"/>
          </a:xfrm>
          <a:custGeom>
            <a:avLst/>
            <a:gdLst>
              <a:gd name="G0" fmla="+- 0 0 0"/>
              <a:gd name="G1" fmla="+- 0 0 0"/>
              <a:gd name="G2" fmla="+- 21600 0 0"/>
              <a:gd name="T0" fmla="*/ 20228 w 20228"/>
              <a:gd name="T1" fmla="*/ 7575 h 17210"/>
              <a:gd name="T2" fmla="*/ 13052 w 20228"/>
              <a:gd name="T3" fmla="*/ 17210 h 17210"/>
              <a:gd name="T4" fmla="*/ 0 w 20228"/>
              <a:gd name="T5" fmla="*/ 0 h 172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228" h="17210" fill="none" extrusionOk="0">
                <a:moveTo>
                  <a:pt x="20228" y="7575"/>
                </a:moveTo>
                <a:cubicBezTo>
                  <a:pt x="18795" y="11400"/>
                  <a:pt x="16307" y="14741"/>
                  <a:pt x="13052" y="17210"/>
                </a:cubicBezTo>
              </a:path>
              <a:path w="20228" h="17210" stroke="0" extrusionOk="0">
                <a:moveTo>
                  <a:pt x="20228" y="7575"/>
                </a:moveTo>
                <a:cubicBezTo>
                  <a:pt x="18795" y="11400"/>
                  <a:pt x="16307" y="14741"/>
                  <a:pt x="13052" y="17210"/>
                </a:cubicBezTo>
                <a:lnTo>
                  <a:pt x="0" y="0"/>
                </a:lnTo>
                <a:close/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17" name="Line 155"/>
          <p:cNvSpPr>
            <a:spLocks noChangeShapeType="1"/>
          </p:cNvSpPr>
          <p:nvPr/>
        </p:nvSpPr>
        <p:spPr bwMode="auto">
          <a:xfrm>
            <a:off x="3019425" y="5570538"/>
            <a:ext cx="47625" cy="635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18" name="Freeform 156"/>
          <p:cNvSpPr>
            <a:spLocks/>
          </p:cNvSpPr>
          <p:nvPr/>
        </p:nvSpPr>
        <p:spPr bwMode="auto">
          <a:xfrm>
            <a:off x="3295650" y="5114925"/>
            <a:ext cx="133350" cy="82550"/>
          </a:xfrm>
          <a:custGeom>
            <a:avLst/>
            <a:gdLst>
              <a:gd name="T0" fmla="*/ 13 w 59"/>
              <a:gd name="T1" fmla="*/ 20 h 37"/>
              <a:gd name="T2" fmla="*/ 0 w 59"/>
              <a:gd name="T3" fmla="*/ 15 h 37"/>
              <a:gd name="T4" fmla="*/ 38 w 59"/>
              <a:gd name="T5" fmla="*/ 0 h 37"/>
              <a:gd name="T6" fmla="*/ 59 w 59"/>
              <a:gd name="T7" fmla="*/ 37 h 37"/>
              <a:gd name="T8" fmla="*/ 46 w 59"/>
              <a:gd name="T9" fmla="*/ 32 h 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9" h="37">
                <a:moveTo>
                  <a:pt x="13" y="20"/>
                </a:moveTo>
                <a:lnTo>
                  <a:pt x="0" y="15"/>
                </a:lnTo>
                <a:lnTo>
                  <a:pt x="38" y="0"/>
                </a:lnTo>
                <a:lnTo>
                  <a:pt x="59" y="37"/>
                </a:lnTo>
                <a:lnTo>
                  <a:pt x="46" y="32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19" name="Line 157"/>
          <p:cNvSpPr>
            <a:spLocks noChangeShapeType="1"/>
          </p:cNvSpPr>
          <p:nvPr/>
        </p:nvSpPr>
        <p:spPr bwMode="auto">
          <a:xfrm flipH="1" flipV="1">
            <a:off x="3282950" y="5408613"/>
            <a:ext cx="312738" cy="11113"/>
          </a:xfrm>
          <a:prstGeom prst="line">
            <a:avLst/>
          </a:prstGeom>
          <a:noFill/>
          <a:ln w="0">
            <a:solidFill>
              <a:srgbClr val="C0804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20" name="Rectangle 158"/>
          <p:cNvSpPr>
            <a:spLocks noChangeArrowheads="1"/>
          </p:cNvSpPr>
          <p:nvPr/>
        </p:nvSpPr>
        <p:spPr bwMode="auto">
          <a:xfrm>
            <a:off x="3602038" y="5421313"/>
            <a:ext cx="4381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300" b="1" i="0" u="none" strike="noStrike" cap="none" normalizeH="0" baseline="0" smtClean="0">
                <a:ln>
                  <a:noFill/>
                </a:ln>
                <a:solidFill>
                  <a:srgbClr val="800000"/>
                </a:solidFill>
                <a:effectLst/>
                <a:latin typeface="Arial" pitchFamily="34" charset="0"/>
                <a:cs typeface="Arial" pitchFamily="34" charset="0"/>
              </a:rPr>
              <a:t>EGFP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224" name="Arc 162"/>
          <p:cNvSpPr>
            <a:spLocks/>
          </p:cNvSpPr>
          <p:nvPr/>
        </p:nvSpPr>
        <p:spPr bwMode="auto">
          <a:xfrm>
            <a:off x="1793875" y="4264025"/>
            <a:ext cx="668338" cy="571500"/>
          </a:xfrm>
          <a:custGeom>
            <a:avLst/>
            <a:gdLst>
              <a:gd name="G0" fmla="+- 18243 0 0"/>
              <a:gd name="G1" fmla="+- 15604 0 0"/>
              <a:gd name="G2" fmla="+- 21600 0 0"/>
              <a:gd name="T0" fmla="*/ 0 w 18243"/>
              <a:gd name="T1" fmla="*/ 4039 h 15604"/>
              <a:gd name="T2" fmla="*/ 3308 w 18243"/>
              <a:gd name="T3" fmla="*/ 0 h 15604"/>
              <a:gd name="T4" fmla="*/ 18243 w 18243"/>
              <a:gd name="T5" fmla="*/ 15604 h 156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243" h="15604" fill="none" extrusionOk="0">
                <a:moveTo>
                  <a:pt x="-1" y="4038"/>
                </a:moveTo>
                <a:cubicBezTo>
                  <a:pt x="935" y="2563"/>
                  <a:pt x="2045" y="1207"/>
                  <a:pt x="3307" y="-1"/>
                </a:cubicBezTo>
              </a:path>
              <a:path w="18243" h="15604" stroke="0" extrusionOk="0">
                <a:moveTo>
                  <a:pt x="-1" y="4038"/>
                </a:moveTo>
                <a:cubicBezTo>
                  <a:pt x="935" y="2563"/>
                  <a:pt x="2045" y="1207"/>
                  <a:pt x="3307" y="-1"/>
                </a:cubicBezTo>
                <a:lnTo>
                  <a:pt x="18243" y="15604"/>
                </a:lnTo>
                <a:close/>
              </a:path>
            </a:pathLst>
          </a:custGeom>
          <a:noFill/>
          <a:ln w="14288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25" name="Line 163"/>
          <p:cNvSpPr>
            <a:spLocks noChangeShapeType="1"/>
          </p:cNvSpPr>
          <p:nvPr/>
        </p:nvSpPr>
        <p:spPr bwMode="auto">
          <a:xfrm>
            <a:off x="1423988" y="4070350"/>
            <a:ext cx="428625" cy="266700"/>
          </a:xfrm>
          <a:prstGeom prst="line">
            <a:avLst/>
          </a:prstGeom>
          <a:noFill/>
          <a:ln w="0">
            <a:solidFill>
              <a:srgbClr val="C0804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26" name="Rectangle 164"/>
          <p:cNvSpPr>
            <a:spLocks noChangeArrowheads="1"/>
          </p:cNvSpPr>
          <p:nvPr/>
        </p:nvSpPr>
        <p:spPr bwMode="auto">
          <a:xfrm>
            <a:off x="844550" y="3956050"/>
            <a:ext cx="55784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1" i="0" u="none" strike="noStrike" cap="none" normalizeH="0" baseline="0" dirty="0" err="1" smtClean="0">
                <a:ln>
                  <a:noFill/>
                </a:ln>
                <a:solidFill>
                  <a:srgbClr val="800080"/>
                </a:solidFill>
                <a:effectLst/>
                <a:latin typeface="Arial" pitchFamily="34" charset="0"/>
                <a:cs typeface="Arial" pitchFamily="34" charset="0"/>
              </a:rPr>
              <a:t>HSVTk</a:t>
            </a:r>
            <a:r>
              <a:rPr kumimoji="0" lang="en-US" altLang="en-US" sz="900" b="1" i="0" u="none" strike="noStrike" cap="none" normalizeH="0" baseline="0" dirty="0" smtClean="0">
                <a:ln>
                  <a:noFill/>
                </a:ln>
                <a:solidFill>
                  <a:srgbClr val="80008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en-US" altLang="en-US" sz="900" b="1" i="0" u="none" strike="noStrike" cap="none" normalizeH="0" baseline="0" dirty="0" err="1" smtClean="0">
                <a:ln>
                  <a:noFill/>
                </a:ln>
                <a:solidFill>
                  <a:srgbClr val="800080"/>
                </a:solidFill>
                <a:effectLst/>
                <a:latin typeface="Arial" pitchFamily="34" charset="0"/>
                <a:cs typeface="Arial" pitchFamily="34" charset="0"/>
              </a:rPr>
              <a:t>pA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227" name="Arc 165"/>
          <p:cNvSpPr>
            <a:spLocks/>
          </p:cNvSpPr>
          <p:nvPr/>
        </p:nvSpPr>
        <p:spPr bwMode="auto">
          <a:xfrm>
            <a:off x="2462213" y="4613275"/>
            <a:ext cx="788988" cy="222250"/>
          </a:xfrm>
          <a:custGeom>
            <a:avLst/>
            <a:gdLst>
              <a:gd name="G0" fmla="+- 0 0 0"/>
              <a:gd name="G1" fmla="+- 6059 0 0"/>
              <a:gd name="G2" fmla="+- 21600 0 0"/>
              <a:gd name="T0" fmla="*/ 20733 w 21525"/>
              <a:gd name="T1" fmla="*/ 0 h 6059"/>
              <a:gd name="T2" fmla="*/ 21525 w 21525"/>
              <a:gd name="T3" fmla="*/ 4260 h 6059"/>
              <a:gd name="T4" fmla="*/ 0 w 21525"/>
              <a:gd name="T5" fmla="*/ 6059 h 60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525" h="6059" fill="none" extrusionOk="0">
                <a:moveTo>
                  <a:pt x="20732" y="0"/>
                </a:moveTo>
                <a:cubicBezTo>
                  <a:pt x="21138" y="1389"/>
                  <a:pt x="21404" y="2817"/>
                  <a:pt x="21524" y="4260"/>
                </a:cubicBezTo>
              </a:path>
              <a:path w="21525" h="6059" stroke="0" extrusionOk="0">
                <a:moveTo>
                  <a:pt x="20732" y="0"/>
                </a:moveTo>
                <a:cubicBezTo>
                  <a:pt x="21138" y="1389"/>
                  <a:pt x="21404" y="2817"/>
                  <a:pt x="21524" y="4260"/>
                </a:cubicBezTo>
                <a:lnTo>
                  <a:pt x="0" y="6059"/>
                </a:lnTo>
                <a:close/>
              </a:path>
            </a:pathLst>
          </a:custGeom>
          <a:noFill/>
          <a:ln w="14288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28" name="Line 166"/>
          <p:cNvSpPr>
            <a:spLocks noChangeShapeType="1"/>
          </p:cNvSpPr>
          <p:nvPr/>
        </p:nvSpPr>
        <p:spPr bwMode="auto">
          <a:xfrm flipH="1" flipV="1">
            <a:off x="3249613" y="4691063"/>
            <a:ext cx="498475" cy="44450"/>
          </a:xfrm>
          <a:prstGeom prst="line">
            <a:avLst/>
          </a:prstGeom>
          <a:noFill/>
          <a:ln w="0">
            <a:solidFill>
              <a:srgbClr val="C0804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29" name="Rectangle 167"/>
          <p:cNvSpPr>
            <a:spLocks noChangeArrowheads="1"/>
          </p:cNvSpPr>
          <p:nvPr/>
        </p:nvSpPr>
        <p:spPr bwMode="auto">
          <a:xfrm>
            <a:off x="3752850" y="4621213"/>
            <a:ext cx="46807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1" i="0" u="none" strike="noStrike" cap="none" normalizeH="0" baseline="0" dirty="0" smtClean="0">
                <a:ln>
                  <a:noFill/>
                </a:ln>
                <a:solidFill>
                  <a:srgbClr val="800080"/>
                </a:solidFill>
                <a:effectLst/>
                <a:latin typeface="Arial" pitchFamily="34" charset="0"/>
                <a:cs typeface="Arial" pitchFamily="34" charset="0"/>
              </a:rPr>
              <a:t>SV40 </a:t>
            </a:r>
            <a:r>
              <a:rPr kumimoji="0" lang="en-US" altLang="en-US" sz="900" b="1" i="0" u="none" strike="noStrike" cap="none" normalizeH="0" baseline="0" dirty="0" err="1" smtClean="0">
                <a:ln>
                  <a:noFill/>
                </a:ln>
                <a:solidFill>
                  <a:srgbClr val="800080"/>
                </a:solidFill>
                <a:effectLst/>
                <a:latin typeface="Arial" pitchFamily="34" charset="0"/>
                <a:cs typeface="Arial" pitchFamily="34" charset="0"/>
              </a:rPr>
              <a:t>pA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230" name="Arc 168"/>
          <p:cNvSpPr>
            <a:spLocks/>
          </p:cNvSpPr>
          <p:nvPr/>
        </p:nvSpPr>
        <p:spPr bwMode="auto">
          <a:xfrm>
            <a:off x="2462213" y="4835525"/>
            <a:ext cx="790575" cy="131763"/>
          </a:xfrm>
          <a:custGeom>
            <a:avLst/>
            <a:gdLst>
              <a:gd name="G0" fmla="+- 0 0 0"/>
              <a:gd name="G1" fmla="+- 0 0 0"/>
              <a:gd name="G2" fmla="+- 21600 0 0"/>
              <a:gd name="T0" fmla="*/ 21581 w 21581"/>
              <a:gd name="T1" fmla="*/ 898 h 3589"/>
              <a:gd name="T2" fmla="*/ 21300 w 21581"/>
              <a:gd name="T3" fmla="*/ 3589 h 3589"/>
              <a:gd name="T4" fmla="*/ 0 w 21581"/>
              <a:gd name="T5" fmla="*/ 0 h 35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581" h="3589" fill="none" extrusionOk="0">
                <a:moveTo>
                  <a:pt x="21581" y="898"/>
                </a:moveTo>
                <a:cubicBezTo>
                  <a:pt x="21543" y="1799"/>
                  <a:pt x="21449" y="2698"/>
                  <a:pt x="21299" y="3588"/>
                </a:cubicBezTo>
              </a:path>
              <a:path w="21581" h="3589" stroke="0" extrusionOk="0">
                <a:moveTo>
                  <a:pt x="21581" y="898"/>
                </a:moveTo>
                <a:cubicBezTo>
                  <a:pt x="21543" y="1799"/>
                  <a:pt x="21449" y="2698"/>
                  <a:pt x="21299" y="3588"/>
                </a:cubicBezTo>
                <a:lnTo>
                  <a:pt x="0" y="0"/>
                </a:lnTo>
                <a:close/>
              </a:path>
            </a:pathLst>
          </a:custGeom>
          <a:noFill/>
          <a:ln w="14288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31" name="Line 169"/>
          <p:cNvSpPr>
            <a:spLocks noChangeShapeType="1"/>
          </p:cNvSpPr>
          <p:nvPr/>
        </p:nvSpPr>
        <p:spPr bwMode="auto">
          <a:xfrm flipH="1" flipV="1">
            <a:off x="3260725" y="4918075"/>
            <a:ext cx="512763" cy="31750"/>
          </a:xfrm>
          <a:prstGeom prst="line">
            <a:avLst/>
          </a:prstGeom>
          <a:noFill/>
          <a:ln w="0">
            <a:solidFill>
              <a:srgbClr val="C0804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32" name="Rectangle 170"/>
          <p:cNvSpPr>
            <a:spLocks noChangeArrowheads="1"/>
          </p:cNvSpPr>
          <p:nvPr/>
        </p:nvSpPr>
        <p:spPr bwMode="auto">
          <a:xfrm>
            <a:off x="3778250" y="4953000"/>
            <a:ext cx="41036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1" i="0" u="none" strike="noStrike" cap="none" normalizeH="0" baseline="0" dirty="0" err="1" smtClean="0">
                <a:ln>
                  <a:noFill/>
                </a:ln>
                <a:solidFill>
                  <a:srgbClr val="800080"/>
                </a:solidFill>
                <a:effectLst/>
                <a:latin typeface="Arial" pitchFamily="34" charset="0"/>
                <a:cs typeface="Arial" pitchFamily="34" charset="0"/>
              </a:rPr>
              <a:t>BGHpA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233" name="Freeform 171"/>
          <p:cNvSpPr>
            <a:spLocks/>
          </p:cNvSpPr>
          <p:nvPr/>
        </p:nvSpPr>
        <p:spPr bwMode="auto">
          <a:xfrm>
            <a:off x="2474913" y="3849688"/>
            <a:ext cx="474663" cy="203200"/>
          </a:xfrm>
          <a:custGeom>
            <a:avLst/>
            <a:gdLst>
              <a:gd name="T0" fmla="*/ 244 w 299"/>
              <a:gd name="T1" fmla="*/ 128 h 128"/>
              <a:gd name="T2" fmla="*/ 299 w 299"/>
              <a:gd name="T3" fmla="*/ 108 h 128"/>
              <a:gd name="T4" fmla="*/ 283 w 299"/>
              <a:gd name="T5" fmla="*/ 48 h 128"/>
              <a:gd name="T6" fmla="*/ 275 w 299"/>
              <a:gd name="T7" fmla="*/ 67 h 128"/>
              <a:gd name="T8" fmla="*/ 224 w 299"/>
              <a:gd name="T9" fmla="*/ 44 h 128"/>
              <a:gd name="T10" fmla="*/ 171 w 299"/>
              <a:gd name="T11" fmla="*/ 25 h 128"/>
              <a:gd name="T12" fmla="*/ 117 w 299"/>
              <a:gd name="T13" fmla="*/ 13 h 128"/>
              <a:gd name="T14" fmla="*/ 61 w 299"/>
              <a:gd name="T15" fmla="*/ 4 h 128"/>
              <a:gd name="T16" fmla="*/ 5 w 299"/>
              <a:gd name="T17" fmla="*/ 0 h 128"/>
              <a:gd name="T18" fmla="*/ 2 w 299"/>
              <a:gd name="T19" fmla="*/ 0 h 128"/>
              <a:gd name="T20" fmla="*/ 0 w 299"/>
              <a:gd name="T21" fmla="*/ 50 h 128"/>
              <a:gd name="T22" fmla="*/ 53 w 299"/>
              <a:gd name="T23" fmla="*/ 52 h 128"/>
              <a:gd name="T24" fmla="*/ 103 w 299"/>
              <a:gd name="T25" fmla="*/ 59 h 128"/>
              <a:gd name="T26" fmla="*/ 154 w 299"/>
              <a:gd name="T27" fmla="*/ 72 h 128"/>
              <a:gd name="T28" fmla="*/ 202 w 299"/>
              <a:gd name="T29" fmla="*/ 88 h 128"/>
              <a:gd name="T30" fmla="*/ 249 w 299"/>
              <a:gd name="T31" fmla="*/ 109 h 128"/>
              <a:gd name="T32" fmla="*/ 252 w 299"/>
              <a:gd name="T33" fmla="*/ 111 h 128"/>
              <a:gd name="T34" fmla="*/ 244 w 299"/>
              <a:gd name="T35" fmla="*/ 128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299" h="128">
                <a:moveTo>
                  <a:pt x="244" y="128"/>
                </a:moveTo>
                <a:lnTo>
                  <a:pt x="299" y="108"/>
                </a:lnTo>
                <a:lnTo>
                  <a:pt x="283" y="48"/>
                </a:lnTo>
                <a:lnTo>
                  <a:pt x="275" y="67"/>
                </a:lnTo>
                <a:lnTo>
                  <a:pt x="224" y="44"/>
                </a:lnTo>
                <a:lnTo>
                  <a:pt x="171" y="25"/>
                </a:lnTo>
                <a:lnTo>
                  <a:pt x="117" y="13"/>
                </a:lnTo>
                <a:lnTo>
                  <a:pt x="61" y="4"/>
                </a:lnTo>
                <a:lnTo>
                  <a:pt x="5" y="0"/>
                </a:lnTo>
                <a:lnTo>
                  <a:pt x="2" y="0"/>
                </a:lnTo>
                <a:lnTo>
                  <a:pt x="0" y="50"/>
                </a:lnTo>
                <a:lnTo>
                  <a:pt x="53" y="52"/>
                </a:lnTo>
                <a:lnTo>
                  <a:pt x="103" y="59"/>
                </a:lnTo>
                <a:lnTo>
                  <a:pt x="154" y="72"/>
                </a:lnTo>
                <a:lnTo>
                  <a:pt x="202" y="88"/>
                </a:lnTo>
                <a:lnTo>
                  <a:pt x="249" y="109"/>
                </a:lnTo>
                <a:lnTo>
                  <a:pt x="252" y="111"/>
                </a:lnTo>
                <a:lnTo>
                  <a:pt x="244" y="128"/>
                </a:lnTo>
                <a:close/>
              </a:path>
            </a:pathLst>
          </a:custGeom>
          <a:pattFill prst="openDmnd">
            <a:fgClr>
              <a:srgbClr val="000080"/>
            </a:fgClr>
            <a:bgClr>
              <a:srgbClr val="FFFFFF"/>
            </a:bgClr>
          </a:patt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34" name="Arc 172"/>
          <p:cNvSpPr>
            <a:spLocks/>
          </p:cNvSpPr>
          <p:nvPr/>
        </p:nvSpPr>
        <p:spPr bwMode="auto">
          <a:xfrm>
            <a:off x="2460625" y="3851275"/>
            <a:ext cx="449263" cy="985838"/>
          </a:xfrm>
          <a:custGeom>
            <a:avLst/>
            <a:gdLst>
              <a:gd name="G0" fmla="+- 0 0 0"/>
              <a:gd name="G1" fmla="+- 21597 0 0"/>
              <a:gd name="G2" fmla="+- 21600 0 0"/>
              <a:gd name="T0" fmla="*/ 382 w 9833"/>
              <a:gd name="T1" fmla="*/ 0 h 21597"/>
              <a:gd name="T2" fmla="*/ 9833 w 9833"/>
              <a:gd name="T3" fmla="*/ 2365 h 21597"/>
              <a:gd name="T4" fmla="*/ 0 w 9833"/>
              <a:gd name="T5" fmla="*/ 21597 h 215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833" h="21597" fill="none" extrusionOk="0">
                <a:moveTo>
                  <a:pt x="381" y="0"/>
                </a:moveTo>
                <a:cubicBezTo>
                  <a:pt x="3671" y="58"/>
                  <a:pt x="6903" y="867"/>
                  <a:pt x="9833" y="2364"/>
                </a:cubicBezTo>
              </a:path>
              <a:path w="9833" h="21597" stroke="0" extrusionOk="0">
                <a:moveTo>
                  <a:pt x="381" y="0"/>
                </a:moveTo>
                <a:cubicBezTo>
                  <a:pt x="3671" y="58"/>
                  <a:pt x="6903" y="867"/>
                  <a:pt x="9833" y="2364"/>
                </a:cubicBezTo>
                <a:lnTo>
                  <a:pt x="0" y="21597"/>
                </a:lnTo>
                <a:close/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35" name="Arc 173"/>
          <p:cNvSpPr>
            <a:spLocks/>
          </p:cNvSpPr>
          <p:nvPr/>
        </p:nvSpPr>
        <p:spPr bwMode="auto">
          <a:xfrm>
            <a:off x="2462213" y="3930650"/>
            <a:ext cx="411163" cy="906463"/>
          </a:xfrm>
          <a:custGeom>
            <a:avLst/>
            <a:gdLst>
              <a:gd name="G0" fmla="+- 0 0 0"/>
              <a:gd name="G1" fmla="+- 21598 0 0"/>
              <a:gd name="G2" fmla="+- 21600 0 0"/>
              <a:gd name="T0" fmla="*/ 302 w 9782"/>
              <a:gd name="T1" fmla="*/ 0 h 21598"/>
              <a:gd name="T2" fmla="*/ 9782 w 9782"/>
              <a:gd name="T3" fmla="*/ 2340 h 21598"/>
              <a:gd name="T4" fmla="*/ 0 w 9782"/>
              <a:gd name="T5" fmla="*/ 21598 h 2159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782" h="21598" fill="none" extrusionOk="0">
                <a:moveTo>
                  <a:pt x="301" y="0"/>
                </a:moveTo>
                <a:cubicBezTo>
                  <a:pt x="3599" y="46"/>
                  <a:pt x="6842" y="846"/>
                  <a:pt x="9782" y="2339"/>
                </a:cubicBezTo>
              </a:path>
              <a:path w="9782" h="21598" stroke="0" extrusionOk="0">
                <a:moveTo>
                  <a:pt x="301" y="0"/>
                </a:moveTo>
                <a:cubicBezTo>
                  <a:pt x="3599" y="46"/>
                  <a:pt x="6842" y="846"/>
                  <a:pt x="9782" y="2339"/>
                </a:cubicBezTo>
                <a:lnTo>
                  <a:pt x="0" y="21598"/>
                </a:lnTo>
                <a:close/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36" name="Line 174"/>
          <p:cNvSpPr>
            <a:spLocks noChangeShapeType="1"/>
          </p:cNvSpPr>
          <p:nvPr/>
        </p:nvSpPr>
        <p:spPr bwMode="auto">
          <a:xfrm flipV="1">
            <a:off x="2474913" y="3849688"/>
            <a:ext cx="3175" cy="793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37" name="Freeform 175"/>
          <p:cNvSpPr>
            <a:spLocks/>
          </p:cNvSpPr>
          <p:nvPr/>
        </p:nvSpPr>
        <p:spPr bwMode="auto">
          <a:xfrm>
            <a:off x="2862263" y="3925888"/>
            <a:ext cx="87313" cy="127000"/>
          </a:xfrm>
          <a:custGeom>
            <a:avLst/>
            <a:gdLst>
              <a:gd name="T0" fmla="*/ 6 w 39"/>
              <a:gd name="T1" fmla="*/ 44 h 56"/>
              <a:gd name="T2" fmla="*/ 0 w 39"/>
              <a:gd name="T3" fmla="*/ 56 h 56"/>
              <a:gd name="T4" fmla="*/ 39 w 39"/>
              <a:gd name="T5" fmla="*/ 42 h 56"/>
              <a:gd name="T6" fmla="*/ 28 w 39"/>
              <a:gd name="T7" fmla="*/ 0 h 56"/>
              <a:gd name="T8" fmla="*/ 22 w 39"/>
              <a:gd name="T9" fmla="*/ 13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56">
                <a:moveTo>
                  <a:pt x="6" y="44"/>
                </a:moveTo>
                <a:lnTo>
                  <a:pt x="0" y="56"/>
                </a:lnTo>
                <a:lnTo>
                  <a:pt x="39" y="42"/>
                </a:lnTo>
                <a:lnTo>
                  <a:pt x="28" y="0"/>
                </a:lnTo>
                <a:lnTo>
                  <a:pt x="22" y="13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38" name="Line 176"/>
          <p:cNvSpPr>
            <a:spLocks noChangeShapeType="1"/>
          </p:cNvSpPr>
          <p:nvPr/>
        </p:nvSpPr>
        <p:spPr bwMode="auto">
          <a:xfrm flipH="1">
            <a:off x="2732088" y="3749675"/>
            <a:ext cx="312738" cy="136525"/>
          </a:xfrm>
          <a:prstGeom prst="line">
            <a:avLst/>
          </a:prstGeom>
          <a:noFill/>
          <a:ln w="0">
            <a:solidFill>
              <a:srgbClr val="C0804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39" name="Rectangle 177"/>
          <p:cNvSpPr>
            <a:spLocks noChangeArrowheads="1"/>
          </p:cNvSpPr>
          <p:nvPr/>
        </p:nvSpPr>
        <p:spPr bwMode="auto">
          <a:xfrm>
            <a:off x="3051175" y="3603625"/>
            <a:ext cx="314189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8000"/>
                </a:solidFill>
                <a:effectLst/>
                <a:latin typeface="Arial" pitchFamily="34" charset="0"/>
                <a:cs typeface="Arial" pitchFamily="34" charset="0"/>
              </a:rPr>
              <a:t>CMV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240" name="Freeform 178"/>
          <p:cNvSpPr>
            <a:spLocks/>
          </p:cNvSpPr>
          <p:nvPr/>
        </p:nvSpPr>
        <p:spPr bwMode="auto">
          <a:xfrm>
            <a:off x="1547813" y="5207000"/>
            <a:ext cx="161925" cy="192088"/>
          </a:xfrm>
          <a:custGeom>
            <a:avLst/>
            <a:gdLst>
              <a:gd name="T0" fmla="*/ 79 w 102"/>
              <a:gd name="T1" fmla="*/ 16 h 121"/>
              <a:gd name="T2" fmla="*/ 24 w 102"/>
              <a:gd name="T3" fmla="*/ 0 h 121"/>
              <a:gd name="T4" fmla="*/ 0 w 102"/>
              <a:gd name="T5" fmla="*/ 56 h 121"/>
              <a:gd name="T6" fmla="*/ 18 w 102"/>
              <a:gd name="T7" fmla="*/ 47 h 121"/>
              <a:gd name="T8" fmla="*/ 44 w 102"/>
              <a:gd name="T9" fmla="*/ 95 h 121"/>
              <a:gd name="T10" fmla="*/ 61 w 102"/>
              <a:gd name="T11" fmla="*/ 121 h 121"/>
              <a:gd name="T12" fmla="*/ 102 w 102"/>
              <a:gd name="T13" fmla="*/ 92 h 121"/>
              <a:gd name="T14" fmla="*/ 75 w 102"/>
              <a:gd name="T15" fmla="*/ 48 h 121"/>
              <a:gd name="T16" fmla="*/ 62 w 102"/>
              <a:gd name="T17" fmla="*/ 24 h 121"/>
              <a:gd name="T18" fmla="*/ 79 w 102"/>
              <a:gd name="T19" fmla="*/ 16 h 1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02" h="121">
                <a:moveTo>
                  <a:pt x="79" y="16"/>
                </a:moveTo>
                <a:lnTo>
                  <a:pt x="24" y="0"/>
                </a:lnTo>
                <a:lnTo>
                  <a:pt x="0" y="56"/>
                </a:lnTo>
                <a:lnTo>
                  <a:pt x="18" y="47"/>
                </a:lnTo>
                <a:lnTo>
                  <a:pt x="44" y="95"/>
                </a:lnTo>
                <a:lnTo>
                  <a:pt x="61" y="121"/>
                </a:lnTo>
                <a:lnTo>
                  <a:pt x="102" y="92"/>
                </a:lnTo>
                <a:lnTo>
                  <a:pt x="75" y="48"/>
                </a:lnTo>
                <a:lnTo>
                  <a:pt x="62" y="24"/>
                </a:lnTo>
                <a:lnTo>
                  <a:pt x="79" y="16"/>
                </a:lnTo>
                <a:close/>
              </a:path>
            </a:pathLst>
          </a:custGeom>
          <a:pattFill prst="openDmnd">
            <a:fgClr>
              <a:srgbClr val="000080"/>
            </a:fgClr>
            <a:bgClr>
              <a:srgbClr val="FFFFFF"/>
            </a:bgClr>
          </a:patt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41" name="Arc 179"/>
          <p:cNvSpPr>
            <a:spLocks/>
          </p:cNvSpPr>
          <p:nvPr/>
        </p:nvSpPr>
        <p:spPr bwMode="auto">
          <a:xfrm>
            <a:off x="1577975" y="4837113"/>
            <a:ext cx="882650" cy="560388"/>
          </a:xfrm>
          <a:custGeom>
            <a:avLst/>
            <a:gdLst>
              <a:gd name="G0" fmla="+- 19296 0 0"/>
              <a:gd name="G1" fmla="+- 0 0 0"/>
              <a:gd name="G2" fmla="+- 21600 0 0"/>
              <a:gd name="T0" fmla="*/ 1511 w 19296"/>
              <a:gd name="T1" fmla="*/ 12258 h 12258"/>
              <a:gd name="T2" fmla="*/ 0 w 19296"/>
              <a:gd name="T3" fmla="*/ 9708 h 12258"/>
              <a:gd name="T4" fmla="*/ 19296 w 19296"/>
              <a:gd name="T5" fmla="*/ 0 h 122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296" h="12258" fill="none" extrusionOk="0">
                <a:moveTo>
                  <a:pt x="1511" y="12257"/>
                </a:moveTo>
                <a:cubicBezTo>
                  <a:pt x="949" y="11443"/>
                  <a:pt x="444" y="10591"/>
                  <a:pt x="0" y="9707"/>
                </a:cubicBezTo>
              </a:path>
              <a:path w="19296" h="12258" stroke="0" extrusionOk="0">
                <a:moveTo>
                  <a:pt x="1511" y="12257"/>
                </a:moveTo>
                <a:cubicBezTo>
                  <a:pt x="949" y="11443"/>
                  <a:pt x="444" y="10591"/>
                  <a:pt x="0" y="9707"/>
                </a:cubicBezTo>
                <a:lnTo>
                  <a:pt x="19296" y="0"/>
                </a:lnTo>
                <a:close/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42" name="Arc 180"/>
          <p:cNvSpPr>
            <a:spLocks/>
          </p:cNvSpPr>
          <p:nvPr/>
        </p:nvSpPr>
        <p:spPr bwMode="auto">
          <a:xfrm>
            <a:off x="1649413" y="4837113"/>
            <a:ext cx="812800" cy="514350"/>
          </a:xfrm>
          <a:custGeom>
            <a:avLst/>
            <a:gdLst>
              <a:gd name="G0" fmla="+- 19313 0 0"/>
              <a:gd name="G1" fmla="+- 0 0 0"/>
              <a:gd name="G2" fmla="+- 21600 0 0"/>
              <a:gd name="T0" fmla="*/ 1508 w 19313"/>
              <a:gd name="T1" fmla="*/ 12229 h 12229"/>
              <a:gd name="T2" fmla="*/ 0 w 19313"/>
              <a:gd name="T3" fmla="*/ 9673 h 12229"/>
              <a:gd name="T4" fmla="*/ 19313 w 19313"/>
              <a:gd name="T5" fmla="*/ 0 h 122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313" h="12229" fill="none" extrusionOk="0">
                <a:moveTo>
                  <a:pt x="1508" y="12228"/>
                </a:moveTo>
                <a:cubicBezTo>
                  <a:pt x="947" y="11412"/>
                  <a:pt x="443" y="10558"/>
                  <a:pt x="-1" y="9673"/>
                </a:cubicBezTo>
              </a:path>
              <a:path w="19313" h="12229" stroke="0" extrusionOk="0">
                <a:moveTo>
                  <a:pt x="1508" y="12228"/>
                </a:moveTo>
                <a:cubicBezTo>
                  <a:pt x="947" y="11412"/>
                  <a:pt x="443" y="10558"/>
                  <a:pt x="-1" y="9673"/>
                </a:cubicBezTo>
                <a:lnTo>
                  <a:pt x="19313" y="0"/>
                </a:lnTo>
                <a:close/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43" name="Line 181"/>
          <p:cNvSpPr>
            <a:spLocks noChangeShapeType="1"/>
          </p:cNvSpPr>
          <p:nvPr/>
        </p:nvSpPr>
        <p:spPr bwMode="auto">
          <a:xfrm flipH="1">
            <a:off x="1644650" y="5353050"/>
            <a:ext cx="65088" cy="460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44" name="Freeform 182"/>
          <p:cNvSpPr>
            <a:spLocks/>
          </p:cNvSpPr>
          <p:nvPr/>
        </p:nvSpPr>
        <p:spPr bwMode="auto">
          <a:xfrm>
            <a:off x="1547813" y="5207000"/>
            <a:ext cx="125413" cy="88900"/>
          </a:xfrm>
          <a:custGeom>
            <a:avLst/>
            <a:gdLst>
              <a:gd name="T0" fmla="*/ 44 w 56"/>
              <a:gd name="T1" fmla="*/ 17 h 39"/>
              <a:gd name="T2" fmla="*/ 56 w 56"/>
              <a:gd name="T3" fmla="*/ 11 h 39"/>
              <a:gd name="T4" fmla="*/ 17 w 56"/>
              <a:gd name="T5" fmla="*/ 0 h 39"/>
              <a:gd name="T6" fmla="*/ 0 w 56"/>
              <a:gd name="T7" fmla="*/ 39 h 39"/>
              <a:gd name="T8" fmla="*/ 13 w 56"/>
              <a:gd name="T9" fmla="*/ 33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6" h="39">
                <a:moveTo>
                  <a:pt x="44" y="17"/>
                </a:moveTo>
                <a:lnTo>
                  <a:pt x="56" y="11"/>
                </a:lnTo>
                <a:lnTo>
                  <a:pt x="17" y="0"/>
                </a:lnTo>
                <a:lnTo>
                  <a:pt x="0" y="39"/>
                </a:lnTo>
                <a:lnTo>
                  <a:pt x="13" y="33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45" name="Line 183"/>
          <p:cNvSpPr>
            <a:spLocks noChangeShapeType="1"/>
          </p:cNvSpPr>
          <p:nvPr/>
        </p:nvSpPr>
        <p:spPr bwMode="auto">
          <a:xfrm flipV="1">
            <a:off x="1328738" y="5310188"/>
            <a:ext cx="263525" cy="127000"/>
          </a:xfrm>
          <a:prstGeom prst="line">
            <a:avLst/>
          </a:prstGeom>
          <a:noFill/>
          <a:ln w="0">
            <a:solidFill>
              <a:srgbClr val="C0804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46" name="Rectangle 184"/>
          <p:cNvSpPr>
            <a:spLocks noChangeArrowheads="1"/>
          </p:cNvSpPr>
          <p:nvPr/>
        </p:nvSpPr>
        <p:spPr bwMode="auto">
          <a:xfrm>
            <a:off x="977900" y="5430838"/>
            <a:ext cx="346249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8000"/>
                </a:solidFill>
                <a:effectLst/>
                <a:latin typeface="Arial" pitchFamily="34" charset="0"/>
                <a:cs typeface="Arial" pitchFamily="34" charset="0"/>
              </a:rPr>
              <a:t>SV40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247" name="Freeform 185"/>
          <p:cNvSpPr>
            <a:spLocks/>
          </p:cNvSpPr>
          <p:nvPr/>
        </p:nvSpPr>
        <p:spPr bwMode="auto">
          <a:xfrm>
            <a:off x="2066925" y="5588000"/>
            <a:ext cx="962025" cy="246063"/>
          </a:xfrm>
          <a:custGeom>
            <a:avLst/>
            <a:gdLst>
              <a:gd name="T0" fmla="*/ 0 w 606"/>
              <a:gd name="T1" fmla="*/ 103 h 155"/>
              <a:gd name="T2" fmla="*/ 51 w 606"/>
              <a:gd name="T3" fmla="*/ 122 h 155"/>
              <a:gd name="T4" fmla="*/ 105 w 606"/>
              <a:gd name="T5" fmla="*/ 138 h 155"/>
              <a:gd name="T6" fmla="*/ 161 w 606"/>
              <a:gd name="T7" fmla="*/ 149 h 155"/>
              <a:gd name="T8" fmla="*/ 216 w 606"/>
              <a:gd name="T9" fmla="*/ 155 h 155"/>
              <a:gd name="T10" fmla="*/ 272 w 606"/>
              <a:gd name="T11" fmla="*/ 155 h 155"/>
              <a:gd name="T12" fmla="*/ 328 w 606"/>
              <a:gd name="T13" fmla="*/ 151 h 155"/>
              <a:gd name="T14" fmla="*/ 382 w 606"/>
              <a:gd name="T15" fmla="*/ 142 h 155"/>
              <a:gd name="T16" fmla="*/ 438 w 606"/>
              <a:gd name="T17" fmla="*/ 128 h 155"/>
              <a:gd name="T18" fmla="*/ 491 w 606"/>
              <a:gd name="T19" fmla="*/ 108 h 155"/>
              <a:gd name="T20" fmla="*/ 540 w 606"/>
              <a:gd name="T21" fmla="*/ 85 h 155"/>
              <a:gd name="T22" fmla="*/ 586 w 606"/>
              <a:gd name="T23" fmla="*/ 60 h 155"/>
              <a:gd name="T24" fmla="*/ 596 w 606"/>
              <a:gd name="T25" fmla="*/ 76 h 155"/>
              <a:gd name="T26" fmla="*/ 606 w 606"/>
              <a:gd name="T27" fmla="*/ 16 h 155"/>
              <a:gd name="T28" fmla="*/ 549 w 606"/>
              <a:gd name="T29" fmla="*/ 0 h 155"/>
              <a:gd name="T30" fmla="*/ 559 w 606"/>
              <a:gd name="T31" fmla="*/ 17 h 155"/>
              <a:gd name="T32" fmla="*/ 515 w 606"/>
              <a:gd name="T33" fmla="*/ 43 h 155"/>
              <a:gd name="T34" fmla="*/ 468 w 606"/>
              <a:gd name="T35" fmla="*/ 64 h 155"/>
              <a:gd name="T36" fmla="*/ 419 w 606"/>
              <a:gd name="T37" fmla="*/ 81 h 155"/>
              <a:gd name="T38" fmla="*/ 370 w 606"/>
              <a:gd name="T39" fmla="*/ 94 h 155"/>
              <a:gd name="T40" fmla="*/ 318 w 606"/>
              <a:gd name="T41" fmla="*/ 103 h 155"/>
              <a:gd name="T42" fmla="*/ 267 w 606"/>
              <a:gd name="T43" fmla="*/ 107 h 155"/>
              <a:gd name="T44" fmla="*/ 216 w 606"/>
              <a:gd name="T45" fmla="*/ 105 h 155"/>
              <a:gd name="T46" fmla="*/ 165 w 606"/>
              <a:gd name="T47" fmla="*/ 100 h 155"/>
              <a:gd name="T48" fmla="*/ 114 w 606"/>
              <a:gd name="T49" fmla="*/ 90 h 155"/>
              <a:gd name="T50" fmla="*/ 64 w 606"/>
              <a:gd name="T51" fmla="*/ 76 h 155"/>
              <a:gd name="T52" fmla="*/ 20 w 606"/>
              <a:gd name="T53" fmla="*/ 57 h 155"/>
              <a:gd name="T54" fmla="*/ 0 w 606"/>
              <a:gd name="T55" fmla="*/ 103 h 1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</a:cxnLst>
            <a:rect l="0" t="0" r="r" b="b"/>
            <a:pathLst>
              <a:path w="606" h="155">
                <a:moveTo>
                  <a:pt x="0" y="103"/>
                </a:moveTo>
                <a:lnTo>
                  <a:pt x="51" y="122"/>
                </a:lnTo>
                <a:lnTo>
                  <a:pt x="105" y="138"/>
                </a:lnTo>
                <a:lnTo>
                  <a:pt x="161" y="149"/>
                </a:lnTo>
                <a:lnTo>
                  <a:pt x="216" y="155"/>
                </a:lnTo>
                <a:lnTo>
                  <a:pt x="272" y="155"/>
                </a:lnTo>
                <a:lnTo>
                  <a:pt x="328" y="151"/>
                </a:lnTo>
                <a:lnTo>
                  <a:pt x="382" y="142"/>
                </a:lnTo>
                <a:lnTo>
                  <a:pt x="438" y="128"/>
                </a:lnTo>
                <a:lnTo>
                  <a:pt x="491" y="108"/>
                </a:lnTo>
                <a:lnTo>
                  <a:pt x="540" y="85"/>
                </a:lnTo>
                <a:lnTo>
                  <a:pt x="586" y="60"/>
                </a:lnTo>
                <a:lnTo>
                  <a:pt x="596" y="76"/>
                </a:lnTo>
                <a:lnTo>
                  <a:pt x="606" y="16"/>
                </a:lnTo>
                <a:lnTo>
                  <a:pt x="549" y="0"/>
                </a:lnTo>
                <a:lnTo>
                  <a:pt x="559" y="17"/>
                </a:lnTo>
                <a:lnTo>
                  <a:pt x="515" y="43"/>
                </a:lnTo>
                <a:lnTo>
                  <a:pt x="468" y="64"/>
                </a:lnTo>
                <a:lnTo>
                  <a:pt x="419" y="81"/>
                </a:lnTo>
                <a:lnTo>
                  <a:pt x="370" y="94"/>
                </a:lnTo>
                <a:lnTo>
                  <a:pt x="318" y="103"/>
                </a:lnTo>
                <a:lnTo>
                  <a:pt x="267" y="107"/>
                </a:lnTo>
                <a:lnTo>
                  <a:pt x="216" y="105"/>
                </a:lnTo>
                <a:lnTo>
                  <a:pt x="165" y="100"/>
                </a:lnTo>
                <a:lnTo>
                  <a:pt x="114" y="90"/>
                </a:lnTo>
                <a:lnTo>
                  <a:pt x="64" y="76"/>
                </a:lnTo>
                <a:lnTo>
                  <a:pt x="20" y="57"/>
                </a:lnTo>
                <a:lnTo>
                  <a:pt x="0" y="103"/>
                </a:lnTo>
                <a:close/>
              </a:path>
            </a:pathLst>
          </a:custGeom>
          <a:pattFill prst="openDmnd">
            <a:fgClr>
              <a:srgbClr val="000080"/>
            </a:fgClr>
            <a:bgClr>
              <a:srgbClr val="FFFFFF"/>
            </a:bgClr>
          </a:patt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48" name="Arc 186"/>
          <p:cNvSpPr>
            <a:spLocks/>
          </p:cNvSpPr>
          <p:nvPr/>
        </p:nvSpPr>
        <p:spPr bwMode="auto">
          <a:xfrm>
            <a:off x="2070100" y="4837113"/>
            <a:ext cx="919163" cy="987425"/>
          </a:xfrm>
          <a:custGeom>
            <a:avLst/>
            <a:gdLst>
              <a:gd name="G0" fmla="+- 8536 0 0"/>
              <a:gd name="G1" fmla="+- 0 0 0"/>
              <a:gd name="G2" fmla="+- 21600 0 0"/>
              <a:gd name="T0" fmla="*/ 20097 w 20097"/>
              <a:gd name="T1" fmla="*/ 18246 h 21600"/>
              <a:gd name="T2" fmla="*/ 0 w 20097"/>
              <a:gd name="T3" fmla="*/ 19842 h 21600"/>
              <a:gd name="T4" fmla="*/ 8536 w 20097"/>
              <a:gd name="T5" fmla="*/ 0 h 216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097" h="21600" fill="none" extrusionOk="0">
                <a:moveTo>
                  <a:pt x="20096" y="18245"/>
                </a:moveTo>
                <a:cubicBezTo>
                  <a:pt x="16638" y="20436"/>
                  <a:pt x="12629" y="21599"/>
                  <a:pt x="8536" y="21600"/>
                </a:cubicBezTo>
                <a:cubicBezTo>
                  <a:pt x="5600" y="21600"/>
                  <a:pt x="2696" y="21001"/>
                  <a:pt x="0" y="19841"/>
                </a:cubicBezTo>
              </a:path>
              <a:path w="20097" h="21600" stroke="0" extrusionOk="0">
                <a:moveTo>
                  <a:pt x="20096" y="18245"/>
                </a:moveTo>
                <a:cubicBezTo>
                  <a:pt x="16638" y="20436"/>
                  <a:pt x="12629" y="21599"/>
                  <a:pt x="8536" y="21600"/>
                </a:cubicBezTo>
                <a:cubicBezTo>
                  <a:pt x="5600" y="21600"/>
                  <a:pt x="2696" y="21001"/>
                  <a:pt x="0" y="19841"/>
                </a:cubicBezTo>
                <a:lnTo>
                  <a:pt x="8536" y="0"/>
                </a:lnTo>
                <a:close/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49" name="Arc 187"/>
          <p:cNvSpPr>
            <a:spLocks/>
          </p:cNvSpPr>
          <p:nvPr/>
        </p:nvSpPr>
        <p:spPr bwMode="auto">
          <a:xfrm>
            <a:off x="2101850" y="4837113"/>
            <a:ext cx="844550" cy="908050"/>
          </a:xfrm>
          <a:custGeom>
            <a:avLst/>
            <a:gdLst>
              <a:gd name="G0" fmla="+- 8555 0 0"/>
              <a:gd name="G1" fmla="+- 0 0 0"/>
              <a:gd name="G2" fmla="+- 21600 0 0"/>
              <a:gd name="T0" fmla="*/ 20089 w 20089"/>
              <a:gd name="T1" fmla="*/ 18263 h 21600"/>
              <a:gd name="T2" fmla="*/ 0 w 20089"/>
              <a:gd name="T3" fmla="*/ 19834 h 21600"/>
              <a:gd name="T4" fmla="*/ 8555 w 20089"/>
              <a:gd name="T5" fmla="*/ 0 h 216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089" h="21600" fill="none" extrusionOk="0">
                <a:moveTo>
                  <a:pt x="20088" y="18262"/>
                </a:moveTo>
                <a:cubicBezTo>
                  <a:pt x="16636" y="20442"/>
                  <a:pt x="12637" y="21599"/>
                  <a:pt x="8555" y="21600"/>
                </a:cubicBezTo>
                <a:cubicBezTo>
                  <a:pt x="5612" y="21600"/>
                  <a:pt x="2701" y="20998"/>
                  <a:pt x="0" y="19833"/>
                </a:cubicBezTo>
              </a:path>
              <a:path w="20089" h="21600" stroke="0" extrusionOk="0">
                <a:moveTo>
                  <a:pt x="20088" y="18262"/>
                </a:moveTo>
                <a:cubicBezTo>
                  <a:pt x="16636" y="20442"/>
                  <a:pt x="12637" y="21599"/>
                  <a:pt x="8555" y="21600"/>
                </a:cubicBezTo>
                <a:cubicBezTo>
                  <a:pt x="5612" y="21600"/>
                  <a:pt x="2701" y="20998"/>
                  <a:pt x="0" y="19833"/>
                </a:cubicBezTo>
                <a:lnTo>
                  <a:pt x="8555" y="0"/>
                </a:lnTo>
                <a:close/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50" name="Line 188"/>
          <p:cNvSpPr>
            <a:spLocks noChangeShapeType="1"/>
          </p:cNvSpPr>
          <p:nvPr/>
        </p:nvSpPr>
        <p:spPr bwMode="auto">
          <a:xfrm flipH="1">
            <a:off x="2066925" y="5678488"/>
            <a:ext cx="31750" cy="730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51" name="Freeform 189"/>
          <p:cNvSpPr>
            <a:spLocks/>
          </p:cNvSpPr>
          <p:nvPr/>
        </p:nvSpPr>
        <p:spPr bwMode="auto">
          <a:xfrm>
            <a:off x="2938463" y="5588000"/>
            <a:ext cx="90488" cy="120650"/>
          </a:xfrm>
          <a:custGeom>
            <a:avLst/>
            <a:gdLst>
              <a:gd name="T0" fmla="*/ 7 w 40"/>
              <a:gd name="T1" fmla="*/ 12 h 53"/>
              <a:gd name="T2" fmla="*/ 0 w 40"/>
              <a:gd name="T3" fmla="*/ 0 h 53"/>
              <a:gd name="T4" fmla="*/ 40 w 40"/>
              <a:gd name="T5" fmla="*/ 11 h 53"/>
              <a:gd name="T6" fmla="*/ 33 w 40"/>
              <a:gd name="T7" fmla="*/ 53 h 53"/>
              <a:gd name="T8" fmla="*/ 26 w 40"/>
              <a:gd name="T9" fmla="*/ 42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53">
                <a:moveTo>
                  <a:pt x="7" y="12"/>
                </a:moveTo>
                <a:lnTo>
                  <a:pt x="0" y="0"/>
                </a:lnTo>
                <a:lnTo>
                  <a:pt x="40" y="11"/>
                </a:lnTo>
                <a:lnTo>
                  <a:pt x="33" y="53"/>
                </a:lnTo>
                <a:lnTo>
                  <a:pt x="26" y="42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52" name="Line 190"/>
          <p:cNvSpPr>
            <a:spLocks noChangeShapeType="1"/>
          </p:cNvSpPr>
          <p:nvPr/>
        </p:nvSpPr>
        <p:spPr bwMode="auto">
          <a:xfrm flipH="1" flipV="1">
            <a:off x="2571750" y="5829300"/>
            <a:ext cx="95250" cy="438150"/>
          </a:xfrm>
          <a:prstGeom prst="line">
            <a:avLst/>
          </a:prstGeom>
          <a:noFill/>
          <a:ln w="0">
            <a:solidFill>
              <a:srgbClr val="C0804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53" name="Rectangle 191"/>
          <p:cNvSpPr>
            <a:spLocks noChangeArrowheads="1"/>
          </p:cNvSpPr>
          <p:nvPr/>
        </p:nvSpPr>
        <p:spPr bwMode="auto">
          <a:xfrm>
            <a:off x="2673350" y="6261100"/>
            <a:ext cx="33823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rgbClr val="008000"/>
                </a:solidFill>
                <a:effectLst/>
                <a:latin typeface="Arial" pitchFamily="34" charset="0"/>
                <a:cs typeface="Arial" pitchFamily="34" charset="0"/>
              </a:rPr>
              <a:t>EF1a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254" name="Arc 192"/>
          <p:cNvSpPr>
            <a:spLocks/>
          </p:cNvSpPr>
          <p:nvPr/>
        </p:nvSpPr>
        <p:spPr bwMode="auto">
          <a:xfrm>
            <a:off x="1557338" y="4837113"/>
            <a:ext cx="903288" cy="711200"/>
          </a:xfrm>
          <a:custGeom>
            <a:avLst/>
            <a:gdLst>
              <a:gd name="G0" fmla="+- 17672 0 0"/>
              <a:gd name="G1" fmla="+- 0 0 0"/>
              <a:gd name="G2" fmla="+- 21600 0 0"/>
              <a:gd name="T0" fmla="*/ 1160 w 17672"/>
              <a:gd name="T1" fmla="*/ 13925 h 13925"/>
              <a:gd name="T2" fmla="*/ 0 w 17672"/>
              <a:gd name="T3" fmla="*/ 12420 h 13925"/>
              <a:gd name="T4" fmla="*/ 17672 w 17672"/>
              <a:gd name="T5" fmla="*/ 0 h 139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672" h="13925" fill="none" extrusionOk="0">
                <a:moveTo>
                  <a:pt x="1159" y="13925"/>
                </a:moveTo>
                <a:cubicBezTo>
                  <a:pt x="751" y="13440"/>
                  <a:pt x="364" y="12938"/>
                  <a:pt x="-1" y="12420"/>
                </a:cubicBezTo>
              </a:path>
              <a:path w="17672" h="13925" stroke="0" extrusionOk="0">
                <a:moveTo>
                  <a:pt x="1159" y="13925"/>
                </a:moveTo>
                <a:cubicBezTo>
                  <a:pt x="751" y="13440"/>
                  <a:pt x="364" y="12938"/>
                  <a:pt x="-1" y="12420"/>
                </a:cubicBezTo>
                <a:lnTo>
                  <a:pt x="17672" y="0"/>
                </a:lnTo>
                <a:close/>
              </a:path>
            </a:pathLst>
          </a:custGeom>
          <a:noFill/>
          <a:ln w="9525">
            <a:solidFill>
              <a:srgbClr val="8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59" name="Freeform 197"/>
          <p:cNvSpPr>
            <a:spLocks/>
          </p:cNvSpPr>
          <p:nvPr/>
        </p:nvSpPr>
        <p:spPr bwMode="auto">
          <a:xfrm>
            <a:off x="1874838" y="3829050"/>
            <a:ext cx="523875" cy="279400"/>
          </a:xfrm>
          <a:custGeom>
            <a:avLst/>
            <a:gdLst>
              <a:gd name="T0" fmla="*/ 297 w 330"/>
              <a:gd name="T1" fmla="*/ 88 h 176"/>
              <a:gd name="T2" fmla="*/ 330 w 330"/>
              <a:gd name="T3" fmla="*/ 40 h 176"/>
              <a:gd name="T4" fmla="*/ 284 w 330"/>
              <a:gd name="T5" fmla="*/ 0 h 176"/>
              <a:gd name="T6" fmla="*/ 287 w 330"/>
              <a:gd name="T7" fmla="*/ 20 h 176"/>
              <a:gd name="T8" fmla="*/ 232 w 330"/>
              <a:gd name="T9" fmla="*/ 30 h 176"/>
              <a:gd name="T10" fmla="*/ 178 w 330"/>
              <a:gd name="T11" fmla="*/ 44 h 176"/>
              <a:gd name="T12" fmla="*/ 125 w 330"/>
              <a:gd name="T13" fmla="*/ 64 h 176"/>
              <a:gd name="T14" fmla="*/ 75 w 330"/>
              <a:gd name="T15" fmla="*/ 88 h 176"/>
              <a:gd name="T16" fmla="*/ 27 w 330"/>
              <a:gd name="T17" fmla="*/ 118 h 176"/>
              <a:gd name="T18" fmla="*/ 0 w 330"/>
              <a:gd name="T19" fmla="*/ 138 h 176"/>
              <a:gd name="T20" fmla="*/ 28 w 330"/>
              <a:gd name="T21" fmla="*/ 176 h 176"/>
              <a:gd name="T22" fmla="*/ 71 w 330"/>
              <a:gd name="T23" fmla="*/ 148 h 176"/>
              <a:gd name="T24" fmla="*/ 117 w 330"/>
              <a:gd name="T25" fmla="*/ 122 h 176"/>
              <a:gd name="T26" fmla="*/ 164 w 330"/>
              <a:gd name="T27" fmla="*/ 102 h 176"/>
              <a:gd name="T28" fmla="*/ 213 w 330"/>
              <a:gd name="T29" fmla="*/ 85 h 176"/>
              <a:gd name="T30" fmla="*/ 263 w 330"/>
              <a:gd name="T31" fmla="*/ 74 h 176"/>
              <a:gd name="T32" fmla="*/ 294 w 330"/>
              <a:gd name="T33" fmla="*/ 68 h 176"/>
              <a:gd name="T34" fmla="*/ 297 w 330"/>
              <a:gd name="T35" fmla="*/ 88 h 1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30" h="176">
                <a:moveTo>
                  <a:pt x="297" y="88"/>
                </a:moveTo>
                <a:lnTo>
                  <a:pt x="330" y="40"/>
                </a:lnTo>
                <a:lnTo>
                  <a:pt x="284" y="0"/>
                </a:lnTo>
                <a:lnTo>
                  <a:pt x="287" y="20"/>
                </a:lnTo>
                <a:lnTo>
                  <a:pt x="232" y="30"/>
                </a:lnTo>
                <a:lnTo>
                  <a:pt x="178" y="44"/>
                </a:lnTo>
                <a:lnTo>
                  <a:pt x="125" y="64"/>
                </a:lnTo>
                <a:lnTo>
                  <a:pt x="75" y="88"/>
                </a:lnTo>
                <a:lnTo>
                  <a:pt x="27" y="118"/>
                </a:lnTo>
                <a:lnTo>
                  <a:pt x="0" y="138"/>
                </a:lnTo>
                <a:lnTo>
                  <a:pt x="28" y="176"/>
                </a:lnTo>
                <a:lnTo>
                  <a:pt x="71" y="148"/>
                </a:lnTo>
                <a:lnTo>
                  <a:pt x="117" y="122"/>
                </a:lnTo>
                <a:lnTo>
                  <a:pt x="164" y="102"/>
                </a:lnTo>
                <a:lnTo>
                  <a:pt x="213" y="85"/>
                </a:lnTo>
                <a:lnTo>
                  <a:pt x="263" y="74"/>
                </a:lnTo>
                <a:lnTo>
                  <a:pt x="294" y="68"/>
                </a:lnTo>
                <a:lnTo>
                  <a:pt x="297" y="88"/>
                </a:lnTo>
                <a:close/>
              </a:path>
            </a:pathLst>
          </a:custGeom>
          <a:solidFill>
            <a:srgbClr val="3399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60" name="Arc 198"/>
          <p:cNvSpPr>
            <a:spLocks/>
          </p:cNvSpPr>
          <p:nvPr/>
        </p:nvSpPr>
        <p:spPr bwMode="auto">
          <a:xfrm>
            <a:off x="1871663" y="3859213"/>
            <a:ext cx="588963" cy="977900"/>
          </a:xfrm>
          <a:custGeom>
            <a:avLst/>
            <a:gdLst>
              <a:gd name="G0" fmla="+- 12869 0 0"/>
              <a:gd name="G1" fmla="+- 21411 0 0"/>
              <a:gd name="G2" fmla="+- 21600 0 0"/>
              <a:gd name="T0" fmla="*/ 0 w 12869"/>
              <a:gd name="T1" fmla="*/ 4063 h 21411"/>
              <a:gd name="T2" fmla="*/ 10017 w 12869"/>
              <a:gd name="T3" fmla="*/ 0 h 21411"/>
              <a:gd name="T4" fmla="*/ 12869 w 12869"/>
              <a:gd name="T5" fmla="*/ 21411 h 214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869" h="21411" fill="none" extrusionOk="0">
                <a:moveTo>
                  <a:pt x="0" y="4063"/>
                </a:moveTo>
                <a:cubicBezTo>
                  <a:pt x="2940" y="1881"/>
                  <a:pt x="6387" y="483"/>
                  <a:pt x="10017" y="0"/>
                </a:cubicBezTo>
              </a:path>
              <a:path w="12869" h="21411" stroke="0" extrusionOk="0">
                <a:moveTo>
                  <a:pt x="0" y="4063"/>
                </a:moveTo>
                <a:cubicBezTo>
                  <a:pt x="2940" y="1881"/>
                  <a:pt x="6387" y="483"/>
                  <a:pt x="10017" y="0"/>
                </a:cubicBezTo>
                <a:lnTo>
                  <a:pt x="12869" y="21411"/>
                </a:lnTo>
                <a:close/>
              </a:path>
            </a:pathLst>
          </a:custGeom>
          <a:noFill/>
          <a:ln w="14288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61" name="Arc 199"/>
          <p:cNvSpPr>
            <a:spLocks/>
          </p:cNvSpPr>
          <p:nvPr/>
        </p:nvSpPr>
        <p:spPr bwMode="auto">
          <a:xfrm>
            <a:off x="1919288" y="3938588"/>
            <a:ext cx="542925" cy="898525"/>
          </a:xfrm>
          <a:custGeom>
            <a:avLst/>
            <a:gdLst>
              <a:gd name="G0" fmla="+- 12891 0 0"/>
              <a:gd name="G1" fmla="+- 21409 0 0"/>
              <a:gd name="G2" fmla="+- 21600 0 0"/>
              <a:gd name="T0" fmla="*/ 0 w 12891"/>
              <a:gd name="T1" fmla="*/ 4078 h 21409"/>
              <a:gd name="T2" fmla="*/ 10026 w 12891"/>
              <a:gd name="T3" fmla="*/ 0 h 21409"/>
              <a:gd name="T4" fmla="*/ 12891 w 12891"/>
              <a:gd name="T5" fmla="*/ 21409 h 214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891" h="21409" fill="none" extrusionOk="0">
                <a:moveTo>
                  <a:pt x="-1" y="4077"/>
                </a:moveTo>
                <a:cubicBezTo>
                  <a:pt x="2941" y="1889"/>
                  <a:pt x="6391" y="486"/>
                  <a:pt x="10025" y="-1"/>
                </a:cubicBezTo>
              </a:path>
              <a:path w="12891" h="21409" stroke="0" extrusionOk="0">
                <a:moveTo>
                  <a:pt x="-1" y="4077"/>
                </a:moveTo>
                <a:cubicBezTo>
                  <a:pt x="2941" y="1889"/>
                  <a:pt x="6391" y="486"/>
                  <a:pt x="10025" y="-1"/>
                </a:cubicBezTo>
                <a:lnTo>
                  <a:pt x="12891" y="21409"/>
                </a:lnTo>
                <a:close/>
              </a:path>
            </a:pathLst>
          </a:custGeom>
          <a:noFill/>
          <a:ln w="14288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62" name="Line 200"/>
          <p:cNvSpPr>
            <a:spLocks noChangeShapeType="1"/>
          </p:cNvSpPr>
          <p:nvPr/>
        </p:nvSpPr>
        <p:spPr bwMode="auto">
          <a:xfrm flipH="1" flipV="1">
            <a:off x="1874838" y="4048125"/>
            <a:ext cx="44450" cy="60325"/>
          </a:xfrm>
          <a:prstGeom prst="line">
            <a:avLst/>
          </a:prstGeom>
          <a:noFill/>
          <a:ln w="14288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63" name="Freeform 201"/>
          <p:cNvSpPr>
            <a:spLocks/>
          </p:cNvSpPr>
          <p:nvPr/>
        </p:nvSpPr>
        <p:spPr bwMode="auto">
          <a:xfrm>
            <a:off x="2325688" y="3829050"/>
            <a:ext cx="73025" cy="139700"/>
          </a:xfrm>
          <a:custGeom>
            <a:avLst/>
            <a:gdLst>
              <a:gd name="T0" fmla="*/ 7 w 32"/>
              <a:gd name="T1" fmla="*/ 48 h 62"/>
              <a:gd name="T2" fmla="*/ 9 w 32"/>
              <a:gd name="T3" fmla="*/ 62 h 62"/>
              <a:gd name="T4" fmla="*/ 32 w 32"/>
              <a:gd name="T5" fmla="*/ 28 h 62"/>
              <a:gd name="T6" fmla="*/ 0 w 32"/>
              <a:gd name="T7" fmla="*/ 0 h 62"/>
              <a:gd name="T8" fmla="*/ 2 w 32"/>
              <a:gd name="T9" fmla="*/ 14 h 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2" h="62">
                <a:moveTo>
                  <a:pt x="7" y="48"/>
                </a:moveTo>
                <a:lnTo>
                  <a:pt x="9" y="62"/>
                </a:lnTo>
                <a:lnTo>
                  <a:pt x="32" y="28"/>
                </a:lnTo>
                <a:lnTo>
                  <a:pt x="0" y="0"/>
                </a:lnTo>
                <a:lnTo>
                  <a:pt x="2" y="14"/>
                </a:lnTo>
              </a:path>
            </a:pathLst>
          </a:custGeom>
          <a:noFill/>
          <a:ln w="14288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64" name="Line 202"/>
          <p:cNvSpPr>
            <a:spLocks noChangeShapeType="1"/>
          </p:cNvSpPr>
          <p:nvPr/>
        </p:nvSpPr>
        <p:spPr bwMode="auto">
          <a:xfrm>
            <a:off x="1885950" y="3749675"/>
            <a:ext cx="234950" cy="163513"/>
          </a:xfrm>
          <a:prstGeom prst="line">
            <a:avLst/>
          </a:prstGeom>
          <a:noFill/>
          <a:ln w="0">
            <a:solidFill>
              <a:srgbClr val="C0804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65" name="Rectangle 203"/>
          <p:cNvSpPr>
            <a:spLocks noChangeArrowheads="1"/>
          </p:cNvSpPr>
          <p:nvPr/>
        </p:nvSpPr>
        <p:spPr bwMode="auto">
          <a:xfrm>
            <a:off x="1678707" y="3563040"/>
            <a:ext cx="17953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 err="1" smtClean="0">
                <a:ln>
                  <a:noFill/>
                </a:ln>
                <a:solidFill>
                  <a:srgbClr val="008000"/>
                </a:solidFill>
                <a:effectLst/>
                <a:latin typeface="Arial" pitchFamily="34" charset="0"/>
                <a:cs typeface="Arial" pitchFamily="34" charset="0"/>
              </a:rPr>
              <a:t>ori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266" name="Freeform 204"/>
          <p:cNvSpPr>
            <a:spLocks/>
          </p:cNvSpPr>
          <p:nvPr/>
        </p:nvSpPr>
        <p:spPr bwMode="auto">
          <a:xfrm>
            <a:off x="1665288" y="5099050"/>
            <a:ext cx="130175" cy="103188"/>
          </a:xfrm>
          <a:custGeom>
            <a:avLst/>
            <a:gdLst>
              <a:gd name="T0" fmla="*/ 82 w 82"/>
              <a:gd name="T1" fmla="*/ 11 h 65"/>
              <a:gd name="T2" fmla="*/ 30 w 82"/>
              <a:gd name="T3" fmla="*/ 0 h 65"/>
              <a:gd name="T4" fmla="*/ 0 w 82"/>
              <a:gd name="T5" fmla="*/ 44 h 65"/>
              <a:gd name="T6" fmla="*/ 17 w 82"/>
              <a:gd name="T7" fmla="*/ 37 h 65"/>
              <a:gd name="T8" fmla="*/ 30 w 82"/>
              <a:gd name="T9" fmla="*/ 65 h 65"/>
              <a:gd name="T10" fmla="*/ 75 w 82"/>
              <a:gd name="T11" fmla="*/ 44 h 65"/>
              <a:gd name="T12" fmla="*/ 64 w 82"/>
              <a:gd name="T13" fmla="*/ 18 h 65"/>
              <a:gd name="T14" fmla="*/ 82 w 82"/>
              <a:gd name="T15" fmla="*/ 11 h 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82" h="65">
                <a:moveTo>
                  <a:pt x="82" y="11"/>
                </a:moveTo>
                <a:lnTo>
                  <a:pt x="30" y="0"/>
                </a:lnTo>
                <a:lnTo>
                  <a:pt x="0" y="44"/>
                </a:lnTo>
                <a:lnTo>
                  <a:pt x="17" y="37"/>
                </a:lnTo>
                <a:lnTo>
                  <a:pt x="30" y="65"/>
                </a:lnTo>
                <a:lnTo>
                  <a:pt x="75" y="44"/>
                </a:lnTo>
                <a:lnTo>
                  <a:pt x="64" y="18"/>
                </a:lnTo>
                <a:lnTo>
                  <a:pt x="82" y="11"/>
                </a:lnTo>
                <a:close/>
              </a:path>
            </a:pathLst>
          </a:custGeom>
          <a:solidFill>
            <a:srgbClr val="3399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67" name="Arc 205"/>
          <p:cNvSpPr>
            <a:spLocks/>
          </p:cNvSpPr>
          <p:nvPr/>
        </p:nvSpPr>
        <p:spPr bwMode="auto">
          <a:xfrm>
            <a:off x="1695450" y="4837113"/>
            <a:ext cx="766763" cy="363538"/>
          </a:xfrm>
          <a:custGeom>
            <a:avLst/>
            <a:gdLst>
              <a:gd name="G0" fmla="+- 19937 0 0"/>
              <a:gd name="G1" fmla="+- 0 0 0"/>
              <a:gd name="G2" fmla="+- 21600 0 0"/>
              <a:gd name="T0" fmla="*/ 523 w 19937"/>
              <a:gd name="T1" fmla="*/ 9469 h 9469"/>
              <a:gd name="T2" fmla="*/ 0 w 19937"/>
              <a:gd name="T3" fmla="*/ 8312 h 9469"/>
              <a:gd name="T4" fmla="*/ 19937 w 19937"/>
              <a:gd name="T5" fmla="*/ 0 h 94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937" h="9469" fill="none" extrusionOk="0">
                <a:moveTo>
                  <a:pt x="523" y="9468"/>
                </a:moveTo>
                <a:cubicBezTo>
                  <a:pt x="337" y="9088"/>
                  <a:pt x="163" y="8702"/>
                  <a:pt x="0" y="8311"/>
                </a:cubicBezTo>
              </a:path>
              <a:path w="19937" h="9469" stroke="0" extrusionOk="0">
                <a:moveTo>
                  <a:pt x="523" y="9468"/>
                </a:moveTo>
                <a:cubicBezTo>
                  <a:pt x="337" y="9088"/>
                  <a:pt x="163" y="8702"/>
                  <a:pt x="0" y="8311"/>
                </a:cubicBezTo>
                <a:lnTo>
                  <a:pt x="19937" y="0"/>
                </a:lnTo>
                <a:close/>
              </a:path>
            </a:pathLst>
          </a:custGeom>
          <a:noFill/>
          <a:ln w="14288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68" name="Arc 206"/>
          <p:cNvSpPr>
            <a:spLocks/>
          </p:cNvSpPr>
          <p:nvPr/>
        </p:nvSpPr>
        <p:spPr bwMode="auto">
          <a:xfrm>
            <a:off x="1768475" y="4837113"/>
            <a:ext cx="693738" cy="330200"/>
          </a:xfrm>
          <a:custGeom>
            <a:avLst/>
            <a:gdLst>
              <a:gd name="G0" fmla="+- 19927 0 0"/>
              <a:gd name="G1" fmla="+- 0 0 0"/>
              <a:gd name="G2" fmla="+- 21600 0 0"/>
              <a:gd name="T0" fmla="*/ 530 w 19927"/>
              <a:gd name="T1" fmla="*/ 9504 h 9504"/>
              <a:gd name="T2" fmla="*/ 0 w 19927"/>
              <a:gd name="T3" fmla="*/ 8335 h 9504"/>
              <a:gd name="T4" fmla="*/ 19927 w 19927"/>
              <a:gd name="T5" fmla="*/ 0 h 95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927" h="9504" fill="none" extrusionOk="0">
                <a:moveTo>
                  <a:pt x="530" y="9503"/>
                </a:moveTo>
                <a:cubicBezTo>
                  <a:pt x="341" y="9119"/>
                  <a:pt x="165" y="8729"/>
                  <a:pt x="-1" y="8335"/>
                </a:cubicBezTo>
              </a:path>
              <a:path w="19927" h="9504" stroke="0" extrusionOk="0">
                <a:moveTo>
                  <a:pt x="530" y="9503"/>
                </a:moveTo>
                <a:cubicBezTo>
                  <a:pt x="341" y="9119"/>
                  <a:pt x="165" y="8729"/>
                  <a:pt x="-1" y="8335"/>
                </a:cubicBezTo>
                <a:lnTo>
                  <a:pt x="19927" y="0"/>
                </a:lnTo>
                <a:close/>
              </a:path>
            </a:pathLst>
          </a:custGeom>
          <a:noFill/>
          <a:ln w="14288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69" name="Line 207"/>
          <p:cNvSpPr>
            <a:spLocks noChangeShapeType="1"/>
          </p:cNvSpPr>
          <p:nvPr/>
        </p:nvSpPr>
        <p:spPr bwMode="auto">
          <a:xfrm flipH="1">
            <a:off x="1712913" y="5168900"/>
            <a:ext cx="71438" cy="33338"/>
          </a:xfrm>
          <a:prstGeom prst="line">
            <a:avLst/>
          </a:prstGeom>
          <a:noFill/>
          <a:ln w="14288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70" name="Freeform 208"/>
          <p:cNvSpPr>
            <a:spLocks/>
          </p:cNvSpPr>
          <p:nvPr/>
        </p:nvSpPr>
        <p:spPr bwMode="auto">
          <a:xfrm>
            <a:off x="1665288" y="5099050"/>
            <a:ext cx="130175" cy="69850"/>
          </a:xfrm>
          <a:custGeom>
            <a:avLst/>
            <a:gdLst>
              <a:gd name="T0" fmla="*/ 45 w 58"/>
              <a:gd name="T1" fmla="*/ 13 h 31"/>
              <a:gd name="T2" fmla="*/ 58 w 58"/>
              <a:gd name="T3" fmla="*/ 8 h 31"/>
              <a:gd name="T4" fmla="*/ 21 w 58"/>
              <a:gd name="T5" fmla="*/ 0 h 31"/>
              <a:gd name="T6" fmla="*/ 0 w 58"/>
              <a:gd name="T7" fmla="*/ 31 h 31"/>
              <a:gd name="T8" fmla="*/ 12 w 58"/>
              <a:gd name="T9" fmla="*/ 26 h 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8" h="31">
                <a:moveTo>
                  <a:pt x="45" y="13"/>
                </a:moveTo>
                <a:lnTo>
                  <a:pt x="58" y="8"/>
                </a:lnTo>
                <a:lnTo>
                  <a:pt x="21" y="0"/>
                </a:lnTo>
                <a:lnTo>
                  <a:pt x="0" y="31"/>
                </a:lnTo>
                <a:lnTo>
                  <a:pt x="12" y="26"/>
                </a:lnTo>
              </a:path>
            </a:pathLst>
          </a:custGeom>
          <a:noFill/>
          <a:ln w="14288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73" name="Freeform 211"/>
          <p:cNvSpPr>
            <a:spLocks/>
          </p:cNvSpPr>
          <p:nvPr/>
        </p:nvSpPr>
        <p:spPr bwMode="auto">
          <a:xfrm>
            <a:off x="1762125" y="5481638"/>
            <a:ext cx="330200" cy="266700"/>
          </a:xfrm>
          <a:custGeom>
            <a:avLst/>
            <a:gdLst>
              <a:gd name="T0" fmla="*/ 61 w 208"/>
              <a:gd name="T1" fmla="*/ 0 h 168"/>
              <a:gd name="T2" fmla="*/ 3 w 208"/>
              <a:gd name="T3" fmla="*/ 5 h 168"/>
              <a:gd name="T4" fmla="*/ 0 w 208"/>
              <a:gd name="T5" fmla="*/ 66 h 168"/>
              <a:gd name="T6" fmla="*/ 14 w 208"/>
              <a:gd name="T7" fmla="*/ 52 h 168"/>
              <a:gd name="T8" fmla="*/ 55 w 208"/>
              <a:gd name="T9" fmla="*/ 89 h 168"/>
              <a:gd name="T10" fmla="*/ 101 w 208"/>
              <a:gd name="T11" fmla="*/ 121 h 168"/>
              <a:gd name="T12" fmla="*/ 149 w 208"/>
              <a:gd name="T13" fmla="*/ 150 h 168"/>
              <a:gd name="T14" fmla="*/ 188 w 208"/>
              <a:gd name="T15" fmla="*/ 168 h 168"/>
              <a:gd name="T16" fmla="*/ 208 w 208"/>
              <a:gd name="T17" fmla="*/ 123 h 168"/>
              <a:gd name="T18" fmla="*/ 162 w 208"/>
              <a:gd name="T19" fmla="*/ 100 h 168"/>
              <a:gd name="T20" fmla="*/ 118 w 208"/>
              <a:gd name="T21" fmla="*/ 73 h 168"/>
              <a:gd name="T22" fmla="*/ 77 w 208"/>
              <a:gd name="T23" fmla="*/ 42 h 168"/>
              <a:gd name="T24" fmla="*/ 48 w 208"/>
              <a:gd name="T25" fmla="*/ 15 h 168"/>
              <a:gd name="T26" fmla="*/ 61 w 208"/>
              <a:gd name="T27" fmla="*/ 0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208" h="168">
                <a:moveTo>
                  <a:pt x="61" y="0"/>
                </a:moveTo>
                <a:lnTo>
                  <a:pt x="3" y="5"/>
                </a:lnTo>
                <a:lnTo>
                  <a:pt x="0" y="66"/>
                </a:lnTo>
                <a:lnTo>
                  <a:pt x="14" y="52"/>
                </a:lnTo>
                <a:lnTo>
                  <a:pt x="55" y="89"/>
                </a:lnTo>
                <a:lnTo>
                  <a:pt x="101" y="121"/>
                </a:lnTo>
                <a:lnTo>
                  <a:pt x="149" y="150"/>
                </a:lnTo>
                <a:lnTo>
                  <a:pt x="188" y="168"/>
                </a:lnTo>
                <a:lnTo>
                  <a:pt x="208" y="123"/>
                </a:lnTo>
                <a:lnTo>
                  <a:pt x="162" y="100"/>
                </a:lnTo>
                <a:lnTo>
                  <a:pt x="118" y="73"/>
                </a:lnTo>
                <a:lnTo>
                  <a:pt x="77" y="42"/>
                </a:lnTo>
                <a:lnTo>
                  <a:pt x="48" y="15"/>
                </a:lnTo>
                <a:lnTo>
                  <a:pt x="61" y="0"/>
                </a:lnTo>
                <a:close/>
              </a:path>
            </a:pathLst>
          </a:custGeom>
          <a:solidFill>
            <a:srgbClr val="3399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74" name="Arc 212"/>
          <p:cNvSpPr>
            <a:spLocks/>
          </p:cNvSpPr>
          <p:nvPr/>
        </p:nvSpPr>
        <p:spPr bwMode="auto">
          <a:xfrm>
            <a:off x="1789113" y="4837113"/>
            <a:ext cx="671513" cy="903288"/>
          </a:xfrm>
          <a:custGeom>
            <a:avLst/>
            <a:gdLst>
              <a:gd name="G0" fmla="+- 14705 0 0"/>
              <a:gd name="G1" fmla="+- 0 0 0"/>
              <a:gd name="G2" fmla="+- 21600 0 0"/>
              <a:gd name="T0" fmla="*/ 6028 w 14705"/>
              <a:gd name="T1" fmla="*/ 19780 h 19780"/>
              <a:gd name="T2" fmla="*/ 0 w 14705"/>
              <a:gd name="T3" fmla="*/ 15822 h 19780"/>
              <a:gd name="T4" fmla="*/ 14705 w 14705"/>
              <a:gd name="T5" fmla="*/ 0 h 197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705" h="19780" fill="none" extrusionOk="0">
                <a:moveTo>
                  <a:pt x="6027" y="19780"/>
                </a:moveTo>
                <a:cubicBezTo>
                  <a:pt x="3810" y="18807"/>
                  <a:pt x="1773" y="17469"/>
                  <a:pt x="0" y="15821"/>
                </a:cubicBezTo>
              </a:path>
              <a:path w="14705" h="19780" stroke="0" extrusionOk="0">
                <a:moveTo>
                  <a:pt x="6027" y="19780"/>
                </a:moveTo>
                <a:cubicBezTo>
                  <a:pt x="3810" y="18807"/>
                  <a:pt x="1773" y="17469"/>
                  <a:pt x="0" y="15821"/>
                </a:cubicBezTo>
                <a:lnTo>
                  <a:pt x="14705" y="0"/>
                </a:lnTo>
                <a:close/>
              </a:path>
            </a:pathLst>
          </a:custGeom>
          <a:noFill/>
          <a:ln w="14288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75" name="Arc 213"/>
          <p:cNvSpPr>
            <a:spLocks/>
          </p:cNvSpPr>
          <p:nvPr/>
        </p:nvSpPr>
        <p:spPr bwMode="auto">
          <a:xfrm>
            <a:off x="1843088" y="4837113"/>
            <a:ext cx="619125" cy="830263"/>
          </a:xfrm>
          <a:custGeom>
            <a:avLst/>
            <a:gdLst>
              <a:gd name="G0" fmla="+- 14726 0 0"/>
              <a:gd name="G1" fmla="+- 0 0 0"/>
              <a:gd name="G2" fmla="+- 21600 0 0"/>
              <a:gd name="T0" fmla="*/ 6032 w 14726"/>
              <a:gd name="T1" fmla="*/ 19773 h 19773"/>
              <a:gd name="T2" fmla="*/ 0 w 14726"/>
              <a:gd name="T3" fmla="*/ 15802 h 19773"/>
              <a:gd name="T4" fmla="*/ 14726 w 14726"/>
              <a:gd name="T5" fmla="*/ 0 h 197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726" h="19773" fill="none" extrusionOk="0">
                <a:moveTo>
                  <a:pt x="6031" y="19773"/>
                </a:moveTo>
                <a:cubicBezTo>
                  <a:pt x="3812" y="18797"/>
                  <a:pt x="1773" y="17454"/>
                  <a:pt x="-1" y="15802"/>
                </a:cubicBezTo>
              </a:path>
              <a:path w="14726" h="19773" stroke="0" extrusionOk="0">
                <a:moveTo>
                  <a:pt x="6031" y="19773"/>
                </a:moveTo>
                <a:cubicBezTo>
                  <a:pt x="3812" y="18797"/>
                  <a:pt x="1773" y="17454"/>
                  <a:pt x="-1" y="15802"/>
                </a:cubicBezTo>
                <a:lnTo>
                  <a:pt x="14726" y="0"/>
                </a:lnTo>
                <a:close/>
              </a:path>
            </a:pathLst>
          </a:custGeom>
          <a:noFill/>
          <a:ln w="14288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76" name="Line 214"/>
          <p:cNvSpPr>
            <a:spLocks noChangeShapeType="1"/>
          </p:cNvSpPr>
          <p:nvPr/>
        </p:nvSpPr>
        <p:spPr bwMode="auto">
          <a:xfrm flipH="1">
            <a:off x="2060575" y="5676900"/>
            <a:ext cx="31750" cy="71438"/>
          </a:xfrm>
          <a:prstGeom prst="line">
            <a:avLst/>
          </a:prstGeom>
          <a:noFill/>
          <a:ln w="14288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77" name="Freeform 215"/>
          <p:cNvSpPr>
            <a:spLocks/>
          </p:cNvSpPr>
          <p:nvPr/>
        </p:nvSpPr>
        <p:spPr bwMode="auto">
          <a:xfrm>
            <a:off x="1762125" y="5481638"/>
            <a:ext cx="96838" cy="104775"/>
          </a:xfrm>
          <a:custGeom>
            <a:avLst/>
            <a:gdLst>
              <a:gd name="T0" fmla="*/ 34 w 43"/>
              <a:gd name="T1" fmla="*/ 10 h 46"/>
              <a:gd name="T2" fmla="*/ 43 w 43"/>
              <a:gd name="T3" fmla="*/ 0 h 46"/>
              <a:gd name="T4" fmla="*/ 2 w 43"/>
              <a:gd name="T5" fmla="*/ 3 h 46"/>
              <a:gd name="T6" fmla="*/ 0 w 43"/>
              <a:gd name="T7" fmla="*/ 46 h 46"/>
              <a:gd name="T8" fmla="*/ 10 w 43"/>
              <a:gd name="T9" fmla="*/ 36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3" h="46">
                <a:moveTo>
                  <a:pt x="34" y="10"/>
                </a:moveTo>
                <a:lnTo>
                  <a:pt x="43" y="0"/>
                </a:lnTo>
                <a:lnTo>
                  <a:pt x="2" y="3"/>
                </a:lnTo>
                <a:lnTo>
                  <a:pt x="0" y="46"/>
                </a:lnTo>
                <a:lnTo>
                  <a:pt x="10" y="36"/>
                </a:lnTo>
              </a:path>
            </a:pathLst>
          </a:custGeom>
          <a:noFill/>
          <a:ln w="14288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78" name="Line 216"/>
          <p:cNvSpPr>
            <a:spLocks noChangeShapeType="1"/>
          </p:cNvSpPr>
          <p:nvPr/>
        </p:nvSpPr>
        <p:spPr bwMode="auto">
          <a:xfrm flipV="1">
            <a:off x="1619250" y="5649913"/>
            <a:ext cx="269875" cy="119063"/>
          </a:xfrm>
          <a:prstGeom prst="line">
            <a:avLst/>
          </a:prstGeom>
          <a:noFill/>
          <a:ln w="0">
            <a:solidFill>
              <a:srgbClr val="C0804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79" name="Rectangle 217"/>
          <p:cNvSpPr>
            <a:spLocks noChangeArrowheads="1"/>
          </p:cNvSpPr>
          <p:nvPr/>
        </p:nvSpPr>
        <p:spPr bwMode="auto">
          <a:xfrm>
            <a:off x="1328738" y="5762625"/>
            <a:ext cx="3333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smtClean="0">
                <a:ln>
                  <a:noFill/>
                </a:ln>
                <a:solidFill>
                  <a:srgbClr val="008000"/>
                </a:solidFill>
                <a:effectLst/>
                <a:latin typeface="Arial" pitchFamily="34" charset="0"/>
                <a:cs typeface="Arial" pitchFamily="34" charset="0"/>
              </a:rPr>
              <a:t>f1 ori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281" name="TextBox 4280"/>
          <p:cNvSpPr txBox="1"/>
          <p:nvPr/>
        </p:nvSpPr>
        <p:spPr>
          <a:xfrm>
            <a:off x="619218" y="342900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4282" name="TextBox 4281"/>
          <p:cNvSpPr txBox="1"/>
          <p:nvPr/>
        </p:nvSpPr>
        <p:spPr>
          <a:xfrm>
            <a:off x="5117328" y="342900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289" name="Freeform 110" descr="Wide downward diagonal"/>
          <p:cNvSpPr>
            <a:spLocks/>
          </p:cNvSpPr>
          <p:nvPr/>
        </p:nvSpPr>
        <p:spPr bwMode="auto">
          <a:xfrm>
            <a:off x="5740482" y="1323489"/>
            <a:ext cx="622538" cy="309923"/>
          </a:xfrm>
          <a:custGeom>
            <a:avLst/>
            <a:gdLst>
              <a:gd name="T0" fmla="*/ 493951260 w 245"/>
              <a:gd name="T1" fmla="*/ 269655131 h 107"/>
              <a:gd name="T2" fmla="*/ 617439869 w 245"/>
              <a:gd name="T3" fmla="*/ 133567094 h 107"/>
              <a:gd name="T4" fmla="*/ 493951260 w 245"/>
              <a:gd name="T5" fmla="*/ 0 h 107"/>
              <a:gd name="T6" fmla="*/ 493951260 w 245"/>
              <a:gd name="T7" fmla="*/ 60483572 h 107"/>
              <a:gd name="T8" fmla="*/ 0 w 245"/>
              <a:gd name="T9" fmla="*/ 60483572 h 107"/>
              <a:gd name="T10" fmla="*/ 0 w 245"/>
              <a:gd name="T11" fmla="*/ 209171559 h 107"/>
              <a:gd name="T12" fmla="*/ 493951260 w 245"/>
              <a:gd name="T13" fmla="*/ 209171559 h 107"/>
              <a:gd name="T14" fmla="*/ 493951260 w 245"/>
              <a:gd name="T15" fmla="*/ 269655131 h 107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w 245"/>
              <a:gd name="T25" fmla="*/ 0 h 107"/>
              <a:gd name="T26" fmla="*/ 245 w 245"/>
              <a:gd name="T27" fmla="*/ 107 h 107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45" h="107">
                <a:moveTo>
                  <a:pt x="196" y="107"/>
                </a:moveTo>
                <a:lnTo>
                  <a:pt x="245" y="53"/>
                </a:lnTo>
                <a:lnTo>
                  <a:pt x="196" y="0"/>
                </a:lnTo>
                <a:lnTo>
                  <a:pt x="196" y="24"/>
                </a:lnTo>
                <a:lnTo>
                  <a:pt x="0" y="24"/>
                </a:lnTo>
                <a:lnTo>
                  <a:pt x="0" y="83"/>
                </a:lnTo>
                <a:lnTo>
                  <a:pt x="196" y="83"/>
                </a:lnTo>
                <a:lnTo>
                  <a:pt x="196" y="107"/>
                </a:lnTo>
                <a:close/>
              </a:path>
            </a:pathLst>
          </a:custGeom>
          <a:pattFill prst="pct10">
            <a:fgClr>
              <a:schemeClr val="tx1"/>
            </a:fgClr>
            <a:bgClr>
              <a:srgbClr val="FFFFFF"/>
            </a:bgClr>
          </a:pattFill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 sz="3200"/>
          </a:p>
        </p:txBody>
      </p:sp>
      <p:sp>
        <p:nvSpPr>
          <p:cNvPr id="4289" name="TextBox 4288"/>
          <p:cNvSpPr txBox="1"/>
          <p:nvPr/>
        </p:nvSpPr>
        <p:spPr>
          <a:xfrm>
            <a:off x="5638282" y="464048"/>
            <a:ext cx="8226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WPRE</a:t>
            </a:r>
            <a:endParaRPr lang="en-US" sz="2000" b="1" dirty="0"/>
          </a:p>
        </p:txBody>
      </p:sp>
      <p:cxnSp>
        <p:nvCxnSpPr>
          <p:cNvPr id="4291" name="Straight Connector 4290"/>
          <p:cNvCxnSpPr>
            <a:stCxn id="4289" idx="2"/>
          </p:cNvCxnSpPr>
          <p:nvPr/>
        </p:nvCxnSpPr>
        <p:spPr>
          <a:xfrm flipH="1">
            <a:off x="6040438" y="864158"/>
            <a:ext cx="9175" cy="55504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Group 2"/>
          <p:cNvGrpSpPr/>
          <p:nvPr/>
        </p:nvGrpSpPr>
        <p:grpSpPr>
          <a:xfrm>
            <a:off x="1474788" y="2029496"/>
            <a:ext cx="5662396" cy="1119919"/>
            <a:chOff x="1474788" y="2029496"/>
            <a:chExt cx="5662396" cy="1119919"/>
          </a:xfrm>
        </p:grpSpPr>
        <p:sp>
          <p:nvSpPr>
            <p:cNvPr id="35" name="Rectangle 106"/>
            <p:cNvSpPr>
              <a:spLocks noChangeArrowheads="1"/>
            </p:cNvSpPr>
            <p:nvPr/>
          </p:nvSpPr>
          <p:spPr bwMode="auto">
            <a:xfrm>
              <a:off x="1512903" y="2966937"/>
              <a:ext cx="10164" cy="43446"/>
            </a:xfrm>
            <a:prstGeom prst="rect">
              <a:avLst/>
            </a:prstGeom>
            <a:solidFill>
              <a:srgbClr val="FFFFCC"/>
            </a:solidFill>
            <a:ln w="0">
              <a:solidFill>
                <a:srgbClr val="CCCC99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endParaRPr lang="en-US" altLang="en-US" sz="3200"/>
            </a:p>
          </p:txBody>
        </p:sp>
        <p:sp>
          <p:nvSpPr>
            <p:cNvPr id="36" name="Rectangle 107"/>
            <p:cNvSpPr>
              <a:spLocks noChangeArrowheads="1"/>
            </p:cNvSpPr>
            <p:nvPr/>
          </p:nvSpPr>
          <p:spPr bwMode="auto">
            <a:xfrm>
              <a:off x="1523067" y="2966937"/>
              <a:ext cx="5066693" cy="43446"/>
            </a:xfrm>
            <a:prstGeom prst="rect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endParaRPr lang="en-US" altLang="en-US" sz="3200"/>
            </a:p>
          </p:txBody>
        </p:sp>
        <p:sp>
          <p:nvSpPr>
            <p:cNvPr id="37" name="Line 111"/>
            <p:cNvSpPr>
              <a:spLocks noChangeShapeType="1"/>
            </p:cNvSpPr>
            <p:nvPr/>
          </p:nvSpPr>
          <p:spPr bwMode="auto">
            <a:xfrm flipH="1">
              <a:off x="5410750" y="2570670"/>
              <a:ext cx="40656" cy="3325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38" name="Rectangle 112"/>
            <p:cNvSpPr>
              <a:spLocks noChangeArrowheads="1"/>
            </p:cNvSpPr>
            <p:nvPr/>
          </p:nvSpPr>
          <p:spPr bwMode="auto">
            <a:xfrm>
              <a:off x="5314806" y="2260609"/>
              <a:ext cx="436018" cy="3077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smtClean="0"/>
                <a:t>Neo</a:t>
              </a:r>
              <a:endParaRPr lang="en-US" altLang="en-US" sz="2000" b="1" dirty="0"/>
            </a:p>
          </p:txBody>
        </p:sp>
        <p:sp>
          <p:nvSpPr>
            <p:cNvPr id="39" name="Line 114"/>
            <p:cNvSpPr>
              <a:spLocks noChangeShapeType="1"/>
            </p:cNvSpPr>
            <p:nvPr/>
          </p:nvSpPr>
          <p:spPr bwMode="auto">
            <a:xfrm flipH="1">
              <a:off x="4122478" y="2717839"/>
              <a:ext cx="2542" cy="1853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40" name="Rectangle 115"/>
            <p:cNvSpPr>
              <a:spLocks noChangeArrowheads="1"/>
            </p:cNvSpPr>
            <p:nvPr/>
          </p:nvSpPr>
          <p:spPr bwMode="auto">
            <a:xfrm>
              <a:off x="3906496" y="2358675"/>
              <a:ext cx="640111" cy="3077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err="1" smtClean="0"/>
                <a:t>Exo</a:t>
              </a:r>
              <a:r>
                <a:rPr lang="en-US" altLang="en-US" sz="2000" b="1" dirty="0" smtClean="0"/>
                <a:t> III</a:t>
              </a:r>
              <a:endParaRPr lang="en-US" altLang="en-US" sz="2000" b="1" dirty="0"/>
            </a:p>
          </p:txBody>
        </p:sp>
        <p:sp>
          <p:nvSpPr>
            <p:cNvPr id="41" name="Line 117"/>
            <p:cNvSpPr>
              <a:spLocks noChangeShapeType="1"/>
            </p:cNvSpPr>
            <p:nvPr/>
          </p:nvSpPr>
          <p:spPr bwMode="auto">
            <a:xfrm>
              <a:off x="1782246" y="2691770"/>
              <a:ext cx="94015" cy="2114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42" name="Rectangle 118"/>
            <p:cNvSpPr>
              <a:spLocks noChangeArrowheads="1"/>
            </p:cNvSpPr>
            <p:nvPr/>
          </p:nvSpPr>
          <p:spPr bwMode="auto">
            <a:xfrm>
              <a:off x="1474788" y="2462948"/>
              <a:ext cx="251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</a:rPr>
                <a:t>LTR</a:t>
              </a:r>
              <a:endParaRPr lang="en-US" altLang="en-US" sz="3200"/>
            </a:p>
          </p:txBody>
        </p:sp>
        <p:sp>
          <p:nvSpPr>
            <p:cNvPr id="43" name="Line 120"/>
            <p:cNvSpPr>
              <a:spLocks noChangeShapeType="1"/>
            </p:cNvSpPr>
            <p:nvPr/>
          </p:nvSpPr>
          <p:spPr bwMode="auto">
            <a:xfrm flipH="1">
              <a:off x="6804523" y="2691770"/>
              <a:ext cx="71147" cy="2114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44" name="Rectangle 121"/>
            <p:cNvSpPr>
              <a:spLocks noChangeArrowheads="1"/>
            </p:cNvSpPr>
            <p:nvPr/>
          </p:nvSpPr>
          <p:spPr bwMode="auto">
            <a:xfrm>
              <a:off x="6885834" y="2462948"/>
              <a:ext cx="251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>
                  <a:solidFill>
                    <a:srgbClr val="000000"/>
                  </a:solidFill>
                </a:rPr>
                <a:t>LTR</a:t>
              </a:r>
              <a:endParaRPr lang="en-US" altLang="en-US" sz="3200" dirty="0"/>
            </a:p>
          </p:txBody>
        </p:sp>
        <p:sp>
          <p:nvSpPr>
            <p:cNvPr id="45" name="Line 144"/>
            <p:cNvSpPr>
              <a:spLocks noChangeShapeType="1"/>
            </p:cNvSpPr>
            <p:nvPr/>
          </p:nvSpPr>
          <p:spPr bwMode="auto">
            <a:xfrm>
              <a:off x="2602978" y="2630945"/>
              <a:ext cx="43197" cy="27227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46" name="Rectangle 145"/>
            <p:cNvSpPr>
              <a:spLocks noChangeArrowheads="1"/>
            </p:cNvSpPr>
            <p:nvPr/>
          </p:nvSpPr>
          <p:spPr bwMode="auto">
            <a:xfrm>
              <a:off x="2323541" y="2204786"/>
              <a:ext cx="584423" cy="3077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smtClean="0">
                  <a:solidFill>
                    <a:srgbClr val="000000"/>
                  </a:solidFill>
                </a:rPr>
                <a:t>Gag</a:t>
              </a:r>
              <a:endParaRPr lang="en-US" altLang="en-US" sz="4400" dirty="0"/>
            </a:p>
          </p:txBody>
        </p:sp>
        <p:sp>
          <p:nvSpPr>
            <p:cNvPr id="47" name="Line 150"/>
            <p:cNvSpPr>
              <a:spLocks noChangeShapeType="1"/>
            </p:cNvSpPr>
            <p:nvPr/>
          </p:nvSpPr>
          <p:spPr bwMode="auto">
            <a:xfrm flipH="1">
              <a:off x="4818704" y="2410146"/>
              <a:ext cx="14855" cy="4930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48" name="Rectangle 151"/>
            <p:cNvSpPr>
              <a:spLocks noChangeArrowheads="1"/>
            </p:cNvSpPr>
            <p:nvPr/>
          </p:nvSpPr>
          <p:spPr bwMode="auto">
            <a:xfrm>
              <a:off x="4647739" y="2169600"/>
              <a:ext cx="37163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 smtClean="0">
                  <a:solidFill>
                    <a:srgbClr val="000000"/>
                  </a:solidFill>
                </a:rPr>
                <a:t>SV40</a:t>
              </a:r>
              <a:endParaRPr lang="en-US" altLang="en-US" sz="3200" baseline="-25000" dirty="0"/>
            </a:p>
          </p:txBody>
        </p:sp>
        <p:sp>
          <p:nvSpPr>
            <p:cNvPr id="50" name="Freeform 110" descr="Wide downward diagonal"/>
            <p:cNvSpPr>
              <a:spLocks/>
            </p:cNvSpPr>
            <p:nvPr/>
          </p:nvSpPr>
          <p:spPr bwMode="auto">
            <a:xfrm>
              <a:off x="5098210" y="2833699"/>
              <a:ext cx="622538" cy="309923"/>
            </a:xfrm>
            <a:custGeom>
              <a:avLst/>
              <a:gdLst>
                <a:gd name="T0" fmla="*/ 493951260 w 245"/>
                <a:gd name="T1" fmla="*/ 269655131 h 107"/>
                <a:gd name="T2" fmla="*/ 617439869 w 245"/>
                <a:gd name="T3" fmla="*/ 133567094 h 107"/>
                <a:gd name="T4" fmla="*/ 493951260 w 245"/>
                <a:gd name="T5" fmla="*/ 0 h 107"/>
                <a:gd name="T6" fmla="*/ 493951260 w 245"/>
                <a:gd name="T7" fmla="*/ 60483572 h 107"/>
                <a:gd name="T8" fmla="*/ 0 w 245"/>
                <a:gd name="T9" fmla="*/ 60483572 h 107"/>
                <a:gd name="T10" fmla="*/ 0 w 245"/>
                <a:gd name="T11" fmla="*/ 209171559 h 107"/>
                <a:gd name="T12" fmla="*/ 493951260 w 245"/>
                <a:gd name="T13" fmla="*/ 209171559 h 107"/>
                <a:gd name="T14" fmla="*/ 493951260 w 245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45"/>
                <a:gd name="T25" fmla="*/ 0 h 107"/>
                <a:gd name="T26" fmla="*/ 245 w 245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45" h="107">
                  <a:moveTo>
                    <a:pt x="196" y="107"/>
                  </a:moveTo>
                  <a:lnTo>
                    <a:pt x="245" y="53"/>
                  </a:lnTo>
                  <a:lnTo>
                    <a:pt x="196" y="0"/>
                  </a:lnTo>
                  <a:lnTo>
                    <a:pt x="196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96" y="83"/>
                  </a:lnTo>
                  <a:lnTo>
                    <a:pt x="196" y="107"/>
                  </a:lnTo>
                  <a:close/>
                </a:path>
              </a:pathLst>
            </a:custGeom>
            <a:pattFill prst="wdDnDiag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1" name="Freeform 113" descr="5%"/>
            <p:cNvSpPr>
              <a:spLocks/>
            </p:cNvSpPr>
            <p:nvPr/>
          </p:nvSpPr>
          <p:spPr bwMode="auto">
            <a:xfrm>
              <a:off x="3784530" y="2833699"/>
              <a:ext cx="744503" cy="309923"/>
            </a:xfrm>
            <a:custGeom>
              <a:avLst/>
              <a:gdLst>
                <a:gd name="T0" fmla="*/ 617436824 w 293"/>
                <a:gd name="T1" fmla="*/ 269655131 h 107"/>
                <a:gd name="T2" fmla="*/ 738404194 w 293"/>
                <a:gd name="T3" fmla="*/ 133567094 h 107"/>
                <a:gd name="T4" fmla="*/ 617436824 w 293"/>
                <a:gd name="T5" fmla="*/ 0 h 107"/>
                <a:gd name="T6" fmla="*/ 617436824 w 293"/>
                <a:gd name="T7" fmla="*/ 60483572 h 107"/>
                <a:gd name="T8" fmla="*/ 0 w 293"/>
                <a:gd name="T9" fmla="*/ 60483572 h 107"/>
                <a:gd name="T10" fmla="*/ 0 w 293"/>
                <a:gd name="T11" fmla="*/ 209171559 h 107"/>
                <a:gd name="T12" fmla="*/ 617436824 w 293"/>
                <a:gd name="T13" fmla="*/ 209171559 h 107"/>
                <a:gd name="T14" fmla="*/ 617436824 w 293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93"/>
                <a:gd name="T25" fmla="*/ 0 h 107"/>
                <a:gd name="T26" fmla="*/ 293 w 293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93" h="107">
                  <a:moveTo>
                    <a:pt x="245" y="107"/>
                  </a:moveTo>
                  <a:lnTo>
                    <a:pt x="293" y="53"/>
                  </a:lnTo>
                  <a:lnTo>
                    <a:pt x="245" y="0"/>
                  </a:lnTo>
                  <a:lnTo>
                    <a:pt x="245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45" y="83"/>
                  </a:lnTo>
                  <a:lnTo>
                    <a:pt x="245" y="107"/>
                  </a:lnTo>
                  <a:close/>
                </a:path>
              </a:pathLst>
            </a:custGeom>
            <a:pattFill prst="dkVert">
              <a:fgClr>
                <a:schemeClr val="tx1"/>
              </a:fgClr>
              <a:bgClr>
                <a:schemeClr val="bg1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2" name="Freeform 116" descr="Small grid"/>
            <p:cNvSpPr>
              <a:spLocks/>
            </p:cNvSpPr>
            <p:nvPr/>
          </p:nvSpPr>
          <p:spPr bwMode="auto">
            <a:xfrm>
              <a:off x="1495116" y="2839492"/>
              <a:ext cx="701308" cy="309923"/>
            </a:xfrm>
            <a:custGeom>
              <a:avLst/>
              <a:gdLst>
                <a:gd name="T0" fmla="*/ 574595625 w 276"/>
                <a:gd name="T1" fmla="*/ 269655131 h 107"/>
                <a:gd name="T2" fmla="*/ 695563125 w 276"/>
                <a:gd name="T3" fmla="*/ 133567094 h 107"/>
                <a:gd name="T4" fmla="*/ 574595625 w 276"/>
                <a:gd name="T5" fmla="*/ 0 h 107"/>
                <a:gd name="T6" fmla="*/ 574595625 w 276"/>
                <a:gd name="T7" fmla="*/ 60483572 h 107"/>
                <a:gd name="T8" fmla="*/ 0 w 276"/>
                <a:gd name="T9" fmla="*/ 60483572 h 107"/>
                <a:gd name="T10" fmla="*/ 0 w 276"/>
                <a:gd name="T11" fmla="*/ 209171559 h 107"/>
                <a:gd name="T12" fmla="*/ 574595625 w 276"/>
                <a:gd name="T13" fmla="*/ 209171559 h 107"/>
                <a:gd name="T14" fmla="*/ 574595625 w 276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76"/>
                <a:gd name="T25" fmla="*/ 0 h 107"/>
                <a:gd name="T26" fmla="*/ 276 w 276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76" h="107">
                  <a:moveTo>
                    <a:pt x="228" y="107"/>
                  </a:moveTo>
                  <a:lnTo>
                    <a:pt x="276" y="53"/>
                  </a:lnTo>
                  <a:lnTo>
                    <a:pt x="228" y="0"/>
                  </a:lnTo>
                  <a:lnTo>
                    <a:pt x="228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28" y="83"/>
                  </a:lnTo>
                  <a:lnTo>
                    <a:pt x="228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3" name="Freeform 119" descr="Small grid"/>
            <p:cNvSpPr>
              <a:spLocks/>
            </p:cNvSpPr>
            <p:nvPr/>
          </p:nvSpPr>
          <p:spPr bwMode="auto">
            <a:xfrm>
              <a:off x="6414603" y="2833699"/>
              <a:ext cx="714013" cy="309923"/>
            </a:xfrm>
            <a:custGeom>
              <a:avLst/>
              <a:gdLst>
                <a:gd name="T0" fmla="*/ 589717223 w 281"/>
                <a:gd name="T1" fmla="*/ 269655131 h 107"/>
                <a:gd name="T2" fmla="*/ 708165494 w 281"/>
                <a:gd name="T3" fmla="*/ 133567094 h 107"/>
                <a:gd name="T4" fmla="*/ 589717223 w 281"/>
                <a:gd name="T5" fmla="*/ 0 h 107"/>
                <a:gd name="T6" fmla="*/ 589717223 w 281"/>
                <a:gd name="T7" fmla="*/ 60483572 h 107"/>
                <a:gd name="T8" fmla="*/ 0 w 281"/>
                <a:gd name="T9" fmla="*/ 60483572 h 107"/>
                <a:gd name="T10" fmla="*/ 0 w 281"/>
                <a:gd name="T11" fmla="*/ 209171559 h 107"/>
                <a:gd name="T12" fmla="*/ 589717223 w 281"/>
                <a:gd name="T13" fmla="*/ 209171559 h 107"/>
                <a:gd name="T14" fmla="*/ 589717223 w 281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81"/>
                <a:gd name="T25" fmla="*/ 0 h 107"/>
                <a:gd name="T26" fmla="*/ 281 w 281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81" h="107">
                  <a:moveTo>
                    <a:pt x="234" y="107"/>
                  </a:moveTo>
                  <a:lnTo>
                    <a:pt x="281" y="53"/>
                  </a:lnTo>
                  <a:lnTo>
                    <a:pt x="234" y="0"/>
                  </a:lnTo>
                  <a:lnTo>
                    <a:pt x="234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34" y="83"/>
                  </a:lnTo>
                  <a:lnTo>
                    <a:pt x="234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4" name="Freeform 143" descr="Light vertical"/>
            <p:cNvSpPr>
              <a:spLocks/>
            </p:cNvSpPr>
            <p:nvPr/>
          </p:nvSpPr>
          <p:spPr bwMode="auto">
            <a:xfrm>
              <a:off x="2252325" y="2833699"/>
              <a:ext cx="790242" cy="309923"/>
            </a:xfrm>
            <a:custGeom>
              <a:avLst/>
              <a:gdLst>
                <a:gd name="T0" fmla="*/ 662802559 w 311"/>
                <a:gd name="T1" fmla="*/ 269655131 h 107"/>
                <a:gd name="T2" fmla="*/ 783770181 w 311"/>
                <a:gd name="T3" fmla="*/ 133567094 h 107"/>
                <a:gd name="T4" fmla="*/ 662802559 w 311"/>
                <a:gd name="T5" fmla="*/ 0 h 107"/>
                <a:gd name="T6" fmla="*/ 662802559 w 311"/>
                <a:gd name="T7" fmla="*/ 60483572 h 107"/>
                <a:gd name="T8" fmla="*/ 0 w 311"/>
                <a:gd name="T9" fmla="*/ 60483572 h 107"/>
                <a:gd name="T10" fmla="*/ 0 w 311"/>
                <a:gd name="T11" fmla="*/ 209171559 h 107"/>
                <a:gd name="T12" fmla="*/ 662802559 w 311"/>
                <a:gd name="T13" fmla="*/ 209171559 h 107"/>
                <a:gd name="T14" fmla="*/ 662802559 w 311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311"/>
                <a:gd name="T25" fmla="*/ 0 h 107"/>
                <a:gd name="T26" fmla="*/ 311 w 311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311" h="107">
                  <a:moveTo>
                    <a:pt x="263" y="107"/>
                  </a:moveTo>
                  <a:lnTo>
                    <a:pt x="311" y="53"/>
                  </a:lnTo>
                  <a:lnTo>
                    <a:pt x="263" y="0"/>
                  </a:lnTo>
                  <a:lnTo>
                    <a:pt x="263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63" y="83"/>
                  </a:lnTo>
                  <a:lnTo>
                    <a:pt x="263" y="107"/>
                  </a:lnTo>
                  <a:close/>
                </a:path>
              </a:pathLst>
            </a:custGeom>
            <a:pattFill prst="ltVert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5" name="Freeform 149"/>
            <p:cNvSpPr>
              <a:spLocks/>
            </p:cNvSpPr>
            <p:nvPr/>
          </p:nvSpPr>
          <p:spPr bwMode="auto">
            <a:xfrm>
              <a:off x="4559525" y="2833699"/>
              <a:ext cx="523440" cy="309923"/>
            </a:xfrm>
            <a:custGeom>
              <a:avLst/>
              <a:gdLst>
                <a:gd name="T0" fmla="*/ 395665325 w 206"/>
                <a:gd name="T1" fmla="*/ 269655131 h 107"/>
                <a:gd name="T2" fmla="*/ 519152188 w 206"/>
                <a:gd name="T3" fmla="*/ 133567094 h 107"/>
                <a:gd name="T4" fmla="*/ 395665325 w 206"/>
                <a:gd name="T5" fmla="*/ 0 h 107"/>
                <a:gd name="T6" fmla="*/ 395665325 w 206"/>
                <a:gd name="T7" fmla="*/ 60483572 h 107"/>
                <a:gd name="T8" fmla="*/ 0 w 206"/>
                <a:gd name="T9" fmla="*/ 60483572 h 107"/>
                <a:gd name="T10" fmla="*/ 0 w 206"/>
                <a:gd name="T11" fmla="*/ 209171559 h 107"/>
                <a:gd name="T12" fmla="*/ 395665325 w 206"/>
                <a:gd name="T13" fmla="*/ 209171559 h 107"/>
                <a:gd name="T14" fmla="*/ 395665325 w 206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06"/>
                <a:gd name="T25" fmla="*/ 0 h 107"/>
                <a:gd name="T26" fmla="*/ 206 w 206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06" h="107">
                  <a:moveTo>
                    <a:pt x="157" y="107"/>
                  </a:moveTo>
                  <a:lnTo>
                    <a:pt x="206" y="53"/>
                  </a:lnTo>
                  <a:lnTo>
                    <a:pt x="157" y="0"/>
                  </a:lnTo>
                  <a:lnTo>
                    <a:pt x="157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57" y="83"/>
                  </a:lnTo>
                  <a:lnTo>
                    <a:pt x="157" y="107"/>
                  </a:lnTo>
                  <a:close/>
                </a:path>
              </a:pathLst>
            </a:custGeom>
            <a:solidFill>
              <a:schemeClr val="tx1"/>
            </a:solid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7" name="Right Arrow 56"/>
            <p:cNvSpPr/>
            <p:nvPr/>
          </p:nvSpPr>
          <p:spPr bwMode="auto">
            <a:xfrm>
              <a:off x="3148407" y="2831112"/>
              <a:ext cx="365242" cy="318303"/>
            </a:xfrm>
            <a:prstGeom prst="rightArrow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3200"/>
            </a:p>
          </p:txBody>
        </p:sp>
        <p:sp>
          <p:nvSpPr>
            <p:cNvPr id="58" name="Rectangle 57"/>
            <p:cNvSpPr/>
            <p:nvPr/>
          </p:nvSpPr>
          <p:spPr bwMode="auto">
            <a:xfrm>
              <a:off x="3523850" y="2926824"/>
              <a:ext cx="232729" cy="13889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3200"/>
            </a:p>
          </p:txBody>
        </p:sp>
        <p:cxnSp>
          <p:nvCxnSpPr>
            <p:cNvPr id="59" name="Straight Connector 58"/>
            <p:cNvCxnSpPr/>
            <p:nvPr/>
          </p:nvCxnSpPr>
          <p:spPr bwMode="auto">
            <a:xfrm flipH="1" flipV="1">
              <a:off x="3295651" y="2664518"/>
              <a:ext cx="8202" cy="24379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Rectangle 145"/>
            <p:cNvSpPr>
              <a:spLocks noChangeArrowheads="1"/>
            </p:cNvSpPr>
            <p:nvPr/>
          </p:nvSpPr>
          <p:spPr bwMode="auto">
            <a:xfrm>
              <a:off x="3099678" y="2442884"/>
              <a:ext cx="32932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>
                  <a:solidFill>
                    <a:srgbClr val="000000"/>
                  </a:solidFill>
                </a:rPr>
                <a:t>MTS</a:t>
              </a:r>
              <a:endParaRPr lang="en-US" altLang="en-US" sz="3200" dirty="0"/>
            </a:p>
          </p:txBody>
        </p:sp>
        <p:cxnSp>
          <p:nvCxnSpPr>
            <p:cNvPr id="61" name="Straight Connector 60"/>
            <p:cNvCxnSpPr/>
            <p:nvPr/>
          </p:nvCxnSpPr>
          <p:spPr bwMode="auto">
            <a:xfrm flipV="1">
              <a:off x="3648174" y="2410146"/>
              <a:ext cx="10164" cy="50874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Rectangle 145"/>
            <p:cNvSpPr>
              <a:spLocks noChangeArrowheads="1"/>
            </p:cNvSpPr>
            <p:nvPr/>
          </p:nvSpPr>
          <p:spPr bwMode="auto">
            <a:xfrm>
              <a:off x="3499940" y="2146466"/>
              <a:ext cx="30059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 err="1">
                  <a:solidFill>
                    <a:srgbClr val="000000"/>
                  </a:solidFill>
                </a:rPr>
                <a:t>myc</a:t>
              </a:r>
              <a:endParaRPr lang="en-US" altLang="en-US" sz="3200" dirty="0"/>
            </a:p>
          </p:txBody>
        </p:sp>
        <p:sp>
          <p:nvSpPr>
            <p:cNvPr id="290" name="Freeform 110" descr="Wide downward diagonal"/>
            <p:cNvSpPr>
              <a:spLocks/>
            </p:cNvSpPr>
            <p:nvPr/>
          </p:nvSpPr>
          <p:spPr bwMode="auto">
            <a:xfrm>
              <a:off x="5757730" y="2831112"/>
              <a:ext cx="622538" cy="309923"/>
            </a:xfrm>
            <a:custGeom>
              <a:avLst/>
              <a:gdLst>
                <a:gd name="T0" fmla="*/ 493951260 w 245"/>
                <a:gd name="T1" fmla="*/ 269655131 h 107"/>
                <a:gd name="T2" fmla="*/ 617439869 w 245"/>
                <a:gd name="T3" fmla="*/ 133567094 h 107"/>
                <a:gd name="T4" fmla="*/ 493951260 w 245"/>
                <a:gd name="T5" fmla="*/ 0 h 107"/>
                <a:gd name="T6" fmla="*/ 493951260 w 245"/>
                <a:gd name="T7" fmla="*/ 60483572 h 107"/>
                <a:gd name="T8" fmla="*/ 0 w 245"/>
                <a:gd name="T9" fmla="*/ 60483572 h 107"/>
                <a:gd name="T10" fmla="*/ 0 w 245"/>
                <a:gd name="T11" fmla="*/ 209171559 h 107"/>
                <a:gd name="T12" fmla="*/ 493951260 w 245"/>
                <a:gd name="T13" fmla="*/ 209171559 h 107"/>
                <a:gd name="T14" fmla="*/ 493951260 w 245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45"/>
                <a:gd name="T25" fmla="*/ 0 h 107"/>
                <a:gd name="T26" fmla="*/ 245 w 245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45" h="107">
                  <a:moveTo>
                    <a:pt x="196" y="107"/>
                  </a:moveTo>
                  <a:lnTo>
                    <a:pt x="245" y="53"/>
                  </a:lnTo>
                  <a:lnTo>
                    <a:pt x="196" y="0"/>
                  </a:lnTo>
                  <a:lnTo>
                    <a:pt x="196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96" y="83"/>
                  </a:lnTo>
                  <a:lnTo>
                    <a:pt x="196" y="107"/>
                  </a:lnTo>
                  <a:close/>
                </a:path>
              </a:pathLst>
            </a:custGeom>
            <a:pattFill prst="pct10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295" name="TextBox 294"/>
            <p:cNvSpPr txBox="1"/>
            <p:nvPr/>
          </p:nvSpPr>
          <p:spPr>
            <a:xfrm>
              <a:off x="5638800" y="2029496"/>
              <a:ext cx="82266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/>
                <a:t>WPRE</a:t>
              </a:r>
              <a:endParaRPr lang="en-US" sz="2000" b="1" dirty="0"/>
            </a:p>
          </p:txBody>
        </p:sp>
        <p:cxnSp>
          <p:nvCxnSpPr>
            <p:cNvPr id="296" name="Straight Connector 295"/>
            <p:cNvCxnSpPr/>
            <p:nvPr/>
          </p:nvCxnSpPr>
          <p:spPr>
            <a:xfrm flipH="1">
              <a:off x="6049612" y="2361910"/>
              <a:ext cx="9175" cy="55504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0019092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94</TotalTime>
  <Words>56</Words>
  <Application>Microsoft Office PowerPoint</Application>
  <PresentationFormat>On-screen Show (4:3)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ourier New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sha</dc:creator>
  <cp:lastModifiedBy>Misha</cp:lastModifiedBy>
  <cp:revision>283</cp:revision>
  <cp:lastPrinted>2015-04-13T22:54:27Z</cp:lastPrinted>
  <dcterms:created xsi:type="dcterms:W3CDTF">2015-04-07T14:36:14Z</dcterms:created>
  <dcterms:modified xsi:type="dcterms:W3CDTF">2016-02-15T18:29:42Z</dcterms:modified>
</cp:coreProperties>
</file>